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6" autoAdjust="0"/>
    <p:restoredTop sz="94660"/>
  </p:normalViewPr>
  <p:slideViewPr>
    <p:cSldViewPr snapToGrid="0" showGuides="1">
      <p:cViewPr varScale="1">
        <p:scale>
          <a:sx n="76" d="100"/>
          <a:sy n="76" d="100"/>
        </p:scale>
        <p:origin x="152" y="60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 smtClean="0"/>
              <a:t>0-4</a:t>
            </a:r>
            <a:r>
              <a:rPr lang="en-US" baseline="0" dirty="0" smtClean="0"/>
              <a:t> years old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8.7473392710982284E-2"/>
          <c:y val="0.1018241469816273"/>
          <c:w val="0.89320434268031346"/>
          <c:h val="0.74557830271216097"/>
        </c:manualLayout>
      </c:layout>
      <c:lineChart>
        <c:grouping val="standard"/>
        <c:varyColors val="0"/>
        <c:ser>
          <c:idx val="1"/>
          <c:order val="1"/>
          <c:tx>
            <c:strRef>
              <c:f>Sheet1!$C$1</c:f>
              <c:strCache>
                <c:ptCount val="1"/>
                <c:pt idx="0">
                  <c:v>The number of influenza cases per week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numRef>
              <c:f>Sheet1!$A$2:$A$314</c:f>
              <c:numCache>
                <c:formatCode>General</c:formatCode>
                <c:ptCount val="31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1</c:v>
                </c:pt>
                <c:pt idx="53">
                  <c:v>2</c:v>
                </c:pt>
                <c:pt idx="54">
                  <c:v>3</c:v>
                </c:pt>
                <c:pt idx="55">
                  <c:v>4</c:v>
                </c:pt>
                <c:pt idx="56">
                  <c:v>5</c:v>
                </c:pt>
                <c:pt idx="57">
                  <c:v>6</c:v>
                </c:pt>
                <c:pt idx="58">
                  <c:v>7</c:v>
                </c:pt>
                <c:pt idx="59">
                  <c:v>8</c:v>
                </c:pt>
                <c:pt idx="60">
                  <c:v>9</c:v>
                </c:pt>
                <c:pt idx="61">
                  <c:v>10</c:v>
                </c:pt>
                <c:pt idx="62">
                  <c:v>11</c:v>
                </c:pt>
                <c:pt idx="63">
                  <c:v>12</c:v>
                </c:pt>
                <c:pt idx="64">
                  <c:v>13</c:v>
                </c:pt>
                <c:pt idx="65">
                  <c:v>14</c:v>
                </c:pt>
                <c:pt idx="66">
                  <c:v>15</c:v>
                </c:pt>
                <c:pt idx="67">
                  <c:v>16</c:v>
                </c:pt>
                <c:pt idx="68">
                  <c:v>17</c:v>
                </c:pt>
                <c:pt idx="69">
                  <c:v>18</c:v>
                </c:pt>
                <c:pt idx="70">
                  <c:v>19</c:v>
                </c:pt>
                <c:pt idx="71">
                  <c:v>20</c:v>
                </c:pt>
                <c:pt idx="72">
                  <c:v>21</c:v>
                </c:pt>
                <c:pt idx="73">
                  <c:v>22</c:v>
                </c:pt>
                <c:pt idx="74">
                  <c:v>23</c:v>
                </c:pt>
                <c:pt idx="75">
                  <c:v>24</c:v>
                </c:pt>
                <c:pt idx="76">
                  <c:v>25</c:v>
                </c:pt>
                <c:pt idx="77">
                  <c:v>26</c:v>
                </c:pt>
                <c:pt idx="78">
                  <c:v>27</c:v>
                </c:pt>
                <c:pt idx="79">
                  <c:v>28</c:v>
                </c:pt>
                <c:pt idx="80">
                  <c:v>29</c:v>
                </c:pt>
                <c:pt idx="81">
                  <c:v>30</c:v>
                </c:pt>
                <c:pt idx="82">
                  <c:v>31</c:v>
                </c:pt>
                <c:pt idx="83">
                  <c:v>32</c:v>
                </c:pt>
                <c:pt idx="84">
                  <c:v>33</c:v>
                </c:pt>
                <c:pt idx="85">
                  <c:v>34</c:v>
                </c:pt>
                <c:pt idx="86">
                  <c:v>35</c:v>
                </c:pt>
                <c:pt idx="87">
                  <c:v>36</c:v>
                </c:pt>
                <c:pt idx="88">
                  <c:v>37</c:v>
                </c:pt>
                <c:pt idx="89">
                  <c:v>38</c:v>
                </c:pt>
                <c:pt idx="90">
                  <c:v>39</c:v>
                </c:pt>
                <c:pt idx="91">
                  <c:v>40</c:v>
                </c:pt>
                <c:pt idx="92">
                  <c:v>41</c:v>
                </c:pt>
                <c:pt idx="93">
                  <c:v>42</c:v>
                </c:pt>
                <c:pt idx="94">
                  <c:v>43</c:v>
                </c:pt>
                <c:pt idx="95">
                  <c:v>44</c:v>
                </c:pt>
                <c:pt idx="96">
                  <c:v>45</c:v>
                </c:pt>
                <c:pt idx="97">
                  <c:v>46</c:v>
                </c:pt>
                <c:pt idx="98">
                  <c:v>47</c:v>
                </c:pt>
                <c:pt idx="99">
                  <c:v>48</c:v>
                </c:pt>
                <c:pt idx="100">
                  <c:v>49</c:v>
                </c:pt>
                <c:pt idx="101">
                  <c:v>50</c:v>
                </c:pt>
                <c:pt idx="102">
                  <c:v>51</c:v>
                </c:pt>
                <c:pt idx="103">
                  <c:v>52</c:v>
                </c:pt>
                <c:pt idx="104">
                  <c:v>1</c:v>
                </c:pt>
                <c:pt idx="105">
                  <c:v>2</c:v>
                </c:pt>
                <c:pt idx="106">
                  <c:v>3</c:v>
                </c:pt>
                <c:pt idx="107">
                  <c:v>4</c:v>
                </c:pt>
                <c:pt idx="108">
                  <c:v>5</c:v>
                </c:pt>
                <c:pt idx="109">
                  <c:v>6</c:v>
                </c:pt>
                <c:pt idx="110">
                  <c:v>7</c:v>
                </c:pt>
                <c:pt idx="111">
                  <c:v>8</c:v>
                </c:pt>
                <c:pt idx="112">
                  <c:v>9</c:v>
                </c:pt>
                <c:pt idx="113">
                  <c:v>10</c:v>
                </c:pt>
                <c:pt idx="114">
                  <c:v>11</c:v>
                </c:pt>
                <c:pt idx="115">
                  <c:v>12</c:v>
                </c:pt>
                <c:pt idx="116">
                  <c:v>13</c:v>
                </c:pt>
                <c:pt idx="117">
                  <c:v>14</c:v>
                </c:pt>
                <c:pt idx="118">
                  <c:v>15</c:v>
                </c:pt>
                <c:pt idx="119">
                  <c:v>16</c:v>
                </c:pt>
                <c:pt idx="120">
                  <c:v>17</c:v>
                </c:pt>
                <c:pt idx="121">
                  <c:v>18</c:v>
                </c:pt>
                <c:pt idx="122">
                  <c:v>19</c:v>
                </c:pt>
                <c:pt idx="123">
                  <c:v>20</c:v>
                </c:pt>
                <c:pt idx="124">
                  <c:v>21</c:v>
                </c:pt>
                <c:pt idx="125">
                  <c:v>22</c:v>
                </c:pt>
                <c:pt idx="126">
                  <c:v>23</c:v>
                </c:pt>
                <c:pt idx="127">
                  <c:v>24</c:v>
                </c:pt>
                <c:pt idx="128">
                  <c:v>25</c:v>
                </c:pt>
                <c:pt idx="129">
                  <c:v>26</c:v>
                </c:pt>
                <c:pt idx="130">
                  <c:v>27</c:v>
                </c:pt>
                <c:pt idx="131">
                  <c:v>28</c:v>
                </c:pt>
                <c:pt idx="132">
                  <c:v>29</c:v>
                </c:pt>
                <c:pt idx="133">
                  <c:v>30</c:v>
                </c:pt>
                <c:pt idx="134">
                  <c:v>31</c:v>
                </c:pt>
                <c:pt idx="135">
                  <c:v>32</c:v>
                </c:pt>
                <c:pt idx="136">
                  <c:v>33</c:v>
                </c:pt>
                <c:pt idx="137">
                  <c:v>34</c:v>
                </c:pt>
                <c:pt idx="138">
                  <c:v>35</c:v>
                </c:pt>
                <c:pt idx="139">
                  <c:v>36</c:v>
                </c:pt>
                <c:pt idx="140">
                  <c:v>37</c:v>
                </c:pt>
                <c:pt idx="141">
                  <c:v>38</c:v>
                </c:pt>
                <c:pt idx="142">
                  <c:v>39</c:v>
                </c:pt>
                <c:pt idx="143">
                  <c:v>40</c:v>
                </c:pt>
                <c:pt idx="144">
                  <c:v>41</c:v>
                </c:pt>
                <c:pt idx="145">
                  <c:v>42</c:v>
                </c:pt>
                <c:pt idx="146">
                  <c:v>43</c:v>
                </c:pt>
                <c:pt idx="147">
                  <c:v>44</c:v>
                </c:pt>
                <c:pt idx="148">
                  <c:v>45</c:v>
                </c:pt>
                <c:pt idx="149">
                  <c:v>46</c:v>
                </c:pt>
                <c:pt idx="150">
                  <c:v>47</c:v>
                </c:pt>
                <c:pt idx="151">
                  <c:v>48</c:v>
                </c:pt>
                <c:pt idx="152">
                  <c:v>49</c:v>
                </c:pt>
                <c:pt idx="153">
                  <c:v>50</c:v>
                </c:pt>
                <c:pt idx="154">
                  <c:v>51</c:v>
                </c:pt>
                <c:pt idx="155">
                  <c:v>52</c:v>
                </c:pt>
                <c:pt idx="156">
                  <c:v>1</c:v>
                </c:pt>
                <c:pt idx="157">
                  <c:v>2</c:v>
                </c:pt>
                <c:pt idx="158">
                  <c:v>3</c:v>
                </c:pt>
                <c:pt idx="159">
                  <c:v>4</c:v>
                </c:pt>
                <c:pt idx="160">
                  <c:v>5</c:v>
                </c:pt>
                <c:pt idx="161">
                  <c:v>6</c:v>
                </c:pt>
                <c:pt idx="162">
                  <c:v>7</c:v>
                </c:pt>
                <c:pt idx="163">
                  <c:v>8</c:v>
                </c:pt>
                <c:pt idx="164">
                  <c:v>9</c:v>
                </c:pt>
                <c:pt idx="165">
                  <c:v>10</c:v>
                </c:pt>
                <c:pt idx="166">
                  <c:v>11</c:v>
                </c:pt>
                <c:pt idx="167">
                  <c:v>12</c:v>
                </c:pt>
                <c:pt idx="168">
                  <c:v>13</c:v>
                </c:pt>
                <c:pt idx="169">
                  <c:v>14</c:v>
                </c:pt>
                <c:pt idx="170">
                  <c:v>15</c:v>
                </c:pt>
                <c:pt idx="171">
                  <c:v>16</c:v>
                </c:pt>
                <c:pt idx="172">
                  <c:v>17</c:v>
                </c:pt>
                <c:pt idx="173">
                  <c:v>18</c:v>
                </c:pt>
                <c:pt idx="174">
                  <c:v>19</c:v>
                </c:pt>
                <c:pt idx="175">
                  <c:v>20</c:v>
                </c:pt>
                <c:pt idx="176">
                  <c:v>21</c:v>
                </c:pt>
                <c:pt idx="177">
                  <c:v>22</c:v>
                </c:pt>
                <c:pt idx="178">
                  <c:v>23</c:v>
                </c:pt>
                <c:pt idx="179">
                  <c:v>24</c:v>
                </c:pt>
                <c:pt idx="180">
                  <c:v>25</c:v>
                </c:pt>
                <c:pt idx="181">
                  <c:v>26</c:v>
                </c:pt>
                <c:pt idx="182">
                  <c:v>27</c:v>
                </c:pt>
                <c:pt idx="183">
                  <c:v>28</c:v>
                </c:pt>
                <c:pt idx="184">
                  <c:v>29</c:v>
                </c:pt>
                <c:pt idx="185">
                  <c:v>30</c:v>
                </c:pt>
                <c:pt idx="186">
                  <c:v>31</c:v>
                </c:pt>
                <c:pt idx="187">
                  <c:v>32</c:v>
                </c:pt>
                <c:pt idx="188">
                  <c:v>33</c:v>
                </c:pt>
                <c:pt idx="189">
                  <c:v>34</c:v>
                </c:pt>
                <c:pt idx="190">
                  <c:v>35</c:v>
                </c:pt>
                <c:pt idx="191">
                  <c:v>36</c:v>
                </c:pt>
                <c:pt idx="192">
                  <c:v>37</c:v>
                </c:pt>
                <c:pt idx="193">
                  <c:v>38</c:v>
                </c:pt>
                <c:pt idx="194">
                  <c:v>39</c:v>
                </c:pt>
                <c:pt idx="195">
                  <c:v>40</c:v>
                </c:pt>
                <c:pt idx="196">
                  <c:v>41</c:v>
                </c:pt>
                <c:pt idx="197">
                  <c:v>42</c:v>
                </c:pt>
                <c:pt idx="198">
                  <c:v>43</c:v>
                </c:pt>
                <c:pt idx="199">
                  <c:v>44</c:v>
                </c:pt>
                <c:pt idx="200">
                  <c:v>45</c:v>
                </c:pt>
                <c:pt idx="201">
                  <c:v>46</c:v>
                </c:pt>
                <c:pt idx="202">
                  <c:v>47</c:v>
                </c:pt>
                <c:pt idx="203">
                  <c:v>48</c:v>
                </c:pt>
                <c:pt idx="204">
                  <c:v>49</c:v>
                </c:pt>
                <c:pt idx="205">
                  <c:v>50</c:v>
                </c:pt>
                <c:pt idx="206">
                  <c:v>51</c:v>
                </c:pt>
                <c:pt idx="207">
                  <c:v>52</c:v>
                </c:pt>
                <c:pt idx="208">
                  <c:v>53</c:v>
                </c:pt>
                <c:pt idx="209">
                  <c:v>1</c:v>
                </c:pt>
                <c:pt idx="210">
                  <c:v>2</c:v>
                </c:pt>
                <c:pt idx="211">
                  <c:v>3</c:v>
                </c:pt>
                <c:pt idx="212">
                  <c:v>4</c:v>
                </c:pt>
                <c:pt idx="213">
                  <c:v>5</c:v>
                </c:pt>
                <c:pt idx="214">
                  <c:v>6</c:v>
                </c:pt>
                <c:pt idx="215">
                  <c:v>7</c:v>
                </c:pt>
                <c:pt idx="216">
                  <c:v>8</c:v>
                </c:pt>
                <c:pt idx="217">
                  <c:v>9</c:v>
                </c:pt>
                <c:pt idx="218">
                  <c:v>10</c:v>
                </c:pt>
                <c:pt idx="219">
                  <c:v>11</c:v>
                </c:pt>
                <c:pt idx="220">
                  <c:v>12</c:v>
                </c:pt>
                <c:pt idx="221">
                  <c:v>13</c:v>
                </c:pt>
                <c:pt idx="222">
                  <c:v>14</c:v>
                </c:pt>
                <c:pt idx="223">
                  <c:v>15</c:v>
                </c:pt>
                <c:pt idx="224">
                  <c:v>16</c:v>
                </c:pt>
                <c:pt idx="225">
                  <c:v>17</c:v>
                </c:pt>
                <c:pt idx="226">
                  <c:v>18</c:v>
                </c:pt>
                <c:pt idx="227">
                  <c:v>19</c:v>
                </c:pt>
                <c:pt idx="228">
                  <c:v>20</c:v>
                </c:pt>
                <c:pt idx="229">
                  <c:v>21</c:v>
                </c:pt>
                <c:pt idx="230">
                  <c:v>22</c:v>
                </c:pt>
                <c:pt idx="231">
                  <c:v>23</c:v>
                </c:pt>
                <c:pt idx="232">
                  <c:v>24</c:v>
                </c:pt>
                <c:pt idx="233">
                  <c:v>25</c:v>
                </c:pt>
                <c:pt idx="234">
                  <c:v>26</c:v>
                </c:pt>
                <c:pt idx="235">
                  <c:v>27</c:v>
                </c:pt>
                <c:pt idx="236">
                  <c:v>28</c:v>
                </c:pt>
                <c:pt idx="237">
                  <c:v>29</c:v>
                </c:pt>
                <c:pt idx="238">
                  <c:v>30</c:v>
                </c:pt>
                <c:pt idx="239">
                  <c:v>31</c:v>
                </c:pt>
                <c:pt idx="240">
                  <c:v>32</c:v>
                </c:pt>
                <c:pt idx="241">
                  <c:v>33</c:v>
                </c:pt>
                <c:pt idx="242">
                  <c:v>34</c:v>
                </c:pt>
                <c:pt idx="243">
                  <c:v>35</c:v>
                </c:pt>
                <c:pt idx="244">
                  <c:v>36</c:v>
                </c:pt>
                <c:pt idx="245">
                  <c:v>37</c:v>
                </c:pt>
                <c:pt idx="246">
                  <c:v>38</c:v>
                </c:pt>
                <c:pt idx="247">
                  <c:v>39</c:v>
                </c:pt>
                <c:pt idx="248">
                  <c:v>40</c:v>
                </c:pt>
                <c:pt idx="249">
                  <c:v>41</c:v>
                </c:pt>
                <c:pt idx="250">
                  <c:v>42</c:v>
                </c:pt>
                <c:pt idx="251">
                  <c:v>43</c:v>
                </c:pt>
                <c:pt idx="252">
                  <c:v>44</c:v>
                </c:pt>
                <c:pt idx="253">
                  <c:v>45</c:v>
                </c:pt>
                <c:pt idx="254">
                  <c:v>46</c:v>
                </c:pt>
                <c:pt idx="255">
                  <c:v>47</c:v>
                </c:pt>
                <c:pt idx="256">
                  <c:v>48</c:v>
                </c:pt>
                <c:pt idx="257">
                  <c:v>49</c:v>
                </c:pt>
                <c:pt idx="258">
                  <c:v>50</c:v>
                </c:pt>
                <c:pt idx="259">
                  <c:v>51</c:v>
                </c:pt>
                <c:pt idx="260">
                  <c:v>52</c:v>
                </c:pt>
                <c:pt idx="261">
                  <c:v>1</c:v>
                </c:pt>
                <c:pt idx="262">
                  <c:v>2</c:v>
                </c:pt>
                <c:pt idx="263">
                  <c:v>3</c:v>
                </c:pt>
                <c:pt idx="264">
                  <c:v>4</c:v>
                </c:pt>
                <c:pt idx="265">
                  <c:v>5</c:v>
                </c:pt>
                <c:pt idx="266">
                  <c:v>6</c:v>
                </c:pt>
                <c:pt idx="267">
                  <c:v>7</c:v>
                </c:pt>
                <c:pt idx="268">
                  <c:v>8</c:v>
                </c:pt>
                <c:pt idx="269">
                  <c:v>9</c:v>
                </c:pt>
                <c:pt idx="270">
                  <c:v>10</c:v>
                </c:pt>
                <c:pt idx="271">
                  <c:v>11</c:v>
                </c:pt>
                <c:pt idx="272">
                  <c:v>12</c:v>
                </c:pt>
                <c:pt idx="273">
                  <c:v>13</c:v>
                </c:pt>
                <c:pt idx="274">
                  <c:v>14</c:v>
                </c:pt>
                <c:pt idx="275">
                  <c:v>15</c:v>
                </c:pt>
                <c:pt idx="276">
                  <c:v>16</c:v>
                </c:pt>
                <c:pt idx="277">
                  <c:v>17</c:v>
                </c:pt>
                <c:pt idx="278">
                  <c:v>18</c:v>
                </c:pt>
                <c:pt idx="279">
                  <c:v>19</c:v>
                </c:pt>
                <c:pt idx="280">
                  <c:v>20</c:v>
                </c:pt>
                <c:pt idx="281">
                  <c:v>21</c:v>
                </c:pt>
                <c:pt idx="282">
                  <c:v>22</c:v>
                </c:pt>
                <c:pt idx="283">
                  <c:v>23</c:v>
                </c:pt>
                <c:pt idx="284">
                  <c:v>24</c:v>
                </c:pt>
                <c:pt idx="285">
                  <c:v>25</c:v>
                </c:pt>
                <c:pt idx="286">
                  <c:v>26</c:v>
                </c:pt>
                <c:pt idx="287">
                  <c:v>27</c:v>
                </c:pt>
                <c:pt idx="288">
                  <c:v>28</c:v>
                </c:pt>
                <c:pt idx="289">
                  <c:v>29</c:v>
                </c:pt>
                <c:pt idx="290">
                  <c:v>30</c:v>
                </c:pt>
                <c:pt idx="291">
                  <c:v>31</c:v>
                </c:pt>
                <c:pt idx="292">
                  <c:v>32</c:v>
                </c:pt>
                <c:pt idx="293">
                  <c:v>33</c:v>
                </c:pt>
                <c:pt idx="294">
                  <c:v>34</c:v>
                </c:pt>
                <c:pt idx="295">
                  <c:v>35</c:v>
                </c:pt>
                <c:pt idx="296">
                  <c:v>36</c:v>
                </c:pt>
                <c:pt idx="297">
                  <c:v>37</c:v>
                </c:pt>
                <c:pt idx="298">
                  <c:v>38</c:v>
                </c:pt>
                <c:pt idx="299">
                  <c:v>39</c:v>
                </c:pt>
                <c:pt idx="300">
                  <c:v>40</c:v>
                </c:pt>
                <c:pt idx="301">
                  <c:v>41</c:v>
                </c:pt>
                <c:pt idx="302">
                  <c:v>42</c:v>
                </c:pt>
                <c:pt idx="303">
                  <c:v>43</c:v>
                </c:pt>
                <c:pt idx="304">
                  <c:v>44</c:v>
                </c:pt>
                <c:pt idx="305">
                  <c:v>45</c:v>
                </c:pt>
                <c:pt idx="306">
                  <c:v>46</c:v>
                </c:pt>
                <c:pt idx="307">
                  <c:v>47</c:v>
                </c:pt>
                <c:pt idx="308">
                  <c:v>48</c:v>
                </c:pt>
                <c:pt idx="309">
                  <c:v>49</c:v>
                </c:pt>
                <c:pt idx="310">
                  <c:v>50</c:v>
                </c:pt>
                <c:pt idx="311">
                  <c:v>51</c:v>
                </c:pt>
                <c:pt idx="312">
                  <c:v>52</c:v>
                </c:pt>
              </c:numCache>
            </c:numRef>
          </c:cat>
          <c:val>
            <c:numRef>
              <c:f>Sheet1!$C$2:$C$314</c:f>
              <c:numCache>
                <c:formatCode>General</c:formatCode>
                <c:ptCount val="313"/>
                <c:pt idx="0">
                  <c:v>352</c:v>
                </c:pt>
                <c:pt idx="1">
                  <c:v>817</c:v>
                </c:pt>
                <c:pt idx="2">
                  <c:v>2237</c:v>
                </c:pt>
                <c:pt idx="3">
                  <c:v>3051</c:v>
                </c:pt>
                <c:pt idx="4">
                  <c:v>3447</c:v>
                </c:pt>
                <c:pt idx="5">
                  <c:v>2736</c:v>
                </c:pt>
                <c:pt idx="6">
                  <c:v>2102</c:v>
                </c:pt>
                <c:pt idx="7">
                  <c:v>1517</c:v>
                </c:pt>
                <c:pt idx="8">
                  <c:v>1260</c:v>
                </c:pt>
                <c:pt idx="9">
                  <c:v>1136</c:v>
                </c:pt>
                <c:pt idx="10">
                  <c:v>921</c:v>
                </c:pt>
                <c:pt idx="11">
                  <c:v>967</c:v>
                </c:pt>
                <c:pt idx="12">
                  <c:v>734</c:v>
                </c:pt>
                <c:pt idx="13">
                  <c:v>589</c:v>
                </c:pt>
                <c:pt idx="14">
                  <c:v>445</c:v>
                </c:pt>
                <c:pt idx="15">
                  <c:v>336</c:v>
                </c:pt>
                <c:pt idx="16">
                  <c:v>160</c:v>
                </c:pt>
                <c:pt idx="17">
                  <c:v>44</c:v>
                </c:pt>
                <c:pt idx="18">
                  <c:v>24</c:v>
                </c:pt>
                <c:pt idx="19">
                  <c:v>9</c:v>
                </c:pt>
                <c:pt idx="20">
                  <c:v>8</c:v>
                </c:pt>
                <c:pt idx="21">
                  <c:v>7</c:v>
                </c:pt>
                <c:pt idx="22">
                  <c:v>2</c:v>
                </c:pt>
                <c:pt idx="23">
                  <c:v>1</c:v>
                </c:pt>
                <c:pt idx="24">
                  <c:v>1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1</c:v>
                </c:pt>
                <c:pt idx="29">
                  <c:v>0</c:v>
                </c:pt>
                <c:pt idx="30">
                  <c:v>1</c:v>
                </c:pt>
                <c:pt idx="31">
                  <c:v>0</c:v>
                </c:pt>
                <c:pt idx="32">
                  <c:v>1</c:v>
                </c:pt>
                <c:pt idx="33">
                  <c:v>0</c:v>
                </c:pt>
                <c:pt idx="34">
                  <c:v>0</c:v>
                </c:pt>
                <c:pt idx="35">
                  <c:v>1</c:v>
                </c:pt>
                <c:pt idx="36">
                  <c:v>1</c:v>
                </c:pt>
                <c:pt idx="37">
                  <c:v>0</c:v>
                </c:pt>
                <c:pt idx="38">
                  <c:v>2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2</c:v>
                </c:pt>
                <c:pt idx="43">
                  <c:v>2</c:v>
                </c:pt>
                <c:pt idx="44">
                  <c:v>6</c:v>
                </c:pt>
                <c:pt idx="45">
                  <c:v>5</c:v>
                </c:pt>
                <c:pt idx="46">
                  <c:v>12</c:v>
                </c:pt>
                <c:pt idx="47">
                  <c:v>12</c:v>
                </c:pt>
                <c:pt idx="48">
                  <c:v>36</c:v>
                </c:pt>
                <c:pt idx="49">
                  <c:v>51</c:v>
                </c:pt>
                <c:pt idx="50">
                  <c:v>57</c:v>
                </c:pt>
                <c:pt idx="51">
                  <c:v>51</c:v>
                </c:pt>
                <c:pt idx="52">
                  <c:v>74</c:v>
                </c:pt>
                <c:pt idx="53">
                  <c:v>414</c:v>
                </c:pt>
                <c:pt idx="54">
                  <c:v>1012</c:v>
                </c:pt>
                <c:pt idx="55">
                  <c:v>1811</c:v>
                </c:pt>
                <c:pt idx="56">
                  <c:v>2131</c:v>
                </c:pt>
                <c:pt idx="57">
                  <c:v>1971</c:v>
                </c:pt>
                <c:pt idx="58">
                  <c:v>1338</c:v>
                </c:pt>
                <c:pt idx="59">
                  <c:v>1082</c:v>
                </c:pt>
                <c:pt idx="60">
                  <c:v>910</c:v>
                </c:pt>
                <c:pt idx="61">
                  <c:v>671</c:v>
                </c:pt>
                <c:pt idx="62">
                  <c:v>477</c:v>
                </c:pt>
                <c:pt idx="63">
                  <c:v>392</c:v>
                </c:pt>
                <c:pt idx="64">
                  <c:v>308</c:v>
                </c:pt>
                <c:pt idx="65">
                  <c:v>266</c:v>
                </c:pt>
                <c:pt idx="66">
                  <c:v>186</c:v>
                </c:pt>
                <c:pt idx="67">
                  <c:v>219</c:v>
                </c:pt>
                <c:pt idx="68">
                  <c:v>193</c:v>
                </c:pt>
                <c:pt idx="69">
                  <c:v>174</c:v>
                </c:pt>
                <c:pt idx="70">
                  <c:v>133</c:v>
                </c:pt>
                <c:pt idx="71">
                  <c:v>131</c:v>
                </c:pt>
                <c:pt idx="72">
                  <c:v>101</c:v>
                </c:pt>
                <c:pt idx="73">
                  <c:v>52</c:v>
                </c:pt>
                <c:pt idx="74">
                  <c:v>35</c:v>
                </c:pt>
                <c:pt idx="75">
                  <c:v>10</c:v>
                </c:pt>
                <c:pt idx="76">
                  <c:v>5</c:v>
                </c:pt>
                <c:pt idx="77">
                  <c:v>2</c:v>
                </c:pt>
                <c:pt idx="78">
                  <c:v>2</c:v>
                </c:pt>
                <c:pt idx="79">
                  <c:v>2</c:v>
                </c:pt>
                <c:pt idx="80">
                  <c:v>0</c:v>
                </c:pt>
                <c:pt idx="81">
                  <c:v>4</c:v>
                </c:pt>
                <c:pt idx="82">
                  <c:v>0</c:v>
                </c:pt>
                <c:pt idx="83">
                  <c:v>2</c:v>
                </c:pt>
                <c:pt idx="84">
                  <c:v>1</c:v>
                </c:pt>
                <c:pt idx="85">
                  <c:v>2</c:v>
                </c:pt>
                <c:pt idx="86">
                  <c:v>1</c:v>
                </c:pt>
                <c:pt idx="87">
                  <c:v>2</c:v>
                </c:pt>
                <c:pt idx="88">
                  <c:v>4</c:v>
                </c:pt>
                <c:pt idx="89">
                  <c:v>6</c:v>
                </c:pt>
                <c:pt idx="90">
                  <c:v>1</c:v>
                </c:pt>
                <c:pt idx="91">
                  <c:v>1</c:v>
                </c:pt>
                <c:pt idx="92">
                  <c:v>1</c:v>
                </c:pt>
                <c:pt idx="93">
                  <c:v>2</c:v>
                </c:pt>
                <c:pt idx="94">
                  <c:v>6</c:v>
                </c:pt>
                <c:pt idx="95">
                  <c:v>2</c:v>
                </c:pt>
                <c:pt idx="96">
                  <c:v>6</c:v>
                </c:pt>
                <c:pt idx="97">
                  <c:v>7</c:v>
                </c:pt>
                <c:pt idx="98">
                  <c:v>4</c:v>
                </c:pt>
                <c:pt idx="99">
                  <c:v>19</c:v>
                </c:pt>
                <c:pt idx="100">
                  <c:v>43</c:v>
                </c:pt>
                <c:pt idx="101">
                  <c:v>59</c:v>
                </c:pt>
                <c:pt idx="102">
                  <c:v>66</c:v>
                </c:pt>
                <c:pt idx="103">
                  <c:v>122</c:v>
                </c:pt>
                <c:pt idx="104">
                  <c:v>102</c:v>
                </c:pt>
                <c:pt idx="105">
                  <c:v>588</c:v>
                </c:pt>
                <c:pt idx="106">
                  <c:v>1466</c:v>
                </c:pt>
                <c:pt idx="107">
                  <c:v>2458</c:v>
                </c:pt>
                <c:pt idx="108">
                  <c:v>2703</c:v>
                </c:pt>
                <c:pt idx="109">
                  <c:v>2045</c:v>
                </c:pt>
                <c:pt idx="110">
                  <c:v>1594</c:v>
                </c:pt>
                <c:pt idx="111">
                  <c:v>1339</c:v>
                </c:pt>
                <c:pt idx="112">
                  <c:v>1330</c:v>
                </c:pt>
                <c:pt idx="113">
                  <c:v>1087</c:v>
                </c:pt>
                <c:pt idx="114">
                  <c:v>989</c:v>
                </c:pt>
                <c:pt idx="115">
                  <c:v>924</c:v>
                </c:pt>
                <c:pt idx="116">
                  <c:v>702</c:v>
                </c:pt>
                <c:pt idx="117">
                  <c:v>418</c:v>
                </c:pt>
                <c:pt idx="118">
                  <c:v>282</c:v>
                </c:pt>
                <c:pt idx="119">
                  <c:v>240</c:v>
                </c:pt>
                <c:pt idx="120">
                  <c:v>186</c:v>
                </c:pt>
                <c:pt idx="121">
                  <c:v>86</c:v>
                </c:pt>
                <c:pt idx="122">
                  <c:v>48</c:v>
                </c:pt>
                <c:pt idx="123">
                  <c:v>44</c:v>
                </c:pt>
                <c:pt idx="124">
                  <c:v>30</c:v>
                </c:pt>
                <c:pt idx="125">
                  <c:v>11</c:v>
                </c:pt>
                <c:pt idx="126">
                  <c:v>8</c:v>
                </c:pt>
                <c:pt idx="127">
                  <c:v>7</c:v>
                </c:pt>
                <c:pt idx="128">
                  <c:v>0</c:v>
                </c:pt>
                <c:pt idx="129">
                  <c:v>1</c:v>
                </c:pt>
                <c:pt idx="130">
                  <c:v>0</c:v>
                </c:pt>
                <c:pt idx="131">
                  <c:v>3</c:v>
                </c:pt>
                <c:pt idx="132">
                  <c:v>1</c:v>
                </c:pt>
                <c:pt idx="133">
                  <c:v>1</c:v>
                </c:pt>
                <c:pt idx="134">
                  <c:v>1</c:v>
                </c:pt>
                <c:pt idx="135">
                  <c:v>1</c:v>
                </c:pt>
                <c:pt idx="136">
                  <c:v>1</c:v>
                </c:pt>
                <c:pt idx="137">
                  <c:v>2</c:v>
                </c:pt>
                <c:pt idx="138">
                  <c:v>3</c:v>
                </c:pt>
                <c:pt idx="139">
                  <c:v>0</c:v>
                </c:pt>
                <c:pt idx="140">
                  <c:v>2</c:v>
                </c:pt>
                <c:pt idx="141">
                  <c:v>1</c:v>
                </c:pt>
                <c:pt idx="142">
                  <c:v>2</c:v>
                </c:pt>
                <c:pt idx="143">
                  <c:v>1</c:v>
                </c:pt>
                <c:pt idx="144">
                  <c:v>1</c:v>
                </c:pt>
                <c:pt idx="145">
                  <c:v>0</c:v>
                </c:pt>
                <c:pt idx="146">
                  <c:v>2</c:v>
                </c:pt>
                <c:pt idx="147">
                  <c:v>9</c:v>
                </c:pt>
                <c:pt idx="148">
                  <c:v>12</c:v>
                </c:pt>
                <c:pt idx="149">
                  <c:v>16</c:v>
                </c:pt>
                <c:pt idx="150">
                  <c:v>36</c:v>
                </c:pt>
                <c:pt idx="151">
                  <c:v>72</c:v>
                </c:pt>
                <c:pt idx="152">
                  <c:v>150</c:v>
                </c:pt>
                <c:pt idx="153">
                  <c:v>355</c:v>
                </c:pt>
                <c:pt idx="154">
                  <c:v>861</c:v>
                </c:pt>
                <c:pt idx="155">
                  <c:v>1785</c:v>
                </c:pt>
                <c:pt idx="156">
                  <c:v>978</c:v>
                </c:pt>
                <c:pt idx="157">
                  <c:v>2389</c:v>
                </c:pt>
                <c:pt idx="158">
                  <c:v>2157</c:v>
                </c:pt>
                <c:pt idx="159">
                  <c:v>2166</c:v>
                </c:pt>
                <c:pt idx="160">
                  <c:v>1442</c:v>
                </c:pt>
                <c:pt idx="161">
                  <c:v>927</c:v>
                </c:pt>
                <c:pt idx="162">
                  <c:v>579</c:v>
                </c:pt>
                <c:pt idx="163">
                  <c:v>357</c:v>
                </c:pt>
                <c:pt idx="164">
                  <c:v>261</c:v>
                </c:pt>
                <c:pt idx="165">
                  <c:v>179</c:v>
                </c:pt>
                <c:pt idx="166">
                  <c:v>128</c:v>
                </c:pt>
                <c:pt idx="167">
                  <c:v>136</c:v>
                </c:pt>
                <c:pt idx="168">
                  <c:v>127</c:v>
                </c:pt>
                <c:pt idx="169">
                  <c:v>123</c:v>
                </c:pt>
                <c:pt idx="170">
                  <c:v>76</c:v>
                </c:pt>
                <c:pt idx="171">
                  <c:v>84</c:v>
                </c:pt>
                <c:pt idx="172">
                  <c:v>94</c:v>
                </c:pt>
                <c:pt idx="173">
                  <c:v>55</c:v>
                </c:pt>
                <c:pt idx="174">
                  <c:v>16</c:v>
                </c:pt>
                <c:pt idx="175">
                  <c:v>20</c:v>
                </c:pt>
                <c:pt idx="176">
                  <c:v>12</c:v>
                </c:pt>
                <c:pt idx="177">
                  <c:v>7</c:v>
                </c:pt>
                <c:pt idx="178">
                  <c:v>2</c:v>
                </c:pt>
                <c:pt idx="179">
                  <c:v>2</c:v>
                </c:pt>
                <c:pt idx="180">
                  <c:v>1</c:v>
                </c:pt>
                <c:pt idx="181">
                  <c:v>0</c:v>
                </c:pt>
                <c:pt idx="182">
                  <c:v>2</c:v>
                </c:pt>
                <c:pt idx="183">
                  <c:v>1</c:v>
                </c:pt>
                <c:pt idx="184">
                  <c:v>2</c:v>
                </c:pt>
                <c:pt idx="185">
                  <c:v>0</c:v>
                </c:pt>
                <c:pt idx="186">
                  <c:v>1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2</c:v>
                </c:pt>
                <c:pt idx="191">
                  <c:v>1</c:v>
                </c:pt>
                <c:pt idx="192">
                  <c:v>0</c:v>
                </c:pt>
                <c:pt idx="193">
                  <c:v>1</c:v>
                </c:pt>
                <c:pt idx="194">
                  <c:v>0</c:v>
                </c:pt>
                <c:pt idx="195">
                  <c:v>1</c:v>
                </c:pt>
                <c:pt idx="196">
                  <c:v>1</c:v>
                </c:pt>
                <c:pt idx="197">
                  <c:v>0</c:v>
                </c:pt>
                <c:pt idx="198">
                  <c:v>7</c:v>
                </c:pt>
                <c:pt idx="199">
                  <c:v>3</c:v>
                </c:pt>
                <c:pt idx="200">
                  <c:v>4</c:v>
                </c:pt>
                <c:pt idx="201">
                  <c:v>4</c:v>
                </c:pt>
                <c:pt idx="202">
                  <c:v>6</c:v>
                </c:pt>
                <c:pt idx="203">
                  <c:v>9</c:v>
                </c:pt>
                <c:pt idx="204">
                  <c:v>7</c:v>
                </c:pt>
                <c:pt idx="205">
                  <c:v>8</c:v>
                </c:pt>
                <c:pt idx="206">
                  <c:v>34</c:v>
                </c:pt>
                <c:pt idx="207">
                  <c:v>37</c:v>
                </c:pt>
                <c:pt idx="208">
                  <c:v>33</c:v>
                </c:pt>
                <c:pt idx="209">
                  <c:v>137</c:v>
                </c:pt>
                <c:pt idx="210">
                  <c:v>259</c:v>
                </c:pt>
                <c:pt idx="211">
                  <c:v>696</c:v>
                </c:pt>
                <c:pt idx="212">
                  <c:v>1397</c:v>
                </c:pt>
                <c:pt idx="213">
                  <c:v>2150</c:v>
                </c:pt>
                <c:pt idx="214">
                  <c:v>2941</c:v>
                </c:pt>
                <c:pt idx="215">
                  <c:v>2849</c:v>
                </c:pt>
                <c:pt idx="216">
                  <c:v>2779</c:v>
                </c:pt>
                <c:pt idx="217">
                  <c:v>2495</c:v>
                </c:pt>
                <c:pt idx="218">
                  <c:v>1919</c:v>
                </c:pt>
                <c:pt idx="219">
                  <c:v>1252</c:v>
                </c:pt>
                <c:pt idx="220">
                  <c:v>746</c:v>
                </c:pt>
                <c:pt idx="221">
                  <c:v>589</c:v>
                </c:pt>
                <c:pt idx="222">
                  <c:v>428</c:v>
                </c:pt>
                <c:pt idx="223">
                  <c:v>177</c:v>
                </c:pt>
                <c:pt idx="224">
                  <c:v>123</c:v>
                </c:pt>
                <c:pt idx="225">
                  <c:v>67</c:v>
                </c:pt>
                <c:pt idx="226">
                  <c:v>24</c:v>
                </c:pt>
                <c:pt idx="227">
                  <c:v>10</c:v>
                </c:pt>
                <c:pt idx="228">
                  <c:v>9</c:v>
                </c:pt>
                <c:pt idx="229">
                  <c:v>4</c:v>
                </c:pt>
                <c:pt idx="230">
                  <c:v>3</c:v>
                </c:pt>
                <c:pt idx="231">
                  <c:v>0</c:v>
                </c:pt>
                <c:pt idx="232">
                  <c:v>1</c:v>
                </c:pt>
                <c:pt idx="233">
                  <c:v>1</c:v>
                </c:pt>
                <c:pt idx="234">
                  <c:v>0</c:v>
                </c:pt>
                <c:pt idx="235">
                  <c:v>0</c:v>
                </c:pt>
                <c:pt idx="236">
                  <c:v>1</c:v>
                </c:pt>
                <c:pt idx="237">
                  <c:v>0</c:v>
                </c:pt>
                <c:pt idx="238">
                  <c:v>2</c:v>
                </c:pt>
                <c:pt idx="239">
                  <c:v>0</c:v>
                </c:pt>
                <c:pt idx="240">
                  <c:v>0</c:v>
                </c:pt>
                <c:pt idx="241">
                  <c:v>1</c:v>
                </c:pt>
                <c:pt idx="242">
                  <c:v>0</c:v>
                </c:pt>
                <c:pt idx="243">
                  <c:v>0</c:v>
                </c:pt>
                <c:pt idx="244">
                  <c:v>1</c:v>
                </c:pt>
                <c:pt idx="245">
                  <c:v>0</c:v>
                </c:pt>
                <c:pt idx="246">
                  <c:v>4</c:v>
                </c:pt>
                <c:pt idx="247">
                  <c:v>3</c:v>
                </c:pt>
                <c:pt idx="248">
                  <c:v>8</c:v>
                </c:pt>
                <c:pt idx="249">
                  <c:v>10</c:v>
                </c:pt>
                <c:pt idx="250">
                  <c:v>8</c:v>
                </c:pt>
                <c:pt idx="251">
                  <c:v>18</c:v>
                </c:pt>
                <c:pt idx="252">
                  <c:v>21</c:v>
                </c:pt>
                <c:pt idx="253">
                  <c:v>46</c:v>
                </c:pt>
                <c:pt idx="254">
                  <c:v>51</c:v>
                </c:pt>
                <c:pt idx="255">
                  <c:v>75</c:v>
                </c:pt>
                <c:pt idx="256">
                  <c:v>95</c:v>
                </c:pt>
                <c:pt idx="257">
                  <c:v>133</c:v>
                </c:pt>
                <c:pt idx="258">
                  <c:v>174</c:v>
                </c:pt>
                <c:pt idx="259">
                  <c:v>297</c:v>
                </c:pt>
                <c:pt idx="260">
                  <c:v>326</c:v>
                </c:pt>
                <c:pt idx="261">
                  <c:v>511</c:v>
                </c:pt>
                <c:pt idx="262">
                  <c:v>977</c:v>
                </c:pt>
                <c:pt idx="263">
                  <c:v>1811</c:v>
                </c:pt>
                <c:pt idx="264">
                  <c:v>2379</c:v>
                </c:pt>
                <c:pt idx="265">
                  <c:v>2587</c:v>
                </c:pt>
                <c:pt idx="266">
                  <c:v>1924</c:v>
                </c:pt>
                <c:pt idx="267">
                  <c:v>1530</c:v>
                </c:pt>
                <c:pt idx="268">
                  <c:v>978</c:v>
                </c:pt>
                <c:pt idx="269">
                  <c:v>651</c:v>
                </c:pt>
                <c:pt idx="270">
                  <c:v>445</c:v>
                </c:pt>
                <c:pt idx="271">
                  <c:v>337</c:v>
                </c:pt>
                <c:pt idx="272">
                  <c:v>226</c:v>
                </c:pt>
                <c:pt idx="273">
                  <c:v>203</c:v>
                </c:pt>
                <c:pt idx="274">
                  <c:v>212</c:v>
                </c:pt>
                <c:pt idx="275">
                  <c:v>218</c:v>
                </c:pt>
                <c:pt idx="276">
                  <c:v>161</c:v>
                </c:pt>
                <c:pt idx="277">
                  <c:v>125</c:v>
                </c:pt>
                <c:pt idx="278">
                  <c:v>75</c:v>
                </c:pt>
                <c:pt idx="279">
                  <c:v>46</c:v>
                </c:pt>
                <c:pt idx="280">
                  <c:v>43</c:v>
                </c:pt>
                <c:pt idx="281">
                  <c:v>17</c:v>
                </c:pt>
                <c:pt idx="282">
                  <c:v>8</c:v>
                </c:pt>
                <c:pt idx="283">
                  <c:v>5</c:v>
                </c:pt>
                <c:pt idx="284">
                  <c:v>7</c:v>
                </c:pt>
                <c:pt idx="285">
                  <c:v>7</c:v>
                </c:pt>
                <c:pt idx="286">
                  <c:v>1</c:v>
                </c:pt>
                <c:pt idx="287">
                  <c:v>2</c:v>
                </c:pt>
                <c:pt idx="288">
                  <c:v>1</c:v>
                </c:pt>
                <c:pt idx="289">
                  <c:v>4</c:v>
                </c:pt>
                <c:pt idx="290">
                  <c:v>6</c:v>
                </c:pt>
                <c:pt idx="291">
                  <c:v>2</c:v>
                </c:pt>
                <c:pt idx="292">
                  <c:v>3</c:v>
                </c:pt>
                <c:pt idx="293">
                  <c:v>13</c:v>
                </c:pt>
                <c:pt idx="294">
                  <c:v>12</c:v>
                </c:pt>
                <c:pt idx="295">
                  <c:v>17</c:v>
                </c:pt>
                <c:pt idx="296">
                  <c:v>13</c:v>
                </c:pt>
                <c:pt idx="297">
                  <c:v>10</c:v>
                </c:pt>
                <c:pt idx="298">
                  <c:v>7</c:v>
                </c:pt>
                <c:pt idx="299">
                  <c:v>12</c:v>
                </c:pt>
                <c:pt idx="300">
                  <c:v>32</c:v>
                </c:pt>
                <c:pt idx="301">
                  <c:v>14</c:v>
                </c:pt>
                <c:pt idx="302">
                  <c:v>1</c:v>
                </c:pt>
                <c:pt idx="303">
                  <c:v>13</c:v>
                </c:pt>
                <c:pt idx="304">
                  <c:v>20</c:v>
                </c:pt>
                <c:pt idx="305">
                  <c:v>32</c:v>
                </c:pt>
                <c:pt idx="306">
                  <c:v>45</c:v>
                </c:pt>
                <c:pt idx="307">
                  <c:v>62</c:v>
                </c:pt>
                <c:pt idx="308">
                  <c:v>97</c:v>
                </c:pt>
                <c:pt idx="309">
                  <c:v>191</c:v>
                </c:pt>
                <c:pt idx="310">
                  <c:v>325</c:v>
                </c:pt>
                <c:pt idx="311">
                  <c:v>619</c:v>
                </c:pt>
                <c:pt idx="312">
                  <c:v>7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B3D-4EC0-A8D6-5E64F831BF17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The predict number of influenza patients calculated from regression model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cat>
            <c:numRef>
              <c:f>Sheet1!$A$2:$A$314</c:f>
              <c:numCache>
                <c:formatCode>General</c:formatCode>
                <c:ptCount val="31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1</c:v>
                </c:pt>
                <c:pt idx="53">
                  <c:v>2</c:v>
                </c:pt>
                <c:pt idx="54">
                  <c:v>3</c:v>
                </c:pt>
                <c:pt idx="55">
                  <c:v>4</c:v>
                </c:pt>
                <c:pt idx="56">
                  <c:v>5</c:v>
                </c:pt>
                <c:pt idx="57">
                  <c:v>6</c:v>
                </c:pt>
                <c:pt idx="58">
                  <c:v>7</c:v>
                </c:pt>
                <c:pt idx="59">
                  <c:v>8</c:v>
                </c:pt>
                <c:pt idx="60">
                  <c:v>9</c:v>
                </c:pt>
                <c:pt idx="61">
                  <c:v>10</c:v>
                </c:pt>
                <c:pt idx="62">
                  <c:v>11</c:v>
                </c:pt>
                <c:pt idx="63">
                  <c:v>12</c:v>
                </c:pt>
                <c:pt idx="64">
                  <c:v>13</c:v>
                </c:pt>
                <c:pt idx="65">
                  <c:v>14</c:v>
                </c:pt>
                <c:pt idx="66">
                  <c:v>15</c:v>
                </c:pt>
                <c:pt idx="67">
                  <c:v>16</c:v>
                </c:pt>
                <c:pt idx="68">
                  <c:v>17</c:v>
                </c:pt>
                <c:pt idx="69">
                  <c:v>18</c:v>
                </c:pt>
                <c:pt idx="70">
                  <c:v>19</c:v>
                </c:pt>
                <c:pt idx="71">
                  <c:v>20</c:v>
                </c:pt>
                <c:pt idx="72">
                  <c:v>21</c:v>
                </c:pt>
                <c:pt idx="73">
                  <c:v>22</c:v>
                </c:pt>
                <c:pt idx="74">
                  <c:v>23</c:v>
                </c:pt>
                <c:pt idx="75">
                  <c:v>24</c:v>
                </c:pt>
                <c:pt idx="76">
                  <c:v>25</c:v>
                </c:pt>
                <c:pt idx="77">
                  <c:v>26</c:v>
                </c:pt>
                <c:pt idx="78">
                  <c:v>27</c:v>
                </c:pt>
                <c:pt idx="79">
                  <c:v>28</c:v>
                </c:pt>
                <c:pt idx="80">
                  <c:v>29</c:v>
                </c:pt>
                <c:pt idx="81">
                  <c:v>30</c:v>
                </c:pt>
                <c:pt idx="82">
                  <c:v>31</c:v>
                </c:pt>
                <c:pt idx="83">
                  <c:v>32</c:v>
                </c:pt>
                <c:pt idx="84">
                  <c:v>33</c:v>
                </c:pt>
                <c:pt idx="85">
                  <c:v>34</c:v>
                </c:pt>
                <c:pt idx="86">
                  <c:v>35</c:v>
                </c:pt>
                <c:pt idx="87">
                  <c:v>36</c:v>
                </c:pt>
                <c:pt idx="88">
                  <c:v>37</c:v>
                </c:pt>
                <c:pt idx="89">
                  <c:v>38</c:v>
                </c:pt>
                <c:pt idx="90">
                  <c:v>39</c:v>
                </c:pt>
                <c:pt idx="91">
                  <c:v>40</c:v>
                </c:pt>
                <c:pt idx="92">
                  <c:v>41</c:v>
                </c:pt>
                <c:pt idx="93">
                  <c:v>42</c:v>
                </c:pt>
                <c:pt idx="94">
                  <c:v>43</c:v>
                </c:pt>
                <c:pt idx="95">
                  <c:v>44</c:v>
                </c:pt>
                <c:pt idx="96">
                  <c:v>45</c:v>
                </c:pt>
                <c:pt idx="97">
                  <c:v>46</c:v>
                </c:pt>
                <c:pt idx="98">
                  <c:v>47</c:v>
                </c:pt>
                <c:pt idx="99">
                  <c:v>48</c:v>
                </c:pt>
                <c:pt idx="100">
                  <c:v>49</c:v>
                </c:pt>
                <c:pt idx="101">
                  <c:v>50</c:v>
                </c:pt>
                <c:pt idx="102">
                  <c:v>51</c:v>
                </c:pt>
                <c:pt idx="103">
                  <c:v>52</c:v>
                </c:pt>
                <c:pt idx="104">
                  <c:v>1</c:v>
                </c:pt>
                <c:pt idx="105">
                  <c:v>2</c:v>
                </c:pt>
                <c:pt idx="106">
                  <c:v>3</c:v>
                </c:pt>
                <c:pt idx="107">
                  <c:v>4</c:v>
                </c:pt>
                <c:pt idx="108">
                  <c:v>5</c:v>
                </c:pt>
                <c:pt idx="109">
                  <c:v>6</c:v>
                </c:pt>
                <c:pt idx="110">
                  <c:v>7</c:v>
                </c:pt>
                <c:pt idx="111">
                  <c:v>8</c:v>
                </c:pt>
                <c:pt idx="112">
                  <c:v>9</c:v>
                </c:pt>
                <c:pt idx="113">
                  <c:v>10</c:v>
                </c:pt>
                <c:pt idx="114">
                  <c:v>11</c:v>
                </c:pt>
                <c:pt idx="115">
                  <c:v>12</c:v>
                </c:pt>
                <c:pt idx="116">
                  <c:v>13</c:v>
                </c:pt>
                <c:pt idx="117">
                  <c:v>14</c:v>
                </c:pt>
                <c:pt idx="118">
                  <c:v>15</c:v>
                </c:pt>
                <c:pt idx="119">
                  <c:v>16</c:v>
                </c:pt>
                <c:pt idx="120">
                  <c:v>17</c:v>
                </c:pt>
                <c:pt idx="121">
                  <c:v>18</c:v>
                </c:pt>
                <c:pt idx="122">
                  <c:v>19</c:v>
                </c:pt>
                <c:pt idx="123">
                  <c:v>20</c:v>
                </c:pt>
                <c:pt idx="124">
                  <c:v>21</c:v>
                </c:pt>
                <c:pt idx="125">
                  <c:v>22</c:v>
                </c:pt>
                <c:pt idx="126">
                  <c:v>23</c:v>
                </c:pt>
                <c:pt idx="127">
                  <c:v>24</c:v>
                </c:pt>
                <c:pt idx="128">
                  <c:v>25</c:v>
                </c:pt>
                <c:pt idx="129">
                  <c:v>26</c:v>
                </c:pt>
                <c:pt idx="130">
                  <c:v>27</c:v>
                </c:pt>
                <c:pt idx="131">
                  <c:v>28</c:v>
                </c:pt>
                <c:pt idx="132">
                  <c:v>29</c:v>
                </c:pt>
                <c:pt idx="133">
                  <c:v>30</c:v>
                </c:pt>
                <c:pt idx="134">
                  <c:v>31</c:v>
                </c:pt>
                <c:pt idx="135">
                  <c:v>32</c:v>
                </c:pt>
                <c:pt idx="136">
                  <c:v>33</c:v>
                </c:pt>
                <c:pt idx="137">
                  <c:v>34</c:v>
                </c:pt>
                <c:pt idx="138">
                  <c:v>35</c:v>
                </c:pt>
                <c:pt idx="139">
                  <c:v>36</c:v>
                </c:pt>
                <c:pt idx="140">
                  <c:v>37</c:v>
                </c:pt>
                <c:pt idx="141">
                  <c:v>38</c:v>
                </c:pt>
                <c:pt idx="142">
                  <c:v>39</c:v>
                </c:pt>
                <c:pt idx="143">
                  <c:v>40</c:v>
                </c:pt>
                <c:pt idx="144">
                  <c:v>41</c:v>
                </c:pt>
                <c:pt idx="145">
                  <c:v>42</c:v>
                </c:pt>
                <c:pt idx="146">
                  <c:v>43</c:v>
                </c:pt>
                <c:pt idx="147">
                  <c:v>44</c:v>
                </c:pt>
                <c:pt idx="148">
                  <c:v>45</c:v>
                </c:pt>
                <c:pt idx="149">
                  <c:v>46</c:v>
                </c:pt>
                <c:pt idx="150">
                  <c:v>47</c:v>
                </c:pt>
                <c:pt idx="151">
                  <c:v>48</c:v>
                </c:pt>
                <c:pt idx="152">
                  <c:v>49</c:v>
                </c:pt>
                <c:pt idx="153">
                  <c:v>50</c:v>
                </c:pt>
                <c:pt idx="154">
                  <c:v>51</c:v>
                </c:pt>
                <c:pt idx="155">
                  <c:v>52</c:v>
                </c:pt>
                <c:pt idx="156">
                  <c:v>1</c:v>
                </c:pt>
                <c:pt idx="157">
                  <c:v>2</c:v>
                </c:pt>
                <c:pt idx="158">
                  <c:v>3</c:v>
                </c:pt>
                <c:pt idx="159">
                  <c:v>4</c:v>
                </c:pt>
                <c:pt idx="160">
                  <c:v>5</c:v>
                </c:pt>
                <c:pt idx="161">
                  <c:v>6</c:v>
                </c:pt>
                <c:pt idx="162">
                  <c:v>7</c:v>
                </c:pt>
                <c:pt idx="163">
                  <c:v>8</c:v>
                </c:pt>
                <c:pt idx="164">
                  <c:v>9</c:v>
                </c:pt>
                <c:pt idx="165">
                  <c:v>10</c:v>
                </c:pt>
                <c:pt idx="166">
                  <c:v>11</c:v>
                </c:pt>
                <c:pt idx="167">
                  <c:v>12</c:v>
                </c:pt>
                <c:pt idx="168">
                  <c:v>13</c:v>
                </c:pt>
                <c:pt idx="169">
                  <c:v>14</c:v>
                </c:pt>
                <c:pt idx="170">
                  <c:v>15</c:v>
                </c:pt>
                <c:pt idx="171">
                  <c:v>16</c:v>
                </c:pt>
                <c:pt idx="172">
                  <c:v>17</c:v>
                </c:pt>
                <c:pt idx="173">
                  <c:v>18</c:v>
                </c:pt>
                <c:pt idx="174">
                  <c:v>19</c:v>
                </c:pt>
                <c:pt idx="175">
                  <c:v>20</c:v>
                </c:pt>
                <c:pt idx="176">
                  <c:v>21</c:v>
                </c:pt>
                <c:pt idx="177">
                  <c:v>22</c:v>
                </c:pt>
                <c:pt idx="178">
                  <c:v>23</c:v>
                </c:pt>
                <c:pt idx="179">
                  <c:v>24</c:v>
                </c:pt>
                <c:pt idx="180">
                  <c:v>25</c:v>
                </c:pt>
                <c:pt idx="181">
                  <c:v>26</c:v>
                </c:pt>
                <c:pt idx="182">
                  <c:v>27</c:v>
                </c:pt>
                <c:pt idx="183">
                  <c:v>28</c:v>
                </c:pt>
                <c:pt idx="184">
                  <c:v>29</c:v>
                </c:pt>
                <c:pt idx="185">
                  <c:v>30</c:v>
                </c:pt>
                <c:pt idx="186">
                  <c:v>31</c:v>
                </c:pt>
                <c:pt idx="187">
                  <c:v>32</c:v>
                </c:pt>
                <c:pt idx="188">
                  <c:v>33</c:v>
                </c:pt>
                <c:pt idx="189">
                  <c:v>34</c:v>
                </c:pt>
                <c:pt idx="190">
                  <c:v>35</c:v>
                </c:pt>
                <c:pt idx="191">
                  <c:v>36</c:v>
                </c:pt>
                <c:pt idx="192">
                  <c:v>37</c:v>
                </c:pt>
                <c:pt idx="193">
                  <c:v>38</c:v>
                </c:pt>
                <c:pt idx="194">
                  <c:v>39</c:v>
                </c:pt>
                <c:pt idx="195">
                  <c:v>40</c:v>
                </c:pt>
                <c:pt idx="196">
                  <c:v>41</c:v>
                </c:pt>
                <c:pt idx="197">
                  <c:v>42</c:v>
                </c:pt>
                <c:pt idx="198">
                  <c:v>43</c:v>
                </c:pt>
                <c:pt idx="199">
                  <c:v>44</c:v>
                </c:pt>
                <c:pt idx="200">
                  <c:v>45</c:v>
                </c:pt>
                <c:pt idx="201">
                  <c:v>46</c:v>
                </c:pt>
                <c:pt idx="202">
                  <c:v>47</c:v>
                </c:pt>
                <c:pt idx="203">
                  <c:v>48</c:v>
                </c:pt>
                <c:pt idx="204">
                  <c:v>49</c:v>
                </c:pt>
                <c:pt idx="205">
                  <c:v>50</c:v>
                </c:pt>
                <c:pt idx="206">
                  <c:v>51</c:v>
                </c:pt>
                <c:pt idx="207">
                  <c:v>52</c:v>
                </c:pt>
                <c:pt idx="208">
                  <c:v>53</c:v>
                </c:pt>
                <c:pt idx="209">
                  <c:v>1</c:v>
                </c:pt>
                <c:pt idx="210">
                  <c:v>2</c:v>
                </c:pt>
                <c:pt idx="211">
                  <c:v>3</c:v>
                </c:pt>
                <c:pt idx="212">
                  <c:v>4</c:v>
                </c:pt>
                <c:pt idx="213">
                  <c:v>5</c:v>
                </c:pt>
                <c:pt idx="214">
                  <c:v>6</c:v>
                </c:pt>
                <c:pt idx="215">
                  <c:v>7</c:v>
                </c:pt>
                <c:pt idx="216">
                  <c:v>8</c:v>
                </c:pt>
                <c:pt idx="217">
                  <c:v>9</c:v>
                </c:pt>
                <c:pt idx="218">
                  <c:v>10</c:v>
                </c:pt>
                <c:pt idx="219">
                  <c:v>11</c:v>
                </c:pt>
                <c:pt idx="220">
                  <c:v>12</c:v>
                </c:pt>
                <c:pt idx="221">
                  <c:v>13</c:v>
                </c:pt>
                <c:pt idx="222">
                  <c:v>14</c:v>
                </c:pt>
                <c:pt idx="223">
                  <c:v>15</c:v>
                </c:pt>
                <c:pt idx="224">
                  <c:v>16</c:v>
                </c:pt>
                <c:pt idx="225">
                  <c:v>17</c:v>
                </c:pt>
                <c:pt idx="226">
                  <c:v>18</c:v>
                </c:pt>
                <c:pt idx="227">
                  <c:v>19</c:v>
                </c:pt>
                <c:pt idx="228">
                  <c:v>20</c:v>
                </c:pt>
                <c:pt idx="229">
                  <c:v>21</c:v>
                </c:pt>
                <c:pt idx="230">
                  <c:v>22</c:v>
                </c:pt>
                <c:pt idx="231">
                  <c:v>23</c:v>
                </c:pt>
                <c:pt idx="232">
                  <c:v>24</c:v>
                </c:pt>
                <c:pt idx="233">
                  <c:v>25</c:v>
                </c:pt>
                <c:pt idx="234">
                  <c:v>26</c:v>
                </c:pt>
                <c:pt idx="235">
                  <c:v>27</c:v>
                </c:pt>
                <c:pt idx="236">
                  <c:v>28</c:v>
                </c:pt>
                <c:pt idx="237">
                  <c:v>29</c:v>
                </c:pt>
                <c:pt idx="238">
                  <c:v>30</c:v>
                </c:pt>
                <c:pt idx="239">
                  <c:v>31</c:v>
                </c:pt>
                <c:pt idx="240">
                  <c:v>32</c:v>
                </c:pt>
                <c:pt idx="241">
                  <c:v>33</c:v>
                </c:pt>
                <c:pt idx="242">
                  <c:v>34</c:v>
                </c:pt>
                <c:pt idx="243">
                  <c:v>35</c:v>
                </c:pt>
                <c:pt idx="244">
                  <c:v>36</c:v>
                </c:pt>
                <c:pt idx="245">
                  <c:v>37</c:v>
                </c:pt>
                <c:pt idx="246">
                  <c:v>38</c:v>
                </c:pt>
                <c:pt idx="247">
                  <c:v>39</c:v>
                </c:pt>
                <c:pt idx="248">
                  <c:v>40</c:v>
                </c:pt>
                <c:pt idx="249">
                  <c:v>41</c:v>
                </c:pt>
                <c:pt idx="250">
                  <c:v>42</c:v>
                </c:pt>
                <c:pt idx="251">
                  <c:v>43</c:v>
                </c:pt>
                <c:pt idx="252">
                  <c:v>44</c:v>
                </c:pt>
                <c:pt idx="253">
                  <c:v>45</c:v>
                </c:pt>
                <c:pt idx="254">
                  <c:v>46</c:v>
                </c:pt>
                <c:pt idx="255">
                  <c:v>47</c:v>
                </c:pt>
                <c:pt idx="256">
                  <c:v>48</c:v>
                </c:pt>
                <c:pt idx="257">
                  <c:v>49</c:v>
                </c:pt>
                <c:pt idx="258">
                  <c:v>50</c:v>
                </c:pt>
                <c:pt idx="259">
                  <c:v>51</c:v>
                </c:pt>
                <c:pt idx="260">
                  <c:v>52</c:v>
                </c:pt>
                <c:pt idx="261">
                  <c:v>1</c:v>
                </c:pt>
                <c:pt idx="262">
                  <c:v>2</c:v>
                </c:pt>
                <c:pt idx="263">
                  <c:v>3</c:v>
                </c:pt>
                <c:pt idx="264">
                  <c:v>4</c:v>
                </c:pt>
                <c:pt idx="265">
                  <c:v>5</c:v>
                </c:pt>
                <c:pt idx="266">
                  <c:v>6</c:v>
                </c:pt>
                <c:pt idx="267">
                  <c:v>7</c:v>
                </c:pt>
                <c:pt idx="268">
                  <c:v>8</c:v>
                </c:pt>
                <c:pt idx="269">
                  <c:v>9</c:v>
                </c:pt>
                <c:pt idx="270">
                  <c:v>10</c:v>
                </c:pt>
                <c:pt idx="271">
                  <c:v>11</c:v>
                </c:pt>
                <c:pt idx="272">
                  <c:v>12</c:v>
                </c:pt>
                <c:pt idx="273">
                  <c:v>13</c:v>
                </c:pt>
                <c:pt idx="274">
                  <c:v>14</c:v>
                </c:pt>
                <c:pt idx="275">
                  <c:v>15</c:v>
                </c:pt>
                <c:pt idx="276">
                  <c:v>16</c:v>
                </c:pt>
                <c:pt idx="277">
                  <c:v>17</c:v>
                </c:pt>
                <c:pt idx="278">
                  <c:v>18</c:v>
                </c:pt>
                <c:pt idx="279">
                  <c:v>19</c:v>
                </c:pt>
                <c:pt idx="280">
                  <c:v>20</c:v>
                </c:pt>
                <c:pt idx="281">
                  <c:v>21</c:v>
                </c:pt>
                <c:pt idx="282">
                  <c:v>22</c:v>
                </c:pt>
                <c:pt idx="283">
                  <c:v>23</c:v>
                </c:pt>
                <c:pt idx="284">
                  <c:v>24</c:v>
                </c:pt>
                <c:pt idx="285">
                  <c:v>25</c:v>
                </c:pt>
                <c:pt idx="286">
                  <c:v>26</c:v>
                </c:pt>
                <c:pt idx="287">
                  <c:v>27</c:v>
                </c:pt>
                <c:pt idx="288">
                  <c:v>28</c:v>
                </c:pt>
                <c:pt idx="289">
                  <c:v>29</c:v>
                </c:pt>
                <c:pt idx="290">
                  <c:v>30</c:v>
                </c:pt>
                <c:pt idx="291">
                  <c:v>31</c:v>
                </c:pt>
                <c:pt idx="292">
                  <c:v>32</c:v>
                </c:pt>
                <c:pt idx="293">
                  <c:v>33</c:v>
                </c:pt>
                <c:pt idx="294">
                  <c:v>34</c:v>
                </c:pt>
                <c:pt idx="295">
                  <c:v>35</c:v>
                </c:pt>
                <c:pt idx="296">
                  <c:v>36</c:v>
                </c:pt>
                <c:pt idx="297">
                  <c:v>37</c:v>
                </c:pt>
                <c:pt idx="298">
                  <c:v>38</c:v>
                </c:pt>
                <c:pt idx="299">
                  <c:v>39</c:v>
                </c:pt>
                <c:pt idx="300">
                  <c:v>40</c:v>
                </c:pt>
                <c:pt idx="301">
                  <c:v>41</c:v>
                </c:pt>
                <c:pt idx="302">
                  <c:v>42</c:v>
                </c:pt>
                <c:pt idx="303">
                  <c:v>43</c:v>
                </c:pt>
                <c:pt idx="304">
                  <c:v>44</c:v>
                </c:pt>
                <c:pt idx="305">
                  <c:v>45</c:v>
                </c:pt>
                <c:pt idx="306">
                  <c:v>46</c:v>
                </c:pt>
                <c:pt idx="307">
                  <c:v>47</c:v>
                </c:pt>
                <c:pt idx="308">
                  <c:v>48</c:v>
                </c:pt>
                <c:pt idx="309">
                  <c:v>49</c:v>
                </c:pt>
                <c:pt idx="310">
                  <c:v>50</c:v>
                </c:pt>
                <c:pt idx="311">
                  <c:v>51</c:v>
                </c:pt>
                <c:pt idx="312">
                  <c:v>52</c:v>
                </c:pt>
              </c:numCache>
            </c:numRef>
          </c:cat>
          <c:val>
            <c:numRef>
              <c:f>Sheet1!$E$2:$E$314</c:f>
              <c:numCache>
                <c:formatCode>General</c:formatCode>
                <c:ptCount val="313"/>
                <c:pt idx="0">
                  <c:v>331.28060079639192</c:v>
                </c:pt>
                <c:pt idx="1">
                  <c:v>1098.2726851956672</c:v>
                </c:pt>
                <c:pt idx="2">
                  <c:v>1828.3199900639788</c:v>
                </c:pt>
                <c:pt idx="3">
                  <c:v>2615.413766629576</c:v>
                </c:pt>
                <c:pt idx="4">
                  <c:v>2663.8251373679373</c:v>
                </c:pt>
                <c:pt idx="5">
                  <c:v>2431.734618005235</c:v>
                </c:pt>
                <c:pt idx="6">
                  <c:v>1891.3974084677598</c:v>
                </c:pt>
                <c:pt idx="7">
                  <c:v>1652.469604757523</c:v>
                </c:pt>
                <c:pt idx="8">
                  <c:v>1469.5668179315335</c:v>
                </c:pt>
                <c:pt idx="9">
                  <c:v>1305.0101353763953</c:v>
                </c:pt>
                <c:pt idx="10">
                  <c:v>1013.1629483512498</c:v>
                </c:pt>
                <c:pt idx="11">
                  <c:v>811.62474180109905</c:v>
                </c:pt>
                <c:pt idx="12">
                  <c:v>626.83832935000385</c:v>
                </c:pt>
                <c:pt idx="13">
                  <c:v>539.9015752967349</c:v>
                </c:pt>
                <c:pt idx="14">
                  <c:v>610.25412379562852</c:v>
                </c:pt>
                <c:pt idx="15">
                  <c:v>462.38946606897377</c:v>
                </c:pt>
                <c:pt idx="16">
                  <c:v>419.65430950039615</c:v>
                </c:pt>
                <c:pt idx="17">
                  <c:v>232.7356627053033</c:v>
                </c:pt>
                <c:pt idx="18">
                  <c:v>27.509000000000015</c:v>
                </c:pt>
                <c:pt idx="19">
                  <c:v>213.21514762833942</c:v>
                </c:pt>
                <c:pt idx="20">
                  <c:v>141.43255577173102</c:v>
                </c:pt>
                <c:pt idx="21">
                  <c:v>48.689622637552702</c:v>
                </c:pt>
                <c:pt idx="22">
                  <c:v>159.38667261912599</c:v>
                </c:pt>
                <c:pt idx="23">
                  <c:v>50.585918565857014</c:v>
                </c:pt>
                <c:pt idx="24">
                  <c:v>96.006884472756951</c:v>
                </c:pt>
                <c:pt idx="25">
                  <c:v>154.22490930124184</c:v>
                </c:pt>
                <c:pt idx="26">
                  <c:v>229.90217576875364</c:v>
                </c:pt>
                <c:pt idx="27">
                  <c:v>171.32145912051385</c:v>
                </c:pt>
                <c:pt idx="28">
                  <c:v>295.95436147352041</c:v>
                </c:pt>
                <c:pt idx="29">
                  <c:v>23.161188345297433</c:v>
                </c:pt>
                <c:pt idx="30">
                  <c:v>23.521164837190668</c:v>
                </c:pt>
                <c:pt idx="31">
                  <c:v>-125.30223536196399</c:v>
                </c:pt>
                <c:pt idx="32">
                  <c:v>-78.712023508333573</c:v>
                </c:pt>
                <c:pt idx="33">
                  <c:v>35.543471350488971</c:v>
                </c:pt>
                <c:pt idx="34">
                  <c:v>-1.8104561556064027</c:v>
                </c:pt>
                <c:pt idx="35">
                  <c:v>-2.6425650587649443</c:v>
                </c:pt>
                <c:pt idx="36">
                  <c:v>-15.27091659672476</c:v>
                </c:pt>
                <c:pt idx="37">
                  <c:v>115.36158886905571</c:v>
                </c:pt>
                <c:pt idx="38">
                  <c:v>6.7561741018062094</c:v>
                </c:pt>
                <c:pt idx="39">
                  <c:v>0.95449518319878734</c:v>
                </c:pt>
                <c:pt idx="40">
                  <c:v>86.664685520273792</c:v>
                </c:pt>
                <c:pt idx="41">
                  <c:v>39.808433945460251</c:v>
                </c:pt>
                <c:pt idx="42">
                  <c:v>67.501102928281057</c:v>
                </c:pt>
                <c:pt idx="43">
                  <c:v>22.54832967460959</c:v>
                </c:pt>
                <c:pt idx="44">
                  <c:v>94.164674264108839</c:v>
                </c:pt>
                <c:pt idx="45">
                  <c:v>27.583935103537328</c:v>
                </c:pt>
                <c:pt idx="46">
                  <c:v>118.06409366366609</c:v>
                </c:pt>
                <c:pt idx="47">
                  <c:v>99.407149273321807</c:v>
                </c:pt>
                <c:pt idx="48">
                  <c:v>174.36288743811804</c:v>
                </c:pt>
                <c:pt idx="49">
                  <c:v>258.89432040999407</c:v>
                </c:pt>
                <c:pt idx="50">
                  <c:v>422.06330551729559</c:v>
                </c:pt>
                <c:pt idx="51">
                  <c:v>558.81350148245258</c:v>
                </c:pt>
                <c:pt idx="52">
                  <c:v>399.26060079639194</c:v>
                </c:pt>
                <c:pt idx="53">
                  <c:v>975.90868519566709</c:v>
                </c:pt>
                <c:pt idx="54">
                  <c:v>1607.3849900639789</c:v>
                </c:pt>
                <c:pt idx="55">
                  <c:v>2227.9277666295761</c:v>
                </c:pt>
                <c:pt idx="56">
                  <c:v>2493.8751373679374</c:v>
                </c:pt>
                <c:pt idx="57">
                  <c:v>2078.2386180052349</c:v>
                </c:pt>
                <c:pt idx="58">
                  <c:v>1701.0534084677597</c:v>
                </c:pt>
                <c:pt idx="59">
                  <c:v>1363.5546047575231</c:v>
                </c:pt>
                <c:pt idx="60">
                  <c:v>1194.2478179315335</c:v>
                </c:pt>
                <c:pt idx="61">
                  <c:v>931.12013537639552</c:v>
                </c:pt>
                <c:pt idx="62">
                  <c:v>782.03094835124978</c:v>
                </c:pt>
                <c:pt idx="63">
                  <c:v>563.4977418010991</c:v>
                </c:pt>
                <c:pt idx="64">
                  <c:v>494.2773293500037</c:v>
                </c:pt>
                <c:pt idx="65">
                  <c:v>342.75957529673485</c:v>
                </c:pt>
                <c:pt idx="66">
                  <c:v>192.17712379562829</c:v>
                </c:pt>
                <c:pt idx="67">
                  <c:v>132.68646606897391</c:v>
                </c:pt>
                <c:pt idx="68">
                  <c:v>96.749309500396294</c:v>
                </c:pt>
                <c:pt idx="69">
                  <c:v>283.7206627053032</c:v>
                </c:pt>
                <c:pt idx="70">
                  <c:v>251.84299999999996</c:v>
                </c:pt>
                <c:pt idx="71">
                  <c:v>97.649147628339279</c:v>
                </c:pt>
                <c:pt idx="72">
                  <c:v>223.00855577173104</c:v>
                </c:pt>
                <c:pt idx="73">
                  <c:v>28.295622637552697</c:v>
                </c:pt>
                <c:pt idx="74">
                  <c:v>26.825672619125839</c:v>
                </c:pt>
                <c:pt idx="75">
                  <c:v>77.777918565857021</c:v>
                </c:pt>
                <c:pt idx="76">
                  <c:v>-39.953115527243085</c:v>
                </c:pt>
                <c:pt idx="77">
                  <c:v>133.83090930124195</c:v>
                </c:pt>
                <c:pt idx="78">
                  <c:v>66.750175768753707</c:v>
                </c:pt>
                <c:pt idx="79">
                  <c:v>225.70545912051386</c:v>
                </c:pt>
                <c:pt idx="80">
                  <c:v>115.80736147352047</c:v>
                </c:pt>
                <c:pt idx="81">
                  <c:v>57.151188345297442</c:v>
                </c:pt>
                <c:pt idx="82">
                  <c:v>71.10716483719068</c:v>
                </c:pt>
                <c:pt idx="83">
                  <c:v>7.2587646380359274</c:v>
                </c:pt>
                <c:pt idx="84">
                  <c:v>301.9759764916663</c:v>
                </c:pt>
                <c:pt idx="85">
                  <c:v>55.937471350488977</c:v>
                </c:pt>
                <c:pt idx="86">
                  <c:v>32.179543844393606</c:v>
                </c:pt>
                <c:pt idx="87">
                  <c:v>-33.233565058764839</c:v>
                </c:pt>
                <c:pt idx="88">
                  <c:v>-42.462916596724767</c:v>
                </c:pt>
                <c:pt idx="89">
                  <c:v>-3.6034111309443233</c:v>
                </c:pt>
                <c:pt idx="90">
                  <c:v>3.3571741018062085</c:v>
                </c:pt>
                <c:pt idx="91">
                  <c:v>-5.8435048168012145</c:v>
                </c:pt>
                <c:pt idx="92">
                  <c:v>-28.901314479726238</c:v>
                </c:pt>
                <c:pt idx="93">
                  <c:v>-31.570566054539881</c:v>
                </c:pt>
                <c:pt idx="94">
                  <c:v>-7.2768970717189632</c:v>
                </c:pt>
                <c:pt idx="95">
                  <c:v>-96.416670325390442</c:v>
                </c:pt>
                <c:pt idx="96">
                  <c:v>46.578674264108827</c:v>
                </c:pt>
                <c:pt idx="97">
                  <c:v>10.588935103537437</c:v>
                </c:pt>
                <c:pt idx="98">
                  <c:v>-31.491906336333955</c:v>
                </c:pt>
                <c:pt idx="99">
                  <c:v>-67.143850726678124</c:v>
                </c:pt>
                <c:pt idx="100">
                  <c:v>75.791887438117897</c:v>
                </c:pt>
                <c:pt idx="101">
                  <c:v>122.93432040999414</c:v>
                </c:pt>
                <c:pt idx="102">
                  <c:v>221.52230551729565</c:v>
                </c:pt>
                <c:pt idx="103">
                  <c:v>371.86850148245264</c:v>
                </c:pt>
                <c:pt idx="104">
                  <c:v>409.45760079639183</c:v>
                </c:pt>
                <c:pt idx="105">
                  <c:v>782.16568519566715</c:v>
                </c:pt>
                <c:pt idx="106">
                  <c:v>1437.4349900639786</c:v>
                </c:pt>
                <c:pt idx="107">
                  <c:v>2187.1397666295761</c:v>
                </c:pt>
                <c:pt idx="108">
                  <c:v>2446.2891373679372</c:v>
                </c:pt>
                <c:pt idx="109">
                  <c:v>1935.4806180052346</c:v>
                </c:pt>
                <c:pt idx="110">
                  <c:v>1626.2754084677599</c:v>
                </c:pt>
                <c:pt idx="111">
                  <c:v>1278.5796047575232</c:v>
                </c:pt>
                <c:pt idx="112">
                  <c:v>1037.8938179315337</c:v>
                </c:pt>
                <c:pt idx="113">
                  <c:v>784.96313537639583</c:v>
                </c:pt>
                <c:pt idx="114">
                  <c:v>731.04594835124988</c:v>
                </c:pt>
                <c:pt idx="115">
                  <c:v>560.09874180109921</c:v>
                </c:pt>
                <c:pt idx="116">
                  <c:v>545.26232935000382</c:v>
                </c:pt>
                <c:pt idx="117">
                  <c:v>325.76457529673473</c:v>
                </c:pt>
                <c:pt idx="118">
                  <c:v>168.3841237956284</c:v>
                </c:pt>
                <c:pt idx="119">
                  <c:v>241.45446606897383</c:v>
                </c:pt>
                <c:pt idx="120">
                  <c:v>151.13330950039619</c:v>
                </c:pt>
                <c:pt idx="121">
                  <c:v>-69.775337294696669</c:v>
                </c:pt>
                <c:pt idx="122">
                  <c:v>139.67600000000004</c:v>
                </c:pt>
                <c:pt idx="123">
                  <c:v>2.4771476283392531</c:v>
                </c:pt>
                <c:pt idx="124">
                  <c:v>46.260555771730992</c:v>
                </c:pt>
                <c:pt idx="125">
                  <c:v>256.02862263755276</c:v>
                </c:pt>
                <c:pt idx="126">
                  <c:v>54.017672619125847</c:v>
                </c:pt>
                <c:pt idx="127">
                  <c:v>16.595918565857005</c:v>
                </c:pt>
                <c:pt idx="128">
                  <c:v>-22.958115527243081</c:v>
                </c:pt>
                <c:pt idx="129">
                  <c:v>-148.28609069875802</c:v>
                </c:pt>
                <c:pt idx="130">
                  <c:v>-143.98782423124635</c:v>
                </c:pt>
                <c:pt idx="131">
                  <c:v>-90.40154087948622</c:v>
                </c:pt>
                <c:pt idx="132">
                  <c:v>-237.68863852647951</c:v>
                </c:pt>
                <c:pt idx="133">
                  <c:v>57.151188345297442</c:v>
                </c:pt>
                <c:pt idx="134">
                  <c:v>-68.251835162809243</c:v>
                </c:pt>
                <c:pt idx="135">
                  <c:v>-67.519235361963979</c:v>
                </c:pt>
                <c:pt idx="136">
                  <c:v>2.863976491666449</c:v>
                </c:pt>
                <c:pt idx="137">
                  <c:v>-8.6435286495110404</c:v>
                </c:pt>
                <c:pt idx="138">
                  <c:v>-12.007456155606405</c:v>
                </c:pt>
                <c:pt idx="139">
                  <c:v>41.544434941235181</c:v>
                </c:pt>
                <c:pt idx="140">
                  <c:v>11.921083403275247</c:v>
                </c:pt>
                <c:pt idx="141">
                  <c:v>-20.598411130944328</c:v>
                </c:pt>
                <c:pt idx="142">
                  <c:v>20.352174101806213</c:v>
                </c:pt>
                <c:pt idx="143">
                  <c:v>72.333495183198806</c:v>
                </c:pt>
                <c:pt idx="144">
                  <c:v>-103.67931447972626</c:v>
                </c:pt>
                <c:pt idx="145">
                  <c:v>-7.7775660545397614</c:v>
                </c:pt>
                <c:pt idx="146">
                  <c:v>23.314102928280931</c:v>
                </c:pt>
                <c:pt idx="147">
                  <c:v>32.745329674609593</c:v>
                </c:pt>
                <c:pt idx="148">
                  <c:v>-18.002325735891304</c:v>
                </c:pt>
                <c:pt idx="149">
                  <c:v>51.376935103537448</c:v>
                </c:pt>
                <c:pt idx="150">
                  <c:v>26.291093663666061</c:v>
                </c:pt>
                <c:pt idx="151">
                  <c:v>116.40214927332192</c:v>
                </c:pt>
                <c:pt idx="152">
                  <c:v>96.185887438117902</c:v>
                </c:pt>
                <c:pt idx="153">
                  <c:v>214.70732040999417</c:v>
                </c:pt>
                <c:pt idx="154">
                  <c:v>367.67930551729557</c:v>
                </c:pt>
                <c:pt idx="155">
                  <c:v>667.58150148245261</c:v>
                </c:pt>
                <c:pt idx="156">
                  <c:v>1007.6816007963918</c:v>
                </c:pt>
                <c:pt idx="157">
                  <c:v>1013.297685195667</c:v>
                </c:pt>
                <c:pt idx="158">
                  <c:v>1818.1229900639787</c:v>
                </c:pt>
                <c:pt idx="159">
                  <c:v>2125.9577666295763</c:v>
                </c:pt>
                <c:pt idx="160">
                  <c:v>2228.7531373679371</c:v>
                </c:pt>
                <c:pt idx="161">
                  <c:v>1738.3386180052348</c:v>
                </c:pt>
                <c:pt idx="162">
                  <c:v>1520.9064084677598</c:v>
                </c:pt>
                <c:pt idx="163">
                  <c:v>1122.2256047575229</c:v>
                </c:pt>
                <c:pt idx="164">
                  <c:v>997.10581793153381</c:v>
                </c:pt>
                <c:pt idx="165">
                  <c:v>716.98313537639581</c:v>
                </c:pt>
                <c:pt idx="166">
                  <c:v>520.30794835124982</c:v>
                </c:pt>
                <c:pt idx="167">
                  <c:v>464.92674180109918</c:v>
                </c:pt>
                <c:pt idx="168">
                  <c:v>334.524329350004</c:v>
                </c:pt>
                <c:pt idx="169">
                  <c:v>237.39057529673494</c:v>
                </c:pt>
                <c:pt idx="170">
                  <c:v>29.025123795628474</c:v>
                </c:pt>
                <c:pt idx="171">
                  <c:v>44.31246606897389</c:v>
                </c:pt>
                <c:pt idx="172">
                  <c:v>-25.614690499603739</c:v>
                </c:pt>
                <c:pt idx="173">
                  <c:v>-161.54833729469658</c:v>
                </c:pt>
                <c:pt idx="174">
                  <c:v>143.07500000000005</c:v>
                </c:pt>
                <c:pt idx="175">
                  <c:v>-65.502852371660765</c:v>
                </c:pt>
                <c:pt idx="176">
                  <c:v>-82.901444228269042</c:v>
                </c:pt>
                <c:pt idx="177">
                  <c:v>-77.073377362447332</c:v>
                </c:pt>
                <c:pt idx="178">
                  <c:v>-112.5333273808742</c:v>
                </c:pt>
                <c:pt idx="179">
                  <c:v>-105.76808143414303</c:v>
                </c:pt>
                <c:pt idx="180">
                  <c:v>-53.549115527243089</c:v>
                </c:pt>
                <c:pt idx="181">
                  <c:v>-178.87709069875802</c:v>
                </c:pt>
                <c:pt idx="182">
                  <c:v>-205.16982423124637</c:v>
                </c:pt>
                <c:pt idx="183">
                  <c:v>-199.16954087948625</c:v>
                </c:pt>
                <c:pt idx="184">
                  <c:v>-156.11263852647949</c:v>
                </c:pt>
                <c:pt idx="185">
                  <c:v>182.91418834529725</c:v>
                </c:pt>
                <c:pt idx="186">
                  <c:v>71.10716483719068</c:v>
                </c:pt>
                <c:pt idx="187">
                  <c:v>54.84476463803594</c:v>
                </c:pt>
                <c:pt idx="188">
                  <c:v>16.459976491666453</c:v>
                </c:pt>
                <c:pt idx="189">
                  <c:v>42.341471350488973</c:v>
                </c:pt>
                <c:pt idx="190">
                  <c:v>49.174543844393611</c:v>
                </c:pt>
                <c:pt idx="191">
                  <c:v>65.337434941235074</c:v>
                </c:pt>
                <c:pt idx="192">
                  <c:v>73.103083403275264</c:v>
                </c:pt>
                <c:pt idx="193">
                  <c:v>-47.790411130944221</c:v>
                </c:pt>
                <c:pt idx="194">
                  <c:v>288.87317410180606</c:v>
                </c:pt>
                <c:pt idx="195">
                  <c:v>-50.030504816801226</c:v>
                </c:pt>
                <c:pt idx="196">
                  <c:v>-1.7093144797262312</c:v>
                </c:pt>
                <c:pt idx="197">
                  <c:v>77.197433945460148</c:v>
                </c:pt>
                <c:pt idx="198">
                  <c:v>13.117102928281042</c:v>
                </c:pt>
                <c:pt idx="199">
                  <c:v>-31.835670325390424</c:v>
                </c:pt>
                <c:pt idx="200">
                  <c:v>29.583674264108708</c:v>
                </c:pt>
                <c:pt idx="201">
                  <c:v>51.376935103537448</c:v>
                </c:pt>
                <c:pt idx="202">
                  <c:v>39.887093663666064</c:v>
                </c:pt>
                <c:pt idx="203">
                  <c:v>238.76614927332173</c:v>
                </c:pt>
                <c:pt idx="204">
                  <c:v>92.786887438117901</c:v>
                </c:pt>
                <c:pt idx="205">
                  <c:v>112.73732040999414</c:v>
                </c:pt>
                <c:pt idx="206">
                  <c:v>235.11830551729565</c:v>
                </c:pt>
                <c:pt idx="207">
                  <c:v>286.89350148245251</c:v>
                </c:pt>
                <c:pt idx="208">
                  <c:v>33.037717643794508</c:v>
                </c:pt>
                <c:pt idx="209">
                  <c:v>-134.3823992036082</c:v>
                </c:pt>
                <c:pt idx="210">
                  <c:v>744.77668519566726</c:v>
                </c:pt>
                <c:pt idx="211">
                  <c:v>1366.0559900639787</c:v>
                </c:pt>
                <c:pt idx="212">
                  <c:v>2054.578766629576</c:v>
                </c:pt>
                <c:pt idx="213">
                  <c:v>2398.703137367937</c:v>
                </c:pt>
                <c:pt idx="214">
                  <c:v>2302.5726180052347</c:v>
                </c:pt>
                <c:pt idx="215">
                  <c:v>1762.23540846776</c:v>
                </c:pt>
                <c:pt idx="216">
                  <c:v>1434.933604757523</c:v>
                </c:pt>
                <c:pt idx="217">
                  <c:v>1245.2328179315336</c:v>
                </c:pt>
                <c:pt idx="218">
                  <c:v>903.92813537639552</c:v>
                </c:pt>
                <c:pt idx="219">
                  <c:v>567.89394835125006</c:v>
                </c:pt>
                <c:pt idx="220">
                  <c:v>621.280741801099</c:v>
                </c:pt>
                <c:pt idx="221">
                  <c:v>409.30232935000379</c:v>
                </c:pt>
                <c:pt idx="222">
                  <c:v>278.17857529673495</c:v>
                </c:pt>
                <c:pt idx="223">
                  <c:v>107.20212379562838</c:v>
                </c:pt>
                <c:pt idx="224">
                  <c:v>91.898466068973903</c:v>
                </c:pt>
                <c:pt idx="225">
                  <c:v>100.14830950039629</c:v>
                </c:pt>
                <c:pt idx="226">
                  <c:v>-66.376337294696782</c:v>
                </c:pt>
                <c:pt idx="227">
                  <c:v>-159.43600000000004</c:v>
                </c:pt>
                <c:pt idx="228">
                  <c:v>-14.517852371660751</c:v>
                </c:pt>
                <c:pt idx="229">
                  <c:v>-11.522444228269137</c:v>
                </c:pt>
                <c:pt idx="230">
                  <c:v>-70.27537736244733</c:v>
                </c:pt>
                <c:pt idx="231">
                  <c:v>-3.7653273808741687</c:v>
                </c:pt>
                <c:pt idx="232">
                  <c:v>-54.783081434143128</c:v>
                </c:pt>
                <c:pt idx="233">
                  <c:v>65.415884472756943</c:v>
                </c:pt>
                <c:pt idx="234">
                  <c:v>116.83590930124205</c:v>
                </c:pt>
                <c:pt idx="235">
                  <c:v>59.952175768753705</c:v>
                </c:pt>
                <c:pt idx="236">
                  <c:v>-185.57354087948625</c:v>
                </c:pt>
                <c:pt idx="237">
                  <c:v>-91.531638526479469</c:v>
                </c:pt>
                <c:pt idx="238">
                  <c:v>-265.75381165470253</c:v>
                </c:pt>
                <c:pt idx="239">
                  <c:v>-170.22183516280927</c:v>
                </c:pt>
                <c:pt idx="240">
                  <c:v>3.8597646380359265</c:v>
                </c:pt>
                <c:pt idx="241">
                  <c:v>-139.89402350833348</c:v>
                </c:pt>
                <c:pt idx="242">
                  <c:v>-63.027528649511055</c:v>
                </c:pt>
                <c:pt idx="243">
                  <c:v>-62.992456155606419</c:v>
                </c:pt>
                <c:pt idx="244">
                  <c:v>-23.03656505876495</c:v>
                </c:pt>
                <c:pt idx="245">
                  <c:v>32.315083403275253</c:v>
                </c:pt>
                <c:pt idx="246">
                  <c:v>3.1945888690556785</c:v>
                </c:pt>
                <c:pt idx="247">
                  <c:v>-115.60782589819382</c:v>
                </c:pt>
                <c:pt idx="248">
                  <c:v>79.131495183198808</c:v>
                </c:pt>
                <c:pt idx="249">
                  <c:v>66.270685520273787</c:v>
                </c:pt>
                <c:pt idx="250">
                  <c:v>-38.368566054539883</c:v>
                </c:pt>
                <c:pt idx="251">
                  <c:v>-51.463897071719089</c:v>
                </c:pt>
                <c:pt idx="252">
                  <c:v>87.129329674609608</c:v>
                </c:pt>
                <c:pt idx="253">
                  <c:v>60.17467426410883</c:v>
                </c:pt>
                <c:pt idx="254">
                  <c:v>88.765935103537345</c:v>
                </c:pt>
                <c:pt idx="255">
                  <c:v>97.67009366366608</c:v>
                </c:pt>
                <c:pt idx="256">
                  <c:v>4.235149273321781</c:v>
                </c:pt>
                <c:pt idx="257">
                  <c:v>41.801887438117888</c:v>
                </c:pt>
                <c:pt idx="258">
                  <c:v>102.54032040999414</c:v>
                </c:pt>
                <c:pt idx="259">
                  <c:v>337.08830551729545</c:v>
                </c:pt>
                <c:pt idx="260">
                  <c:v>487.43450148245267</c:v>
                </c:pt>
                <c:pt idx="261">
                  <c:v>140.93660079639176</c:v>
                </c:pt>
                <c:pt idx="262">
                  <c:v>829.75168519566716</c:v>
                </c:pt>
                <c:pt idx="263">
                  <c:v>1321.8689900639788</c:v>
                </c:pt>
                <c:pt idx="264">
                  <c:v>2051.1797666295761</c:v>
                </c:pt>
                <c:pt idx="265">
                  <c:v>2228.7531373679371</c:v>
                </c:pt>
                <c:pt idx="266">
                  <c:v>2057.8446180052347</c:v>
                </c:pt>
                <c:pt idx="267">
                  <c:v>1490.3154084677599</c:v>
                </c:pt>
                <c:pt idx="268">
                  <c:v>1200.402604757523</c:v>
                </c:pt>
                <c:pt idx="269">
                  <c:v>963.11581793153357</c:v>
                </c:pt>
                <c:pt idx="270">
                  <c:v>795.16013537639571</c:v>
                </c:pt>
                <c:pt idx="271">
                  <c:v>489.71694835124993</c:v>
                </c:pt>
                <c:pt idx="272">
                  <c:v>369.75474180109916</c:v>
                </c:pt>
                <c:pt idx="273">
                  <c:v>252.94832935000397</c:v>
                </c:pt>
                <c:pt idx="274">
                  <c:v>312.16857529673473</c:v>
                </c:pt>
                <c:pt idx="275">
                  <c:v>277.15212379562843</c:v>
                </c:pt>
                <c:pt idx="276">
                  <c:v>190.46946606897393</c:v>
                </c:pt>
                <c:pt idx="277">
                  <c:v>83.15330950039629</c:v>
                </c:pt>
                <c:pt idx="278">
                  <c:v>239.5336627053033</c:v>
                </c:pt>
                <c:pt idx="279">
                  <c:v>-125.44600000000003</c:v>
                </c:pt>
                <c:pt idx="280">
                  <c:v>22.871147628339259</c:v>
                </c:pt>
                <c:pt idx="281">
                  <c:v>-144.08344422826906</c:v>
                </c:pt>
                <c:pt idx="282">
                  <c:v>-97.467377362447337</c:v>
                </c:pt>
                <c:pt idx="283">
                  <c:v>-71.745327380874187</c:v>
                </c:pt>
                <c:pt idx="284">
                  <c:v>43.787918565857012</c:v>
                </c:pt>
                <c:pt idx="285">
                  <c:v>-29.756115527243082</c:v>
                </c:pt>
                <c:pt idx="286">
                  <c:v>-73.508090698757997</c:v>
                </c:pt>
                <c:pt idx="287">
                  <c:v>-1.2298242312463117</c:v>
                </c:pt>
                <c:pt idx="288">
                  <c:v>86.346459120513714</c:v>
                </c:pt>
                <c:pt idx="289">
                  <c:v>81.817361473520464</c:v>
                </c:pt>
                <c:pt idx="290">
                  <c:v>-41.419811654702585</c:v>
                </c:pt>
                <c:pt idx="291">
                  <c:v>77.905164837190682</c:v>
                </c:pt>
                <c:pt idx="292">
                  <c:v>133.02176463803596</c:v>
                </c:pt>
                <c:pt idx="293">
                  <c:v>-85.510023508333575</c:v>
                </c:pt>
                <c:pt idx="294">
                  <c:v>-46.03252864951105</c:v>
                </c:pt>
                <c:pt idx="295">
                  <c:v>18.583543844393603</c:v>
                </c:pt>
                <c:pt idx="296">
                  <c:v>-29.834565058764952</c:v>
                </c:pt>
                <c:pt idx="297">
                  <c:v>-42.462916596724767</c:v>
                </c:pt>
                <c:pt idx="298">
                  <c:v>-27.39641113094433</c:v>
                </c:pt>
                <c:pt idx="299">
                  <c:v>-183.58782589819384</c:v>
                </c:pt>
                <c:pt idx="300">
                  <c:v>-53.429504816801227</c:v>
                </c:pt>
                <c:pt idx="301">
                  <c:v>8.4876855202737715</c:v>
                </c:pt>
                <c:pt idx="302">
                  <c:v>-28.171566054539767</c:v>
                </c:pt>
                <c:pt idx="303">
                  <c:v>2.9201029282809259</c:v>
                </c:pt>
                <c:pt idx="304">
                  <c:v>42.942329674609596</c:v>
                </c:pt>
                <c:pt idx="305">
                  <c:v>-106.37632573589133</c:v>
                </c:pt>
                <c:pt idx="306">
                  <c:v>-101.57806489646271</c:v>
                </c:pt>
                <c:pt idx="307">
                  <c:v>-55.284906336333961</c:v>
                </c:pt>
                <c:pt idx="308">
                  <c:v>-87.53785072667813</c:v>
                </c:pt>
                <c:pt idx="309">
                  <c:v>79.190887438117898</c:v>
                </c:pt>
                <c:pt idx="310">
                  <c:v>160.32332040999415</c:v>
                </c:pt>
                <c:pt idx="311">
                  <c:v>350.68430551729546</c:v>
                </c:pt>
                <c:pt idx="312">
                  <c:v>650.586501482452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B3D-4EC0-A8D6-5E64F831BF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27113808"/>
        <c:axId val="1626116352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Sheet1!$B$1</c15:sqref>
                        </c15:formulaRef>
                      </c:ext>
                    </c:extLst>
                    <c:strCache>
                      <c:ptCount val="1"/>
                      <c:pt idx="0">
                        <c:v>発熱トリアージ件数</c:v>
                      </c:pt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cat>
                  <c:numRef>
                    <c:extLst>
                      <c:ext uri="{02D57815-91ED-43cb-92C2-25804820EDAC}">
                        <c15:formulaRef>
                          <c15:sqref>Sheet1!$A$2:$A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1</c:v>
                      </c:pt>
                      <c:pt idx="1">
                        <c:v>2</c:v>
                      </c:pt>
                      <c:pt idx="2">
                        <c:v>3</c:v>
                      </c:pt>
                      <c:pt idx="3">
                        <c:v>4</c:v>
                      </c:pt>
                      <c:pt idx="4">
                        <c:v>5</c:v>
                      </c:pt>
                      <c:pt idx="5">
                        <c:v>6</c:v>
                      </c:pt>
                      <c:pt idx="6">
                        <c:v>7</c:v>
                      </c:pt>
                      <c:pt idx="7">
                        <c:v>8</c:v>
                      </c:pt>
                      <c:pt idx="8">
                        <c:v>9</c:v>
                      </c:pt>
                      <c:pt idx="9">
                        <c:v>10</c:v>
                      </c:pt>
                      <c:pt idx="10">
                        <c:v>11</c:v>
                      </c:pt>
                      <c:pt idx="11">
                        <c:v>12</c:v>
                      </c:pt>
                      <c:pt idx="12">
                        <c:v>13</c:v>
                      </c:pt>
                      <c:pt idx="13">
                        <c:v>14</c:v>
                      </c:pt>
                      <c:pt idx="14">
                        <c:v>15</c:v>
                      </c:pt>
                      <c:pt idx="15">
                        <c:v>16</c:v>
                      </c:pt>
                      <c:pt idx="16">
                        <c:v>17</c:v>
                      </c:pt>
                      <c:pt idx="17">
                        <c:v>18</c:v>
                      </c:pt>
                      <c:pt idx="18">
                        <c:v>19</c:v>
                      </c:pt>
                      <c:pt idx="19">
                        <c:v>20</c:v>
                      </c:pt>
                      <c:pt idx="20">
                        <c:v>21</c:v>
                      </c:pt>
                      <c:pt idx="21">
                        <c:v>22</c:v>
                      </c:pt>
                      <c:pt idx="22">
                        <c:v>23</c:v>
                      </c:pt>
                      <c:pt idx="23">
                        <c:v>24</c:v>
                      </c:pt>
                      <c:pt idx="24">
                        <c:v>25</c:v>
                      </c:pt>
                      <c:pt idx="25">
                        <c:v>26</c:v>
                      </c:pt>
                      <c:pt idx="26">
                        <c:v>27</c:v>
                      </c:pt>
                      <c:pt idx="27">
                        <c:v>28</c:v>
                      </c:pt>
                      <c:pt idx="28">
                        <c:v>29</c:v>
                      </c:pt>
                      <c:pt idx="29">
                        <c:v>30</c:v>
                      </c:pt>
                      <c:pt idx="30">
                        <c:v>31</c:v>
                      </c:pt>
                      <c:pt idx="31">
                        <c:v>32</c:v>
                      </c:pt>
                      <c:pt idx="32">
                        <c:v>33</c:v>
                      </c:pt>
                      <c:pt idx="33">
                        <c:v>34</c:v>
                      </c:pt>
                      <c:pt idx="34">
                        <c:v>35</c:v>
                      </c:pt>
                      <c:pt idx="35">
                        <c:v>36</c:v>
                      </c:pt>
                      <c:pt idx="36">
                        <c:v>37</c:v>
                      </c:pt>
                      <c:pt idx="37">
                        <c:v>38</c:v>
                      </c:pt>
                      <c:pt idx="38">
                        <c:v>39</c:v>
                      </c:pt>
                      <c:pt idx="39">
                        <c:v>40</c:v>
                      </c:pt>
                      <c:pt idx="40">
                        <c:v>41</c:v>
                      </c:pt>
                      <c:pt idx="41">
                        <c:v>42</c:v>
                      </c:pt>
                      <c:pt idx="42">
                        <c:v>43</c:v>
                      </c:pt>
                      <c:pt idx="43">
                        <c:v>44</c:v>
                      </c:pt>
                      <c:pt idx="44">
                        <c:v>45</c:v>
                      </c:pt>
                      <c:pt idx="45">
                        <c:v>46</c:v>
                      </c:pt>
                      <c:pt idx="46">
                        <c:v>47</c:v>
                      </c:pt>
                      <c:pt idx="47">
                        <c:v>48</c:v>
                      </c:pt>
                      <c:pt idx="48">
                        <c:v>49</c:v>
                      </c:pt>
                      <c:pt idx="49">
                        <c:v>50</c:v>
                      </c:pt>
                      <c:pt idx="50">
                        <c:v>51</c:v>
                      </c:pt>
                      <c:pt idx="51">
                        <c:v>52</c:v>
                      </c:pt>
                      <c:pt idx="52">
                        <c:v>1</c:v>
                      </c:pt>
                      <c:pt idx="53">
                        <c:v>2</c:v>
                      </c:pt>
                      <c:pt idx="54">
                        <c:v>3</c:v>
                      </c:pt>
                      <c:pt idx="55">
                        <c:v>4</c:v>
                      </c:pt>
                      <c:pt idx="56">
                        <c:v>5</c:v>
                      </c:pt>
                      <c:pt idx="57">
                        <c:v>6</c:v>
                      </c:pt>
                      <c:pt idx="58">
                        <c:v>7</c:v>
                      </c:pt>
                      <c:pt idx="59">
                        <c:v>8</c:v>
                      </c:pt>
                      <c:pt idx="60">
                        <c:v>9</c:v>
                      </c:pt>
                      <c:pt idx="61">
                        <c:v>10</c:v>
                      </c:pt>
                      <c:pt idx="62">
                        <c:v>11</c:v>
                      </c:pt>
                      <c:pt idx="63">
                        <c:v>12</c:v>
                      </c:pt>
                      <c:pt idx="64">
                        <c:v>13</c:v>
                      </c:pt>
                      <c:pt idx="65">
                        <c:v>14</c:v>
                      </c:pt>
                      <c:pt idx="66">
                        <c:v>15</c:v>
                      </c:pt>
                      <c:pt idx="67">
                        <c:v>16</c:v>
                      </c:pt>
                      <c:pt idx="68">
                        <c:v>17</c:v>
                      </c:pt>
                      <c:pt idx="69">
                        <c:v>18</c:v>
                      </c:pt>
                      <c:pt idx="70">
                        <c:v>19</c:v>
                      </c:pt>
                      <c:pt idx="71">
                        <c:v>20</c:v>
                      </c:pt>
                      <c:pt idx="72">
                        <c:v>21</c:v>
                      </c:pt>
                      <c:pt idx="73">
                        <c:v>22</c:v>
                      </c:pt>
                      <c:pt idx="74">
                        <c:v>23</c:v>
                      </c:pt>
                      <c:pt idx="75">
                        <c:v>24</c:v>
                      </c:pt>
                      <c:pt idx="76">
                        <c:v>25</c:v>
                      </c:pt>
                      <c:pt idx="77">
                        <c:v>26</c:v>
                      </c:pt>
                      <c:pt idx="78">
                        <c:v>27</c:v>
                      </c:pt>
                      <c:pt idx="79">
                        <c:v>28</c:v>
                      </c:pt>
                      <c:pt idx="80">
                        <c:v>29</c:v>
                      </c:pt>
                      <c:pt idx="81">
                        <c:v>30</c:v>
                      </c:pt>
                      <c:pt idx="82">
                        <c:v>31</c:v>
                      </c:pt>
                      <c:pt idx="83">
                        <c:v>32</c:v>
                      </c:pt>
                      <c:pt idx="84">
                        <c:v>33</c:v>
                      </c:pt>
                      <c:pt idx="85">
                        <c:v>34</c:v>
                      </c:pt>
                      <c:pt idx="86">
                        <c:v>35</c:v>
                      </c:pt>
                      <c:pt idx="87">
                        <c:v>36</c:v>
                      </c:pt>
                      <c:pt idx="88">
                        <c:v>37</c:v>
                      </c:pt>
                      <c:pt idx="89">
                        <c:v>38</c:v>
                      </c:pt>
                      <c:pt idx="90">
                        <c:v>39</c:v>
                      </c:pt>
                      <c:pt idx="91">
                        <c:v>40</c:v>
                      </c:pt>
                      <c:pt idx="92">
                        <c:v>41</c:v>
                      </c:pt>
                      <c:pt idx="93">
                        <c:v>42</c:v>
                      </c:pt>
                      <c:pt idx="94">
                        <c:v>43</c:v>
                      </c:pt>
                      <c:pt idx="95">
                        <c:v>44</c:v>
                      </c:pt>
                      <c:pt idx="96">
                        <c:v>45</c:v>
                      </c:pt>
                      <c:pt idx="97">
                        <c:v>46</c:v>
                      </c:pt>
                      <c:pt idx="98">
                        <c:v>47</c:v>
                      </c:pt>
                      <c:pt idx="99">
                        <c:v>48</c:v>
                      </c:pt>
                      <c:pt idx="100">
                        <c:v>49</c:v>
                      </c:pt>
                      <c:pt idx="101">
                        <c:v>50</c:v>
                      </c:pt>
                      <c:pt idx="102">
                        <c:v>51</c:v>
                      </c:pt>
                      <c:pt idx="103">
                        <c:v>52</c:v>
                      </c:pt>
                      <c:pt idx="104">
                        <c:v>1</c:v>
                      </c:pt>
                      <c:pt idx="105">
                        <c:v>2</c:v>
                      </c:pt>
                      <c:pt idx="106">
                        <c:v>3</c:v>
                      </c:pt>
                      <c:pt idx="107">
                        <c:v>4</c:v>
                      </c:pt>
                      <c:pt idx="108">
                        <c:v>5</c:v>
                      </c:pt>
                      <c:pt idx="109">
                        <c:v>6</c:v>
                      </c:pt>
                      <c:pt idx="110">
                        <c:v>7</c:v>
                      </c:pt>
                      <c:pt idx="111">
                        <c:v>8</c:v>
                      </c:pt>
                      <c:pt idx="112">
                        <c:v>9</c:v>
                      </c:pt>
                      <c:pt idx="113">
                        <c:v>10</c:v>
                      </c:pt>
                      <c:pt idx="114">
                        <c:v>11</c:v>
                      </c:pt>
                      <c:pt idx="115">
                        <c:v>12</c:v>
                      </c:pt>
                      <c:pt idx="116">
                        <c:v>13</c:v>
                      </c:pt>
                      <c:pt idx="117">
                        <c:v>14</c:v>
                      </c:pt>
                      <c:pt idx="118">
                        <c:v>15</c:v>
                      </c:pt>
                      <c:pt idx="119">
                        <c:v>16</c:v>
                      </c:pt>
                      <c:pt idx="120">
                        <c:v>17</c:v>
                      </c:pt>
                      <c:pt idx="121">
                        <c:v>18</c:v>
                      </c:pt>
                      <c:pt idx="122">
                        <c:v>19</c:v>
                      </c:pt>
                      <c:pt idx="123">
                        <c:v>20</c:v>
                      </c:pt>
                      <c:pt idx="124">
                        <c:v>21</c:v>
                      </c:pt>
                      <c:pt idx="125">
                        <c:v>22</c:v>
                      </c:pt>
                      <c:pt idx="126">
                        <c:v>23</c:v>
                      </c:pt>
                      <c:pt idx="127">
                        <c:v>24</c:v>
                      </c:pt>
                      <c:pt idx="128">
                        <c:v>25</c:v>
                      </c:pt>
                      <c:pt idx="129">
                        <c:v>26</c:v>
                      </c:pt>
                      <c:pt idx="130">
                        <c:v>27</c:v>
                      </c:pt>
                      <c:pt idx="131">
                        <c:v>28</c:v>
                      </c:pt>
                      <c:pt idx="132">
                        <c:v>29</c:v>
                      </c:pt>
                      <c:pt idx="133">
                        <c:v>30</c:v>
                      </c:pt>
                      <c:pt idx="134">
                        <c:v>31</c:v>
                      </c:pt>
                      <c:pt idx="135">
                        <c:v>32</c:v>
                      </c:pt>
                      <c:pt idx="136">
                        <c:v>33</c:v>
                      </c:pt>
                      <c:pt idx="137">
                        <c:v>34</c:v>
                      </c:pt>
                      <c:pt idx="138">
                        <c:v>35</c:v>
                      </c:pt>
                      <c:pt idx="139">
                        <c:v>36</c:v>
                      </c:pt>
                      <c:pt idx="140">
                        <c:v>37</c:v>
                      </c:pt>
                      <c:pt idx="141">
                        <c:v>38</c:v>
                      </c:pt>
                      <c:pt idx="142">
                        <c:v>39</c:v>
                      </c:pt>
                      <c:pt idx="143">
                        <c:v>40</c:v>
                      </c:pt>
                      <c:pt idx="144">
                        <c:v>41</c:v>
                      </c:pt>
                      <c:pt idx="145">
                        <c:v>42</c:v>
                      </c:pt>
                      <c:pt idx="146">
                        <c:v>43</c:v>
                      </c:pt>
                      <c:pt idx="147">
                        <c:v>44</c:v>
                      </c:pt>
                      <c:pt idx="148">
                        <c:v>45</c:v>
                      </c:pt>
                      <c:pt idx="149">
                        <c:v>46</c:v>
                      </c:pt>
                      <c:pt idx="150">
                        <c:v>47</c:v>
                      </c:pt>
                      <c:pt idx="151">
                        <c:v>48</c:v>
                      </c:pt>
                      <c:pt idx="152">
                        <c:v>49</c:v>
                      </c:pt>
                      <c:pt idx="153">
                        <c:v>50</c:v>
                      </c:pt>
                      <c:pt idx="154">
                        <c:v>51</c:v>
                      </c:pt>
                      <c:pt idx="155">
                        <c:v>52</c:v>
                      </c:pt>
                      <c:pt idx="156">
                        <c:v>1</c:v>
                      </c:pt>
                      <c:pt idx="157">
                        <c:v>2</c:v>
                      </c:pt>
                      <c:pt idx="158">
                        <c:v>3</c:v>
                      </c:pt>
                      <c:pt idx="159">
                        <c:v>4</c:v>
                      </c:pt>
                      <c:pt idx="160">
                        <c:v>5</c:v>
                      </c:pt>
                      <c:pt idx="161">
                        <c:v>6</c:v>
                      </c:pt>
                      <c:pt idx="162">
                        <c:v>7</c:v>
                      </c:pt>
                      <c:pt idx="163">
                        <c:v>8</c:v>
                      </c:pt>
                      <c:pt idx="164">
                        <c:v>9</c:v>
                      </c:pt>
                      <c:pt idx="165">
                        <c:v>10</c:v>
                      </c:pt>
                      <c:pt idx="166">
                        <c:v>11</c:v>
                      </c:pt>
                      <c:pt idx="167">
                        <c:v>12</c:v>
                      </c:pt>
                      <c:pt idx="168">
                        <c:v>13</c:v>
                      </c:pt>
                      <c:pt idx="169">
                        <c:v>14</c:v>
                      </c:pt>
                      <c:pt idx="170">
                        <c:v>15</c:v>
                      </c:pt>
                      <c:pt idx="171">
                        <c:v>16</c:v>
                      </c:pt>
                      <c:pt idx="172">
                        <c:v>17</c:v>
                      </c:pt>
                      <c:pt idx="173">
                        <c:v>18</c:v>
                      </c:pt>
                      <c:pt idx="174">
                        <c:v>19</c:v>
                      </c:pt>
                      <c:pt idx="175">
                        <c:v>20</c:v>
                      </c:pt>
                      <c:pt idx="176">
                        <c:v>21</c:v>
                      </c:pt>
                      <c:pt idx="177">
                        <c:v>22</c:v>
                      </c:pt>
                      <c:pt idx="178">
                        <c:v>23</c:v>
                      </c:pt>
                      <c:pt idx="179">
                        <c:v>24</c:v>
                      </c:pt>
                      <c:pt idx="180">
                        <c:v>25</c:v>
                      </c:pt>
                      <c:pt idx="181">
                        <c:v>26</c:v>
                      </c:pt>
                      <c:pt idx="182">
                        <c:v>27</c:v>
                      </c:pt>
                      <c:pt idx="183">
                        <c:v>28</c:v>
                      </c:pt>
                      <c:pt idx="184">
                        <c:v>29</c:v>
                      </c:pt>
                      <c:pt idx="185">
                        <c:v>30</c:v>
                      </c:pt>
                      <c:pt idx="186">
                        <c:v>31</c:v>
                      </c:pt>
                      <c:pt idx="187">
                        <c:v>32</c:v>
                      </c:pt>
                      <c:pt idx="188">
                        <c:v>33</c:v>
                      </c:pt>
                      <c:pt idx="189">
                        <c:v>34</c:v>
                      </c:pt>
                      <c:pt idx="190">
                        <c:v>35</c:v>
                      </c:pt>
                      <c:pt idx="191">
                        <c:v>36</c:v>
                      </c:pt>
                      <c:pt idx="192">
                        <c:v>37</c:v>
                      </c:pt>
                      <c:pt idx="193">
                        <c:v>38</c:v>
                      </c:pt>
                      <c:pt idx="194">
                        <c:v>39</c:v>
                      </c:pt>
                      <c:pt idx="195">
                        <c:v>40</c:v>
                      </c:pt>
                      <c:pt idx="196">
                        <c:v>41</c:v>
                      </c:pt>
                      <c:pt idx="197">
                        <c:v>42</c:v>
                      </c:pt>
                      <c:pt idx="198">
                        <c:v>43</c:v>
                      </c:pt>
                      <c:pt idx="199">
                        <c:v>44</c:v>
                      </c:pt>
                      <c:pt idx="200">
                        <c:v>45</c:v>
                      </c:pt>
                      <c:pt idx="201">
                        <c:v>46</c:v>
                      </c:pt>
                      <c:pt idx="202">
                        <c:v>47</c:v>
                      </c:pt>
                      <c:pt idx="203">
                        <c:v>48</c:v>
                      </c:pt>
                      <c:pt idx="204">
                        <c:v>49</c:v>
                      </c:pt>
                      <c:pt idx="205">
                        <c:v>50</c:v>
                      </c:pt>
                      <c:pt idx="206">
                        <c:v>51</c:v>
                      </c:pt>
                      <c:pt idx="207">
                        <c:v>52</c:v>
                      </c:pt>
                      <c:pt idx="208">
                        <c:v>53</c:v>
                      </c:pt>
                      <c:pt idx="209">
                        <c:v>1</c:v>
                      </c:pt>
                      <c:pt idx="210">
                        <c:v>2</c:v>
                      </c:pt>
                      <c:pt idx="211">
                        <c:v>3</c:v>
                      </c:pt>
                      <c:pt idx="212">
                        <c:v>4</c:v>
                      </c:pt>
                      <c:pt idx="213">
                        <c:v>5</c:v>
                      </c:pt>
                      <c:pt idx="214">
                        <c:v>6</c:v>
                      </c:pt>
                      <c:pt idx="215">
                        <c:v>7</c:v>
                      </c:pt>
                      <c:pt idx="216">
                        <c:v>8</c:v>
                      </c:pt>
                      <c:pt idx="217">
                        <c:v>9</c:v>
                      </c:pt>
                      <c:pt idx="218">
                        <c:v>10</c:v>
                      </c:pt>
                      <c:pt idx="219">
                        <c:v>11</c:v>
                      </c:pt>
                      <c:pt idx="220">
                        <c:v>12</c:v>
                      </c:pt>
                      <c:pt idx="221">
                        <c:v>13</c:v>
                      </c:pt>
                      <c:pt idx="222">
                        <c:v>14</c:v>
                      </c:pt>
                      <c:pt idx="223">
                        <c:v>15</c:v>
                      </c:pt>
                      <c:pt idx="224">
                        <c:v>16</c:v>
                      </c:pt>
                      <c:pt idx="225">
                        <c:v>17</c:v>
                      </c:pt>
                      <c:pt idx="226">
                        <c:v>18</c:v>
                      </c:pt>
                      <c:pt idx="227">
                        <c:v>19</c:v>
                      </c:pt>
                      <c:pt idx="228">
                        <c:v>20</c:v>
                      </c:pt>
                      <c:pt idx="229">
                        <c:v>21</c:v>
                      </c:pt>
                      <c:pt idx="230">
                        <c:v>22</c:v>
                      </c:pt>
                      <c:pt idx="231">
                        <c:v>23</c:v>
                      </c:pt>
                      <c:pt idx="232">
                        <c:v>24</c:v>
                      </c:pt>
                      <c:pt idx="233">
                        <c:v>25</c:v>
                      </c:pt>
                      <c:pt idx="234">
                        <c:v>26</c:v>
                      </c:pt>
                      <c:pt idx="235">
                        <c:v>27</c:v>
                      </c:pt>
                      <c:pt idx="236">
                        <c:v>28</c:v>
                      </c:pt>
                      <c:pt idx="237">
                        <c:v>29</c:v>
                      </c:pt>
                      <c:pt idx="238">
                        <c:v>30</c:v>
                      </c:pt>
                      <c:pt idx="239">
                        <c:v>31</c:v>
                      </c:pt>
                      <c:pt idx="240">
                        <c:v>32</c:v>
                      </c:pt>
                      <c:pt idx="241">
                        <c:v>33</c:v>
                      </c:pt>
                      <c:pt idx="242">
                        <c:v>34</c:v>
                      </c:pt>
                      <c:pt idx="243">
                        <c:v>35</c:v>
                      </c:pt>
                      <c:pt idx="244">
                        <c:v>36</c:v>
                      </c:pt>
                      <c:pt idx="245">
                        <c:v>37</c:v>
                      </c:pt>
                      <c:pt idx="246">
                        <c:v>38</c:v>
                      </c:pt>
                      <c:pt idx="247">
                        <c:v>39</c:v>
                      </c:pt>
                      <c:pt idx="248">
                        <c:v>40</c:v>
                      </c:pt>
                      <c:pt idx="249">
                        <c:v>41</c:v>
                      </c:pt>
                      <c:pt idx="250">
                        <c:v>42</c:v>
                      </c:pt>
                      <c:pt idx="251">
                        <c:v>43</c:v>
                      </c:pt>
                      <c:pt idx="252">
                        <c:v>44</c:v>
                      </c:pt>
                      <c:pt idx="253">
                        <c:v>45</c:v>
                      </c:pt>
                      <c:pt idx="254">
                        <c:v>46</c:v>
                      </c:pt>
                      <c:pt idx="255">
                        <c:v>47</c:v>
                      </c:pt>
                      <c:pt idx="256">
                        <c:v>48</c:v>
                      </c:pt>
                      <c:pt idx="257">
                        <c:v>49</c:v>
                      </c:pt>
                      <c:pt idx="258">
                        <c:v>50</c:v>
                      </c:pt>
                      <c:pt idx="259">
                        <c:v>51</c:v>
                      </c:pt>
                      <c:pt idx="260">
                        <c:v>52</c:v>
                      </c:pt>
                      <c:pt idx="261">
                        <c:v>1</c:v>
                      </c:pt>
                      <c:pt idx="262">
                        <c:v>2</c:v>
                      </c:pt>
                      <c:pt idx="263">
                        <c:v>3</c:v>
                      </c:pt>
                      <c:pt idx="264">
                        <c:v>4</c:v>
                      </c:pt>
                      <c:pt idx="265">
                        <c:v>5</c:v>
                      </c:pt>
                      <c:pt idx="266">
                        <c:v>6</c:v>
                      </c:pt>
                      <c:pt idx="267">
                        <c:v>7</c:v>
                      </c:pt>
                      <c:pt idx="268">
                        <c:v>8</c:v>
                      </c:pt>
                      <c:pt idx="269">
                        <c:v>9</c:v>
                      </c:pt>
                      <c:pt idx="270">
                        <c:v>10</c:v>
                      </c:pt>
                      <c:pt idx="271">
                        <c:v>11</c:v>
                      </c:pt>
                      <c:pt idx="272">
                        <c:v>12</c:v>
                      </c:pt>
                      <c:pt idx="273">
                        <c:v>13</c:v>
                      </c:pt>
                      <c:pt idx="274">
                        <c:v>14</c:v>
                      </c:pt>
                      <c:pt idx="275">
                        <c:v>15</c:v>
                      </c:pt>
                      <c:pt idx="276">
                        <c:v>16</c:v>
                      </c:pt>
                      <c:pt idx="277">
                        <c:v>17</c:v>
                      </c:pt>
                      <c:pt idx="278">
                        <c:v>18</c:v>
                      </c:pt>
                      <c:pt idx="279">
                        <c:v>19</c:v>
                      </c:pt>
                      <c:pt idx="280">
                        <c:v>20</c:v>
                      </c:pt>
                      <c:pt idx="281">
                        <c:v>21</c:v>
                      </c:pt>
                      <c:pt idx="282">
                        <c:v>22</c:v>
                      </c:pt>
                      <c:pt idx="283">
                        <c:v>23</c:v>
                      </c:pt>
                      <c:pt idx="284">
                        <c:v>24</c:v>
                      </c:pt>
                      <c:pt idx="285">
                        <c:v>25</c:v>
                      </c:pt>
                      <c:pt idx="286">
                        <c:v>26</c:v>
                      </c:pt>
                      <c:pt idx="287">
                        <c:v>27</c:v>
                      </c:pt>
                      <c:pt idx="288">
                        <c:v>28</c:v>
                      </c:pt>
                      <c:pt idx="289">
                        <c:v>29</c:v>
                      </c:pt>
                      <c:pt idx="290">
                        <c:v>30</c:v>
                      </c:pt>
                      <c:pt idx="291">
                        <c:v>31</c:v>
                      </c:pt>
                      <c:pt idx="292">
                        <c:v>32</c:v>
                      </c:pt>
                      <c:pt idx="293">
                        <c:v>33</c:v>
                      </c:pt>
                      <c:pt idx="294">
                        <c:v>34</c:v>
                      </c:pt>
                      <c:pt idx="295">
                        <c:v>35</c:v>
                      </c:pt>
                      <c:pt idx="296">
                        <c:v>36</c:v>
                      </c:pt>
                      <c:pt idx="297">
                        <c:v>37</c:v>
                      </c:pt>
                      <c:pt idx="298">
                        <c:v>38</c:v>
                      </c:pt>
                      <c:pt idx="299">
                        <c:v>39</c:v>
                      </c:pt>
                      <c:pt idx="300">
                        <c:v>40</c:v>
                      </c:pt>
                      <c:pt idx="301">
                        <c:v>41</c:v>
                      </c:pt>
                      <c:pt idx="302">
                        <c:v>42</c:v>
                      </c:pt>
                      <c:pt idx="303">
                        <c:v>43</c:v>
                      </c:pt>
                      <c:pt idx="304">
                        <c:v>44</c:v>
                      </c:pt>
                      <c:pt idx="305">
                        <c:v>45</c:v>
                      </c:pt>
                      <c:pt idx="306">
                        <c:v>46</c:v>
                      </c:pt>
                      <c:pt idx="307">
                        <c:v>47</c:v>
                      </c:pt>
                      <c:pt idx="308">
                        <c:v>48</c:v>
                      </c:pt>
                      <c:pt idx="309">
                        <c:v>49</c:v>
                      </c:pt>
                      <c:pt idx="310">
                        <c:v>50</c:v>
                      </c:pt>
                      <c:pt idx="311">
                        <c:v>51</c:v>
                      </c:pt>
                      <c:pt idx="312">
                        <c:v>52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Sheet1!$B$2:$B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279</c:v>
                      </c:pt>
                      <c:pt idx="1">
                        <c:v>268</c:v>
                      </c:pt>
                      <c:pt idx="2">
                        <c:v>308</c:v>
                      </c:pt>
                      <c:pt idx="3">
                        <c:v>361</c:v>
                      </c:pt>
                      <c:pt idx="4">
                        <c:v>318</c:v>
                      </c:pt>
                      <c:pt idx="5">
                        <c:v>357</c:v>
                      </c:pt>
                      <c:pt idx="6">
                        <c:v>291</c:v>
                      </c:pt>
                      <c:pt idx="7">
                        <c:v>294</c:v>
                      </c:pt>
                      <c:pt idx="8">
                        <c:v>293</c:v>
                      </c:pt>
                      <c:pt idx="9">
                        <c:v>319</c:v>
                      </c:pt>
                      <c:pt idx="10">
                        <c:v>291</c:v>
                      </c:pt>
                      <c:pt idx="11">
                        <c:v>297</c:v>
                      </c:pt>
                      <c:pt idx="12">
                        <c:v>241</c:v>
                      </c:pt>
                      <c:pt idx="13">
                        <c:v>259</c:v>
                      </c:pt>
                      <c:pt idx="14">
                        <c:v>350</c:v>
                      </c:pt>
                      <c:pt idx="15">
                        <c:v>337</c:v>
                      </c:pt>
                      <c:pt idx="16">
                        <c:v>357</c:v>
                      </c:pt>
                      <c:pt idx="17">
                        <c:v>401</c:v>
                      </c:pt>
                      <c:pt idx="18">
                        <c:v>265</c:v>
                      </c:pt>
                      <c:pt idx="19">
                        <c:v>285</c:v>
                      </c:pt>
                      <c:pt idx="20">
                        <c:v>271</c:v>
                      </c:pt>
                      <c:pt idx="21">
                        <c:v>252</c:v>
                      </c:pt>
                      <c:pt idx="22">
                        <c:v>272</c:v>
                      </c:pt>
                      <c:pt idx="23">
                        <c:v>254</c:v>
                      </c:pt>
                      <c:pt idx="24">
                        <c:v>280</c:v>
                      </c:pt>
                      <c:pt idx="25">
                        <c:v>315</c:v>
                      </c:pt>
                      <c:pt idx="26">
                        <c:v>333</c:v>
                      </c:pt>
                      <c:pt idx="27">
                        <c:v>330</c:v>
                      </c:pt>
                      <c:pt idx="28">
                        <c:v>388</c:v>
                      </c:pt>
                      <c:pt idx="29">
                        <c:v>256</c:v>
                      </c:pt>
                      <c:pt idx="30">
                        <c:v>211</c:v>
                      </c:pt>
                      <c:pt idx="31">
                        <c:v>163</c:v>
                      </c:pt>
                      <c:pt idx="32">
                        <c:v>201</c:v>
                      </c:pt>
                      <c:pt idx="33">
                        <c:v>155</c:v>
                      </c:pt>
                      <c:pt idx="34">
                        <c:v>154</c:v>
                      </c:pt>
                      <c:pt idx="35">
                        <c:v>163</c:v>
                      </c:pt>
                      <c:pt idx="36">
                        <c:v>169</c:v>
                      </c:pt>
                      <c:pt idx="37">
                        <c:v>238</c:v>
                      </c:pt>
                      <c:pt idx="38">
                        <c:v>176</c:v>
                      </c:pt>
                      <c:pt idx="39">
                        <c:v>140</c:v>
                      </c:pt>
                      <c:pt idx="40">
                        <c:v>187</c:v>
                      </c:pt>
                      <c:pt idx="41">
                        <c:v>155</c:v>
                      </c:pt>
                      <c:pt idx="42">
                        <c:v>154</c:v>
                      </c:pt>
                      <c:pt idx="43">
                        <c:v>142</c:v>
                      </c:pt>
                      <c:pt idx="44">
                        <c:v>173</c:v>
                      </c:pt>
                      <c:pt idx="45">
                        <c:v>142</c:v>
                      </c:pt>
                      <c:pt idx="46">
                        <c:v>191</c:v>
                      </c:pt>
                      <c:pt idx="47">
                        <c:v>172</c:v>
                      </c:pt>
                      <c:pt idx="48">
                        <c:v>171</c:v>
                      </c:pt>
                      <c:pt idx="49">
                        <c:v>196</c:v>
                      </c:pt>
                      <c:pt idx="50">
                        <c:v>220</c:v>
                      </c:pt>
                      <c:pt idx="51">
                        <c:v>234</c:v>
                      </c:pt>
                      <c:pt idx="52">
                        <c:v>299</c:v>
                      </c:pt>
                      <c:pt idx="53">
                        <c:v>232</c:v>
                      </c:pt>
                      <c:pt idx="54">
                        <c:v>243</c:v>
                      </c:pt>
                      <c:pt idx="55">
                        <c:v>247</c:v>
                      </c:pt>
                      <c:pt idx="56">
                        <c:v>268</c:v>
                      </c:pt>
                      <c:pt idx="57">
                        <c:v>253</c:v>
                      </c:pt>
                      <c:pt idx="58">
                        <c:v>235</c:v>
                      </c:pt>
                      <c:pt idx="59">
                        <c:v>209</c:v>
                      </c:pt>
                      <c:pt idx="60">
                        <c:v>212</c:v>
                      </c:pt>
                      <c:pt idx="61">
                        <c:v>209</c:v>
                      </c:pt>
                      <c:pt idx="62">
                        <c:v>223</c:v>
                      </c:pt>
                      <c:pt idx="63">
                        <c:v>224</c:v>
                      </c:pt>
                      <c:pt idx="64">
                        <c:v>202</c:v>
                      </c:pt>
                      <c:pt idx="65">
                        <c:v>201</c:v>
                      </c:pt>
                      <c:pt idx="66">
                        <c:v>227</c:v>
                      </c:pt>
                      <c:pt idx="67">
                        <c:v>240</c:v>
                      </c:pt>
                      <c:pt idx="68">
                        <c:v>262</c:v>
                      </c:pt>
                      <c:pt idx="69">
                        <c:v>416</c:v>
                      </c:pt>
                      <c:pt idx="70">
                        <c:v>331</c:v>
                      </c:pt>
                      <c:pt idx="71">
                        <c:v>251</c:v>
                      </c:pt>
                      <c:pt idx="72">
                        <c:v>295</c:v>
                      </c:pt>
                      <c:pt idx="73">
                        <c:v>246</c:v>
                      </c:pt>
                      <c:pt idx="74">
                        <c:v>233</c:v>
                      </c:pt>
                      <c:pt idx="75">
                        <c:v>262</c:v>
                      </c:pt>
                      <c:pt idx="76">
                        <c:v>240</c:v>
                      </c:pt>
                      <c:pt idx="77">
                        <c:v>309</c:v>
                      </c:pt>
                      <c:pt idx="78">
                        <c:v>285</c:v>
                      </c:pt>
                      <c:pt idx="79">
                        <c:v>346</c:v>
                      </c:pt>
                      <c:pt idx="80">
                        <c:v>335</c:v>
                      </c:pt>
                      <c:pt idx="81">
                        <c:v>266</c:v>
                      </c:pt>
                      <c:pt idx="82">
                        <c:v>225</c:v>
                      </c:pt>
                      <c:pt idx="83">
                        <c:v>202</c:v>
                      </c:pt>
                      <c:pt idx="84">
                        <c:v>313</c:v>
                      </c:pt>
                      <c:pt idx="85">
                        <c:v>161</c:v>
                      </c:pt>
                      <c:pt idx="86">
                        <c:v>164</c:v>
                      </c:pt>
                      <c:pt idx="87">
                        <c:v>154</c:v>
                      </c:pt>
                      <c:pt idx="88">
                        <c:v>161</c:v>
                      </c:pt>
                      <c:pt idx="89">
                        <c:v>203</c:v>
                      </c:pt>
                      <c:pt idx="90">
                        <c:v>175</c:v>
                      </c:pt>
                      <c:pt idx="91">
                        <c:v>138</c:v>
                      </c:pt>
                      <c:pt idx="92">
                        <c:v>153</c:v>
                      </c:pt>
                      <c:pt idx="93">
                        <c:v>134</c:v>
                      </c:pt>
                      <c:pt idx="94">
                        <c:v>132</c:v>
                      </c:pt>
                      <c:pt idx="95">
                        <c:v>107</c:v>
                      </c:pt>
                      <c:pt idx="96">
                        <c:v>159</c:v>
                      </c:pt>
                      <c:pt idx="97">
                        <c:v>137</c:v>
                      </c:pt>
                      <c:pt idx="98">
                        <c:v>147</c:v>
                      </c:pt>
                      <c:pt idx="99">
                        <c:v>123</c:v>
                      </c:pt>
                      <c:pt idx="100">
                        <c:v>142</c:v>
                      </c:pt>
                      <c:pt idx="101">
                        <c:v>156</c:v>
                      </c:pt>
                      <c:pt idx="102">
                        <c:v>161</c:v>
                      </c:pt>
                      <c:pt idx="103">
                        <c:v>179</c:v>
                      </c:pt>
                      <c:pt idx="104">
                        <c:v>302</c:v>
                      </c:pt>
                      <c:pt idx="105">
                        <c:v>175</c:v>
                      </c:pt>
                      <c:pt idx="106">
                        <c:v>193</c:v>
                      </c:pt>
                      <c:pt idx="107">
                        <c:v>235</c:v>
                      </c:pt>
                      <c:pt idx="108">
                        <c:v>254</c:v>
                      </c:pt>
                      <c:pt idx="109">
                        <c:v>211</c:v>
                      </c:pt>
                      <c:pt idx="110">
                        <c:v>213</c:v>
                      </c:pt>
                      <c:pt idx="111">
                        <c:v>184</c:v>
                      </c:pt>
                      <c:pt idx="112">
                        <c:v>166</c:v>
                      </c:pt>
                      <c:pt idx="113">
                        <c:v>166</c:v>
                      </c:pt>
                      <c:pt idx="114">
                        <c:v>208</c:v>
                      </c:pt>
                      <c:pt idx="115">
                        <c:v>223</c:v>
                      </c:pt>
                      <c:pt idx="116">
                        <c:v>217</c:v>
                      </c:pt>
                      <c:pt idx="117">
                        <c:v>196</c:v>
                      </c:pt>
                      <c:pt idx="118">
                        <c:v>220</c:v>
                      </c:pt>
                      <c:pt idx="119">
                        <c:v>272</c:v>
                      </c:pt>
                      <c:pt idx="120">
                        <c:v>278</c:v>
                      </c:pt>
                      <c:pt idx="121">
                        <c:v>312</c:v>
                      </c:pt>
                      <c:pt idx="122">
                        <c:v>298</c:v>
                      </c:pt>
                      <c:pt idx="123">
                        <c:v>223</c:v>
                      </c:pt>
                      <c:pt idx="124">
                        <c:v>243</c:v>
                      </c:pt>
                      <c:pt idx="125">
                        <c:v>313</c:v>
                      </c:pt>
                      <c:pt idx="126">
                        <c:v>241</c:v>
                      </c:pt>
                      <c:pt idx="127">
                        <c:v>244</c:v>
                      </c:pt>
                      <c:pt idx="128">
                        <c:v>245</c:v>
                      </c:pt>
                      <c:pt idx="129">
                        <c:v>226</c:v>
                      </c:pt>
                      <c:pt idx="130">
                        <c:v>223</c:v>
                      </c:pt>
                      <c:pt idx="131">
                        <c:v>253</c:v>
                      </c:pt>
                      <c:pt idx="132">
                        <c:v>231</c:v>
                      </c:pt>
                      <c:pt idx="133">
                        <c:v>266</c:v>
                      </c:pt>
                      <c:pt idx="134">
                        <c:v>184</c:v>
                      </c:pt>
                      <c:pt idx="135">
                        <c:v>180</c:v>
                      </c:pt>
                      <c:pt idx="136">
                        <c:v>225</c:v>
                      </c:pt>
                      <c:pt idx="137">
                        <c:v>142</c:v>
                      </c:pt>
                      <c:pt idx="138">
                        <c:v>151</c:v>
                      </c:pt>
                      <c:pt idx="139">
                        <c:v>176</c:v>
                      </c:pt>
                      <c:pt idx="140">
                        <c:v>177</c:v>
                      </c:pt>
                      <c:pt idx="141">
                        <c:v>198</c:v>
                      </c:pt>
                      <c:pt idx="142">
                        <c:v>180</c:v>
                      </c:pt>
                      <c:pt idx="143">
                        <c:v>161</c:v>
                      </c:pt>
                      <c:pt idx="144">
                        <c:v>131</c:v>
                      </c:pt>
                      <c:pt idx="145">
                        <c:v>141</c:v>
                      </c:pt>
                      <c:pt idx="146">
                        <c:v>141</c:v>
                      </c:pt>
                      <c:pt idx="147">
                        <c:v>145</c:v>
                      </c:pt>
                      <c:pt idx="148">
                        <c:v>140</c:v>
                      </c:pt>
                      <c:pt idx="149">
                        <c:v>149</c:v>
                      </c:pt>
                      <c:pt idx="150">
                        <c:v>164</c:v>
                      </c:pt>
                      <c:pt idx="151">
                        <c:v>177</c:v>
                      </c:pt>
                      <c:pt idx="152">
                        <c:v>148</c:v>
                      </c:pt>
                      <c:pt idx="153">
                        <c:v>183</c:v>
                      </c:pt>
                      <c:pt idx="154">
                        <c:v>204</c:v>
                      </c:pt>
                      <c:pt idx="155">
                        <c:v>266</c:v>
                      </c:pt>
                      <c:pt idx="156">
                        <c:v>478</c:v>
                      </c:pt>
                      <c:pt idx="157">
                        <c:v>243</c:v>
                      </c:pt>
                      <c:pt idx="158">
                        <c:v>305</c:v>
                      </c:pt>
                      <c:pt idx="159">
                        <c:v>217</c:v>
                      </c:pt>
                      <c:pt idx="160">
                        <c:v>190</c:v>
                      </c:pt>
                      <c:pt idx="161">
                        <c:v>153</c:v>
                      </c:pt>
                      <c:pt idx="162">
                        <c:v>182</c:v>
                      </c:pt>
                      <c:pt idx="163">
                        <c:v>138</c:v>
                      </c:pt>
                      <c:pt idx="164">
                        <c:v>154</c:v>
                      </c:pt>
                      <c:pt idx="165">
                        <c:v>146</c:v>
                      </c:pt>
                      <c:pt idx="166">
                        <c:v>146</c:v>
                      </c:pt>
                      <c:pt idx="167">
                        <c:v>195</c:v>
                      </c:pt>
                      <c:pt idx="168">
                        <c:v>155</c:v>
                      </c:pt>
                      <c:pt idx="169">
                        <c:v>170</c:v>
                      </c:pt>
                      <c:pt idx="170">
                        <c:v>179</c:v>
                      </c:pt>
                      <c:pt idx="171">
                        <c:v>214</c:v>
                      </c:pt>
                      <c:pt idx="172">
                        <c:v>226</c:v>
                      </c:pt>
                      <c:pt idx="173">
                        <c:v>285</c:v>
                      </c:pt>
                      <c:pt idx="174">
                        <c:v>299</c:v>
                      </c:pt>
                      <c:pt idx="175">
                        <c:v>203</c:v>
                      </c:pt>
                      <c:pt idx="176">
                        <c:v>205</c:v>
                      </c:pt>
                      <c:pt idx="177">
                        <c:v>215</c:v>
                      </c:pt>
                      <c:pt idx="178">
                        <c:v>192</c:v>
                      </c:pt>
                      <c:pt idx="179">
                        <c:v>208</c:v>
                      </c:pt>
                      <c:pt idx="180">
                        <c:v>236</c:v>
                      </c:pt>
                      <c:pt idx="181">
                        <c:v>217</c:v>
                      </c:pt>
                      <c:pt idx="182">
                        <c:v>205</c:v>
                      </c:pt>
                      <c:pt idx="183">
                        <c:v>221</c:v>
                      </c:pt>
                      <c:pt idx="184">
                        <c:v>255</c:v>
                      </c:pt>
                      <c:pt idx="185">
                        <c:v>303</c:v>
                      </c:pt>
                      <c:pt idx="186">
                        <c:v>225</c:v>
                      </c:pt>
                      <c:pt idx="187">
                        <c:v>216</c:v>
                      </c:pt>
                      <c:pt idx="188">
                        <c:v>229</c:v>
                      </c:pt>
                      <c:pt idx="189">
                        <c:v>157</c:v>
                      </c:pt>
                      <c:pt idx="190">
                        <c:v>169</c:v>
                      </c:pt>
                      <c:pt idx="191">
                        <c:v>183</c:v>
                      </c:pt>
                      <c:pt idx="192">
                        <c:v>195</c:v>
                      </c:pt>
                      <c:pt idx="193">
                        <c:v>190</c:v>
                      </c:pt>
                      <c:pt idx="194">
                        <c:v>259</c:v>
                      </c:pt>
                      <c:pt idx="195">
                        <c:v>125</c:v>
                      </c:pt>
                      <c:pt idx="196">
                        <c:v>161</c:v>
                      </c:pt>
                      <c:pt idx="197">
                        <c:v>166</c:v>
                      </c:pt>
                      <c:pt idx="198">
                        <c:v>138</c:v>
                      </c:pt>
                      <c:pt idx="199">
                        <c:v>126</c:v>
                      </c:pt>
                      <c:pt idx="200">
                        <c:v>154</c:v>
                      </c:pt>
                      <c:pt idx="201">
                        <c:v>149</c:v>
                      </c:pt>
                      <c:pt idx="202">
                        <c:v>168</c:v>
                      </c:pt>
                      <c:pt idx="203">
                        <c:v>213</c:v>
                      </c:pt>
                      <c:pt idx="204">
                        <c:v>147</c:v>
                      </c:pt>
                      <c:pt idx="205">
                        <c:v>153</c:v>
                      </c:pt>
                      <c:pt idx="206">
                        <c:v>165</c:v>
                      </c:pt>
                      <c:pt idx="207">
                        <c:v>154</c:v>
                      </c:pt>
                      <c:pt idx="208">
                        <c:v>277</c:v>
                      </c:pt>
                      <c:pt idx="209">
                        <c:v>142</c:v>
                      </c:pt>
                      <c:pt idx="210">
                        <c:v>164</c:v>
                      </c:pt>
                      <c:pt idx="211">
                        <c:v>172</c:v>
                      </c:pt>
                      <c:pt idx="212">
                        <c:v>196</c:v>
                      </c:pt>
                      <c:pt idx="213">
                        <c:v>240</c:v>
                      </c:pt>
                      <c:pt idx="214">
                        <c:v>319</c:v>
                      </c:pt>
                      <c:pt idx="215">
                        <c:v>253</c:v>
                      </c:pt>
                      <c:pt idx="216">
                        <c:v>230</c:v>
                      </c:pt>
                      <c:pt idx="217">
                        <c:v>227</c:v>
                      </c:pt>
                      <c:pt idx="218">
                        <c:v>201</c:v>
                      </c:pt>
                      <c:pt idx="219">
                        <c:v>160</c:v>
                      </c:pt>
                      <c:pt idx="220">
                        <c:v>241</c:v>
                      </c:pt>
                      <c:pt idx="221">
                        <c:v>177</c:v>
                      </c:pt>
                      <c:pt idx="222">
                        <c:v>182</c:v>
                      </c:pt>
                      <c:pt idx="223">
                        <c:v>202</c:v>
                      </c:pt>
                      <c:pt idx="224">
                        <c:v>228</c:v>
                      </c:pt>
                      <c:pt idx="225">
                        <c:v>263</c:v>
                      </c:pt>
                      <c:pt idx="226">
                        <c:v>313</c:v>
                      </c:pt>
                      <c:pt idx="227">
                        <c:v>210</c:v>
                      </c:pt>
                      <c:pt idx="228">
                        <c:v>218</c:v>
                      </c:pt>
                      <c:pt idx="229">
                        <c:v>226</c:v>
                      </c:pt>
                      <c:pt idx="230">
                        <c:v>217</c:v>
                      </c:pt>
                      <c:pt idx="231">
                        <c:v>224</c:v>
                      </c:pt>
                      <c:pt idx="232">
                        <c:v>223</c:v>
                      </c:pt>
                      <c:pt idx="233">
                        <c:v>271</c:v>
                      </c:pt>
                      <c:pt idx="234">
                        <c:v>304</c:v>
                      </c:pt>
                      <c:pt idx="235">
                        <c:v>283</c:v>
                      </c:pt>
                      <c:pt idx="236">
                        <c:v>225</c:v>
                      </c:pt>
                      <c:pt idx="237">
                        <c:v>274</c:v>
                      </c:pt>
                      <c:pt idx="238">
                        <c:v>171</c:v>
                      </c:pt>
                      <c:pt idx="239">
                        <c:v>154</c:v>
                      </c:pt>
                      <c:pt idx="240">
                        <c:v>201</c:v>
                      </c:pt>
                      <c:pt idx="241">
                        <c:v>183</c:v>
                      </c:pt>
                      <c:pt idx="242">
                        <c:v>126</c:v>
                      </c:pt>
                      <c:pt idx="243">
                        <c:v>136</c:v>
                      </c:pt>
                      <c:pt idx="244">
                        <c:v>157</c:v>
                      </c:pt>
                      <c:pt idx="245">
                        <c:v>183</c:v>
                      </c:pt>
                      <c:pt idx="246">
                        <c:v>205</c:v>
                      </c:pt>
                      <c:pt idx="247">
                        <c:v>140</c:v>
                      </c:pt>
                      <c:pt idx="248">
                        <c:v>163</c:v>
                      </c:pt>
                      <c:pt idx="249">
                        <c:v>181</c:v>
                      </c:pt>
                      <c:pt idx="250">
                        <c:v>132</c:v>
                      </c:pt>
                      <c:pt idx="251">
                        <c:v>119</c:v>
                      </c:pt>
                      <c:pt idx="252">
                        <c:v>161</c:v>
                      </c:pt>
                      <c:pt idx="253">
                        <c:v>163</c:v>
                      </c:pt>
                      <c:pt idx="254">
                        <c:v>160</c:v>
                      </c:pt>
                      <c:pt idx="255">
                        <c:v>185</c:v>
                      </c:pt>
                      <c:pt idx="256">
                        <c:v>144</c:v>
                      </c:pt>
                      <c:pt idx="257">
                        <c:v>132</c:v>
                      </c:pt>
                      <c:pt idx="258">
                        <c:v>150</c:v>
                      </c:pt>
                      <c:pt idx="259">
                        <c:v>195</c:v>
                      </c:pt>
                      <c:pt idx="260">
                        <c:v>213</c:v>
                      </c:pt>
                      <c:pt idx="261">
                        <c:v>223</c:v>
                      </c:pt>
                      <c:pt idx="262">
                        <c:v>189</c:v>
                      </c:pt>
                      <c:pt idx="263">
                        <c:v>159</c:v>
                      </c:pt>
                      <c:pt idx="264">
                        <c:v>195</c:v>
                      </c:pt>
                      <c:pt idx="265">
                        <c:v>190</c:v>
                      </c:pt>
                      <c:pt idx="266">
                        <c:v>247</c:v>
                      </c:pt>
                      <c:pt idx="267">
                        <c:v>173</c:v>
                      </c:pt>
                      <c:pt idx="268">
                        <c:v>161</c:v>
                      </c:pt>
                      <c:pt idx="269">
                        <c:v>144</c:v>
                      </c:pt>
                      <c:pt idx="270">
                        <c:v>169</c:v>
                      </c:pt>
                      <c:pt idx="271">
                        <c:v>137</c:v>
                      </c:pt>
                      <c:pt idx="272">
                        <c:v>167</c:v>
                      </c:pt>
                      <c:pt idx="273">
                        <c:v>131</c:v>
                      </c:pt>
                      <c:pt idx="274">
                        <c:v>192</c:v>
                      </c:pt>
                      <c:pt idx="275">
                        <c:v>252</c:v>
                      </c:pt>
                      <c:pt idx="276">
                        <c:v>257</c:v>
                      </c:pt>
                      <c:pt idx="277">
                        <c:v>258</c:v>
                      </c:pt>
                      <c:pt idx="278">
                        <c:v>403</c:v>
                      </c:pt>
                      <c:pt idx="279">
                        <c:v>220</c:v>
                      </c:pt>
                      <c:pt idx="280">
                        <c:v>229</c:v>
                      </c:pt>
                      <c:pt idx="281">
                        <c:v>187</c:v>
                      </c:pt>
                      <c:pt idx="282">
                        <c:v>209</c:v>
                      </c:pt>
                      <c:pt idx="283">
                        <c:v>204</c:v>
                      </c:pt>
                      <c:pt idx="284">
                        <c:v>252</c:v>
                      </c:pt>
                      <c:pt idx="285">
                        <c:v>243</c:v>
                      </c:pt>
                      <c:pt idx="286">
                        <c:v>248</c:v>
                      </c:pt>
                      <c:pt idx="287">
                        <c:v>265</c:v>
                      </c:pt>
                      <c:pt idx="288">
                        <c:v>305</c:v>
                      </c:pt>
                      <c:pt idx="289">
                        <c:v>325</c:v>
                      </c:pt>
                      <c:pt idx="290">
                        <c:v>237</c:v>
                      </c:pt>
                      <c:pt idx="291">
                        <c:v>227</c:v>
                      </c:pt>
                      <c:pt idx="292">
                        <c:v>239</c:v>
                      </c:pt>
                      <c:pt idx="293">
                        <c:v>199</c:v>
                      </c:pt>
                      <c:pt idx="294">
                        <c:v>131</c:v>
                      </c:pt>
                      <c:pt idx="295">
                        <c:v>160</c:v>
                      </c:pt>
                      <c:pt idx="296">
                        <c:v>155</c:v>
                      </c:pt>
                      <c:pt idx="297">
                        <c:v>161</c:v>
                      </c:pt>
                      <c:pt idx="298">
                        <c:v>196</c:v>
                      </c:pt>
                      <c:pt idx="299">
                        <c:v>120</c:v>
                      </c:pt>
                      <c:pt idx="300">
                        <c:v>124</c:v>
                      </c:pt>
                      <c:pt idx="301">
                        <c:v>164</c:v>
                      </c:pt>
                      <c:pt idx="302">
                        <c:v>135</c:v>
                      </c:pt>
                      <c:pt idx="303">
                        <c:v>135</c:v>
                      </c:pt>
                      <c:pt idx="304">
                        <c:v>148</c:v>
                      </c:pt>
                      <c:pt idx="305">
                        <c:v>114</c:v>
                      </c:pt>
                      <c:pt idx="306">
                        <c:v>104</c:v>
                      </c:pt>
                      <c:pt idx="307">
                        <c:v>140</c:v>
                      </c:pt>
                      <c:pt idx="308">
                        <c:v>117</c:v>
                      </c:pt>
                      <c:pt idx="309">
                        <c:v>143</c:v>
                      </c:pt>
                      <c:pt idx="310">
                        <c:v>167</c:v>
                      </c:pt>
                      <c:pt idx="311">
                        <c:v>199</c:v>
                      </c:pt>
                      <c:pt idx="312">
                        <c:v>261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0-1B3D-4EC0-A8D6-5E64F831BF17}"/>
                  </c:ext>
                </c:extLst>
              </c15:ser>
            </c15:filteredLineSeries>
            <c15:filteredLine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D$1</c15:sqref>
                        </c15:formulaRef>
                      </c:ext>
                    </c:extLst>
                    <c:strCache>
                      <c:ptCount val="1"/>
                      <c:pt idx="0">
                        <c:v>Week係数</c:v>
                      </c:pt>
                    </c:strCache>
                  </c:strRef>
                </c:tx>
                <c:spPr>
                  <a:ln w="28575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3"/>
                    </a:solidFill>
                    <a:ln w="9525">
                      <a:solidFill>
                        <a:schemeClr val="accent3"/>
                      </a:solidFill>
                    </a:ln>
                    <a:effectLst/>
                  </c:spPr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2:$A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1</c:v>
                      </c:pt>
                      <c:pt idx="1">
                        <c:v>2</c:v>
                      </c:pt>
                      <c:pt idx="2">
                        <c:v>3</c:v>
                      </c:pt>
                      <c:pt idx="3">
                        <c:v>4</c:v>
                      </c:pt>
                      <c:pt idx="4">
                        <c:v>5</c:v>
                      </c:pt>
                      <c:pt idx="5">
                        <c:v>6</c:v>
                      </c:pt>
                      <c:pt idx="6">
                        <c:v>7</c:v>
                      </c:pt>
                      <c:pt idx="7">
                        <c:v>8</c:v>
                      </c:pt>
                      <c:pt idx="8">
                        <c:v>9</c:v>
                      </c:pt>
                      <c:pt idx="9">
                        <c:v>10</c:v>
                      </c:pt>
                      <c:pt idx="10">
                        <c:v>11</c:v>
                      </c:pt>
                      <c:pt idx="11">
                        <c:v>12</c:v>
                      </c:pt>
                      <c:pt idx="12">
                        <c:v>13</c:v>
                      </c:pt>
                      <c:pt idx="13">
                        <c:v>14</c:v>
                      </c:pt>
                      <c:pt idx="14">
                        <c:v>15</c:v>
                      </c:pt>
                      <c:pt idx="15">
                        <c:v>16</c:v>
                      </c:pt>
                      <c:pt idx="16">
                        <c:v>17</c:v>
                      </c:pt>
                      <c:pt idx="17">
                        <c:v>18</c:v>
                      </c:pt>
                      <c:pt idx="18">
                        <c:v>19</c:v>
                      </c:pt>
                      <c:pt idx="19">
                        <c:v>20</c:v>
                      </c:pt>
                      <c:pt idx="20">
                        <c:v>21</c:v>
                      </c:pt>
                      <c:pt idx="21">
                        <c:v>22</c:v>
                      </c:pt>
                      <c:pt idx="22">
                        <c:v>23</c:v>
                      </c:pt>
                      <c:pt idx="23">
                        <c:v>24</c:v>
                      </c:pt>
                      <c:pt idx="24">
                        <c:v>25</c:v>
                      </c:pt>
                      <c:pt idx="25">
                        <c:v>26</c:v>
                      </c:pt>
                      <c:pt idx="26">
                        <c:v>27</c:v>
                      </c:pt>
                      <c:pt idx="27">
                        <c:v>28</c:v>
                      </c:pt>
                      <c:pt idx="28">
                        <c:v>29</c:v>
                      </c:pt>
                      <c:pt idx="29">
                        <c:v>30</c:v>
                      </c:pt>
                      <c:pt idx="30">
                        <c:v>31</c:v>
                      </c:pt>
                      <c:pt idx="31">
                        <c:v>32</c:v>
                      </c:pt>
                      <c:pt idx="32">
                        <c:v>33</c:v>
                      </c:pt>
                      <c:pt idx="33">
                        <c:v>34</c:v>
                      </c:pt>
                      <c:pt idx="34">
                        <c:v>35</c:v>
                      </c:pt>
                      <c:pt idx="35">
                        <c:v>36</c:v>
                      </c:pt>
                      <c:pt idx="36">
                        <c:v>37</c:v>
                      </c:pt>
                      <c:pt idx="37">
                        <c:v>38</c:v>
                      </c:pt>
                      <c:pt idx="38">
                        <c:v>39</c:v>
                      </c:pt>
                      <c:pt idx="39">
                        <c:v>40</c:v>
                      </c:pt>
                      <c:pt idx="40">
                        <c:v>41</c:v>
                      </c:pt>
                      <c:pt idx="41">
                        <c:v>42</c:v>
                      </c:pt>
                      <c:pt idx="42">
                        <c:v>43</c:v>
                      </c:pt>
                      <c:pt idx="43">
                        <c:v>44</c:v>
                      </c:pt>
                      <c:pt idx="44">
                        <c:v>45</c:v>
                      </c:pt>
                      <c:pt idx="45">
                        <c:v>46</c:v>
                      </c:pt>
                      <c:pt idx="46">
                        <c:v>47</c:v>
                      </c:pt>
                      <c:pt idx="47">
                        <c:v>48</c:v>
                      </c:pt>
                      <c:pt idx="48">
                        <c:v>49</c:v>
                      </c:pt>
                      <c:pt idx="49">
                        <c:v>50</c:v>
                      </c:pt>
                      <c:pt idx="50">
                        <c:v>51</c:v>
                      </c:pt>
                      <c:pt idx="51">
                        <c:v>52</c:v>
                      </c:pt>
                      <c:pt idx="52">
                        <c:v>1</c:v>
                      </c:pt>
                      <c:pt idx="53">
                        <c:v>2</c:v>
                      </c:pt>
                      <c:pt idx="54">
                        <c:v>3</c:v>
                      </c:pt>
                      <c:pt idx="55">
                        <c:v>4</c:v>
                      </c:pt>
                      <c:pt idx="56">
                        <c:v>5</c:v>
                      </c:pt>
                      <c:pt idx="57">
                        <c:v>6</c:v>
                      </c:pt>
                      <c:pt idx="58">
                        <c:v>7</c:v>
                      </c:pt>
                      <c:pt idx="59">
                        <c:v>8</c:v>
                      </c:pt>
                      <c:pt idx="60">
                        <c:v>9</c:v>
                      </c:pt>
                      <c:pt idx="61">
                        <c:v>10</c:v>
                      </c:pt>
                      <c:pt idx="62">
                        <c:v>11</c:v>
                      </c:pt>
                      <c:pt idx="63">
                        <c:v>12</c:v>
                      </c:pt>
                      <c:pt idx="64">
                        <c:v>13</c:v>
                      </c:pt>
                      <c:pt idx="65">
                        <c:v>14</c:v>
                      </c:pt>
                      <c:pt idx="66">
                        <c:v>15</c:v>
                      </c:pt>
                      <c:pt idx="67">
                        <c:v>16</c:v>
                      </c:pt>
                      <c:pt idx="68">
                        <c:v>17</c:v>
                      </c:pt>
                      <c:pt idx="69">
                        <c:v>18</c:v>
                      </c:pt>
                      <c:pt idx="70">
                        <c:v>19</c:v>
                      </c:pt>
                      <c:pt idx="71">
                        <c:v>20</c:v>
                      </c:pt>
                      <c:pt idx="72">
                        <c:v>21</c:v>
                      </c:pt>
                      <c:pt idx="73">
                        <c:v>22</c:v>
                      </c:pt>
                      <c:pt idx="74">
                        <c:v>23</c:v>
                      </c:pt>
                      <c:pt idx="75">
                        <c:v>24</c:v>
                      </c:pt>
                      <c:pt idx="76">
                        <c:v>25</c:v>
                      </c:pt>
                      <c:pt idx="77">
                        <c:v>26</c:v>
                      </c:pt>
                      <c:pt idx="78">
                        <c:v>27</c:v>
                      </c:pt>
                      <c:pt idx="79">
                        <c:v>28</c:v>
                      </c:pt>
                      <c:pt idx="80">
                        <c:v>29</c:v>
                      </c:pt>
                      <c:pt idx="81">
                        <c:v>30</c:v>
                      </c:pt>
                      <c:pt idx="82">
                        <c:v>31</c:v>
                      </c:pt>
                      <c:pt idx="83">
                        <c:v>32</c:v>
                      </c:pt>
                      <c:pt idx="84">
                        <c:v>33</c:v>
                      </c:pt>
                      <c:pt idx="85">
                        <c:v>34</c:v>
                      </c:pt>
                      <c:pt idx="86">
                        <c:v>35</c:v>
                      </c:pt>
                      <c:pt idx="87">
                        <c:v>36</c:v>
                      </c:pt>
                      <c:pt idx="88">
                        <c:v>37</c:v>
                      </c:pt>
                      <c:pt idx="89">
                        <c:v>38</c:v>
                      </c:pt>
                      <c:pt idx="90">
                        <c:v>39</c:v>
                      </c:pt>
                      <c:pt idx="91">
                        <c:v>40</c:v>
                      </c:pt>
                      <c:pt idx="92">
                        <c:v>41</c:v>
                      </c:pt>
                      <c:pt idx="93">
                        <c:v>42</c:v>
                      </c:pt>
                      <c:pt idx="94">
                        <c:v>43</c:v>
                      </c:pt>
                      <c:pt idx="95">
                        <c:v>44</c:v>
                      </c:pt>
                      <c:pt idx="96">
                        <c:v>45</c:v>
                      </c:pt>
                      <c:pt idx="97">
                        <c:v>46</c:v>
                      </c:pt>
                      <c:pt idx="98">
                        <c:v>47</c:v>
                      </c:pt>
                      <c:pt idx="99">
                        <c:v>48</c:v>
                      </c:pt>
                      <c:pt idx="100">
                        <c:v>49</c:v>
                      </c:pt>
                      <c:pt idx="101">
                        <c:v>50</c:v>
                      </c:pt>
                      <c:pt idx="102">
                        <c:v>51</c:v>
                      </c:pt>
                      <c:pt idx="103">
                        <c:v>52</c:v>
                      </c:pt>
                      <c:pt idx="104">
                        <c:v>1</c:v>
                      </c:pt>
                      <c:pt idx="105">
                        <c:v>2</c:v>
                      </c:pt>
                      <c:pt idx="106">
                        <c:v>3</c:v>
                      </c:pt>
                      <c:pt idx="107">
                        <c:v>4</c:v>
                      </c:pt>
                      <c:pt idx="108">
                        <c:v>5</c:v>
                      </c:pt>
                      <c:pt idx="109">
                        <c:v>6</c:v>
                      </c:pt>
                      <c:pt idx="110">
                        <c:v>7</c:v>
                      </c:pt>
                      <c:pt idx="111">
                        <c:v>8</c:v>
                      </c:pt>
                      <c:pt idx="112">
                        <c:v>9</c:v>
                      </c:pt>
                      <c:pt idx="113">
                        <c:v>10</c:v>
                      </c:pt>
                      <c:pt idx="114">
                        <c:v>11</c:v>
                      </c:pt>
                      <c:pt idx="115">
                        <c:v>12</c:v>
                      </c:pt>
                      <c:pt idx="116">
                        <c:v>13</c:v>
                      </c:pt>
                      <c:pt idx="117">
                        <c:v>14</c:v>
                      </c:pt>
                      <c:pt idx="118">
                        <c:v>15</c:v>
                      </c:pt>
                      <c:pt idx="119">
                        <c:v>16</c:v>
                      </c:pt>
                      <c:pt idx="120">
                        <c:v>17</c:v>
                      </c:pt>
                      <c:pt idx="121">
                        <c:v>18</c:v>
                      </c:pt>
                      <c:pt idx="122">
                        <c:v>19</c:v>
                      </c:pt>
                      <c:pt idx="123">
                        <c:v>20</c:v>
                      </c:pt>
                      <c:pt idx="124">
                        <c:v>21</c:v>
                      </c:pt>
                      <c:pt idx="125">
                        <c:v>22</c:v>
                      </c:pt>
                      <c:pt idx="126">
                        <c:v>23</c:v>
                      </c:pt>
                      <c:pt idx="127">
                        <c:v>24</c:v>
                      </c:pt>
                      <c:pt idx="128">
                        <c:v>25</c:v>
                      </c:pt>
                      <c:pt idx="129">
                        <c:v>26</c:v>
                      </c:pt>
                      <c:pt idx="130">
                        <c:v>27</c:v>
                      </c:pt>
                      <c:pt idx="131">
                        <c:v>28</c:v>
                      </c:pt>
                      <c:pt idx="132">
                        <c:v>29</c:v>
                      </c:pt>
                      <c:pt idx="133">
                        <c:v>30</c:v>
                      </c:pt>
                      <c:pt idx="134">
                        <c:v>31</c:v>
                      </c:pt>
                      <c:pt idx="135">
                        <c:v>32</c:v>
                      </c:pt>
                      <c:pt idx="136">
                        <c:v>33</c:v>
                      </c:pt>
                      <c:pt idx="137">
                        <c:v>34</c:v>
                      </c:pt>
                      <c:pt idx="138">
                        <c:v>35</c:v>
                      </c:pt>
                      <c:pt idx="139">
                        <c:v>36</c:v>
                      </c:pt>
                      <c:pt idx="140">
                        <c:v>37</c:v>
                      </c:pt>
                      <c:pt idx="141">
                        <c:v>38</c:v>
                      </c:pt>
                      <c:pt idx="142">
                        <c:v>39</c:v>
                      </c:pt>
                      <c:pt idx="143">
                        <c:v>40</c:v>
                      </c:pt>
                      <c:pt idx="144">
                        <c:v>41</c:v>
                      </c:pt>
                      <c:pt idx="145">
                        <c:v>42</c:v>
                      </c:pt>
                      <c:pt idx="146">
                        <c:v>43</c:v>
                      </c:pt>
                      <c:pt idx="147">
                        <c:v>44</c:v>
                      </c:pt>
                      <c:pt idx="148">
                        <c:v>45</c:v>
                      </c:pt>
                      <c:pt idx="149">
                        <c:v>46</c:v>
                      </c:pt>
                      <c:pt idx="150">
                        <c:v>47</c:v>
                      </c:pt>
                      <c:pt idx="151">
                        <c:v>48</c:v>
                      </c:pt>
                      <c:pt idx="152">
                        <c:v>49</c:v>
                      </c:pt>
                      <c:pt idx="153">
                        <c:v>50</c:v>
                      </c:pt>
                      <c:pt idx="154">
                        <c:v>51</c:v>
                      </c:pt>
                      <c:pt idx="155">
                        <c:v>52</c:v>
                      </c:pt>
                      <c:pt idx="156">
                        <c:v>1</c:v>
                      </c:pt>
                      <c:pt idx="157">
                        <c:v>2</c:v>
                      </c:pt>
                      <c:pt idx="158">
                        <c:v>3</c:v>
                      </c:pt>
                      <c:pt idx="159">
                        <c:v>4</c:v>
                      </c:pt>
                      <c:pt idx="160">
                        <c:v>5</c:v>
                      </c:pt>
                      <c:pt idx="161">
                        <c:v>6</c:v>
                      </c:pt>
                      <c:pt idx="162">
                        <c:v>7</c:v>
                      </c:pt>
                      <c:pt idx="163">
                        <c:v>8</c:v>
                      </c:pt>
                      <c:pt idx="164">
                        <c:v>9</c:v>
                      </c:pt>
                      <c:pt idx="165">
                        <c:v>10</c:v>
                      </c:pt>
                      <c:pt idx="166">
                        <c:v>11</c:v>
                      </c:pt>
                      <c:pt idx="167">
                        <c:v>12</c:v>
                      </c:pt>
                      <c:pt idx="168">
                        <c:v>13</c:v>
                      </c:pt>
                      <c:pt idx="169">
                        <c:v>14</c:v>
                      </c:pt>
                      <c:pt idx="170">
                        <c:v>15</c:v>
                      </c:pt>
                      <c:pt idx="171">
                        <c:v>16</c:v>
                      </c:pt>
                      <c:pt idx="172">
                        <c:v>17</c:v>
                      </c:pt>
                      <c:pt idx="173">
                        <c:v>18</c:v>
                      </c:pt>
                      <c:pt idx="174">
                        <c:v>19</c:v>
                      </c:pt>
                      <c:pt idx="175">
                        <c:v>20</c:v>
                      </c:pt>
                      <c:pt idx="176">
                        <c:v>21</c:v>
                      </c:pt>
                      <c:pt idx="177">
                        <c:v>22</c:v>
                      </c:pt>
                      <c:pt idx="178">
                        <c:v>23</c:v>
                      </c:pt>
                      <c:pt idx="179">
                        <c:v>24</c:v>
                      </c:pt>
                      <c:pt idx="180">
                        <c:v>25</c:v>
                      </c:pt>
                      <c:pt idx="181">
                        <c:v>26</c:v>
                      </c:pt>
                      <c:pt idx="182">
                        <c:v>27</c:v>
                      </c:pt>
                      <c:pt idx="183">
                        <c:v>28</c:v>
                      </c:pt>
                      <c:pt idx="184">
                        <c:v>29</c:v>
                      </c:pt>
                      <c:pt idx="185">
                        <c:v>30</c:v>
                      </c:pt>
                      <c:pt idx="186">
                        <c:v>31</c:v>
                      </c:pt>
                      <c:pt idx="187">
                        <c:v>32</c:v>
                      </c:pt>
                      <c:pt idx="188">
                        <c:v>33</c:v>
                      </c:pt>
                      <c:pt idx="189">
                        <c:v>34</c:v>
                      </c:pt>
                      <c:pt idx="190">
                        <c:v>35</c:v>
                      </c:pt>
                      <c:pt idx="191">
                        <c:v>36</c:v>
                      </c:pt>
                      <c:pt idx="192">
                        <c:v>37</c:v>
                      </c:pt>
                      <c:pt idx="193">
                        <c:v>38</c:v>
                      </c:pt>
                      <c:pt idx="194">
                        <c:v>39</c:v>
                      </c:pt>
                      <c:pt idx="195">
                        <c:v>40</c:v>
                      </c:pt>
                      <c:pt idx="196">
                        <c:v>41</c:v>
                      </c:pt>
                      <c:pt idx="197">
                        <c:v>42</c:v>
                      </c:pt>
                      <c:pt idx="198">
                        <c:v>43</c:v>
                      </c:pt>
                      <c:pt idx="199">
                        <c:v>44</c:v>
                      </c:pt>
                      <c:pt idx="200">
                        <c:v>45</c:v>
                      </c:pt>
                      <c:pt idx="201">
                        <c:v>46</c:v>
                      </c:pt>
                      <c:pt idx="202">
                        <c:v>47</c:v>
                      </c:pt>
                      <c:pt idx="203">
                        <c:v>48</c:v>
                      </c:pt>
                      <c:pt idx="204">
                        <c:v>49</c:v>
                      </c:pt>
                      <c:pt idx="205">
                        <c:v>50</c:v>
                      </c:pt>
                      <c:pt idx="206">
                        <c:v>51</c:v>
                      </c:pt>
                      <c:pt idx="207">
                        <c:v>52</c:v>
                      </c:pt>
                      <c:pt idx="208">
                        <c:v>53</c:v>
                      </c:pt>
                      <c:pt idx="209">
                        <c:v>1</c:v>
                      </c:pt>
                      <c:pt idx="210">
                        <c:v>2</c:v>
                      </c:pt>
                      <c:pt idx="211">
                        <c:v>3</c:v>
                      </c:pt>
                      <c:pt idx="212">
                        <c:v>4</c:v>
                      </c:pt>
                      <c:pt idx="213">
                        <c:v>5</c:v>
                      </c:pt>
                      <c:pt idx="214">
                        <c:v>6</c:v>
                      </c:pt>
                      <c:pt idx="215">
                        <c:v>7</c:v>
                      </c:pt>
                      <c:pt idx="216">
                        <c:v>8</c:v>
                      </c:pt>
                      <c:pt idx="217">
                        <c:v>9</c:v>
                      </c:pt>
                      <c:pt idx="218">
                        <c:v>10</c:v>
                      </c:pt>
                      <c:pt idx="219">
                        <c:v>11</c:v>
                      </c:pt>
                      <c:pt idx="220">
                        <c:v>12</c:v>
                      </c:pt>
                      <c:pt idx="221">
                        <c:v>13</c:v>
                      </c:pt>
                      <c:pt idx="222">
                        <c:v>14</c:v>
                      </c:pt>
                      <c:pt idx="223">
                        <c:v>15</c:v>
                      </c:pt>
                      <c:pt idx="224">
                        <c:v>16</c:v>
                      </c:pt>
                      <c:pt idx="225">
                        <c:v>17</c:v>
                      </c:pt>
                      <c:pt idx="226">
                        <c:v>18</c:v>
                      </c:pt>
                      <c:pt idx="227">
                        <c:v>19</c:v>
                      </c:pt>
                      <c:pt idx="228">
                        <c:v>20</c:v>
                      </c:pt>
                      <c:pt idx="229">
                        <c:v>21</c:v>
                      </c:pt>
                      <c:pt idx="230">
                        <c:v>22</c:v>
                      </c:pt>
                      <c:pt idx="231">
                        <c:v>23</c:v>
                      </c:pt>
                      <c:pt idx="232">
                        <c:v>24</c:v>
                      </c:pt>
                      <c:pt idx="233">
                        <c:v>25</c:v>
                      </c:pt>
                      <c:pt idx="234">
                        <c:v>26</c:v>
                      </c:pt>
                      <c:pt idx="235">
                        <c:v>27</c:v>
                      </c:pt>
                      <c:pt idx="236">
                        <c:v>28</c:v>
                      </c:pt>
                      <c:pt idx="237">
                        <c:v>29</c:v>
                      </c:pt>
                      <c:pt idx="238">
                        <c:v>30</c:v>
                      </c:pt>
                      <c:pt idx="239">
                        <c:v>31</c:v>
                      </c:pt>
                      <c:pt idx="240">
                        <c:v>32</c:v>
                      </c:pt>
                      <c:pt idx="241">
                        <c:v>33</c:v>
                      </c:pt>
                      <c:pt idx="242">
                        <c:v>34</c:v>
                      </c:pt>
                      <c:pt idx="243">
                        <c:v>35</c:v>
                      </c:pt>
                      <c:pt idx="244">
                        <c:v>36</c:v>
                      </c:pt>
                      <c:pt idx="245">
                        <c:v>37</c:v>
                      </c:pt>
                      <c:pt idx="246">
                        <c:v>38</c:v>
                      </c:pt>
                      <c:pt idx="247">
                        <c:v>39</c:v>
                      </c:pt>
                      <c:pt idx="248">
                        <c:v>40</c:v>
                      </c:pt>
                      <c:pt idx="249">
                        <c:v>41</c:v>
                      </c:pt>
                      <c:pt idx="250">
                        <c:v>42</c:v>
                      </c:pt>
                      <c:pt idx="251">
                        <c:v>43</c:v>
                      </c:pt>
                      <c:pt idx="252">
                        <c:v>44</c:v>
                      </c:pt>
                      <c:pt idx="253">
                        <c:v>45</c:v>
                      </c:pt>
                      <c:pt idx="254">
                        <c:v>46</c:v>
                      </c:pt>
                      <c:pt idx="255">
                        <c:v>47</c:v>
                      </c:pt>
                      <c:pt idx="256">
                        <c:v>48</c:v>
                      </c:pt>
                      <c:pt idx="257">
                        <c:v>49</c:v>
                      </c:pt>
                      <c:pt idx="258">
                        <c:v>50</c:v>
                      </c:pt>
                      <c:pt idx="259">
                        <c:v>51</c:v>
                      </c:pt>
                      <c:pt idx="260">
                        <c:v>52</c:v>
                      </c:pt>
                      <c:pt idx="261">
                        <c:v>1</c:v>
                      </c:pt>
                      <c:pt idx="262">
                        <c:v>2</c:v>
                      </c:pt>
                      <c:pt idx="263">
                        <c:v>3</c:v>
                      </c:pt>
                      <c:pt idx="264">
                        <c:v>4</c:v>
                      </c:pt>
                      <c:pt idx="265">
                        <c:v>5</c:v>
                      </c:pt>
                      <c:pt idx="266">
                        <c:v>6</c:v>
                      </c:pt>
                      <c:pt idx="267">
                        <c:v>7</c:v>
                      </c:pt>
                      <c:pt idx="268">
                        <c:v>8</c:v>
                      </c:pt>
                      <c:pt idx="269">
                        <c:v>9</c:v>
                      </c:pt>
                      <c:pt idx="270">
                        <c:v>10</c:v>
                      </c:pt>
                      <c:pt idx="271">
                        <c:v>11</c:v>
                      </c:pt>
                      <c:pt idx="272">
                        <c:v>12</c:v>
                      </c:pt>
                      <c:pt idx="273">
                        <c:v>13</c:v>
                      </c:pt>
                      <c:pt idx="274">
                        <c:v>14</c:v>
                      </c:pt>
                      <c:pt idx="275">
                        <c:v>15</c:v>
                      </c:pt>
                      <c:pt idx="276">
                        <c:v>16</c:v>
                      </c:pt>
                      <c:pt idx="277">
                        <c:v>17</c:v>
                      </c:pt>
                      <c:pt idx="278">
                        <c:v>18</c:v>
                      </c:pt>
                      <c:pt idx="279">
                        <c:v>19</c:v>
                      </c:pt>
                      <c:pt idx="280">
                        <c:v>20</c:v>
                      </c:pt>
                      <c:pt idx="281">
                        <c:v>21</c:v>
                      </c:pt>
                      <c:pt idx="282">
                        <c:v>22</c:v>
                      </c:pt>
                      <c:pt idx="283">
                        <c:v>23</c:v>
                      </c:pt>
                      <c:pt idx="284">
                        <c:v>24</c:v>
                      </c:pt>
                      <c:pt idx="285">
                        <c:v>25</c:v>
                      </c:pt>
                      <c:pt idx="286">
                        <c:v>26</c:v>
                      </c:pt>
                      <c:pt idx="287">
                        <c:v>27</c:v>
                      </c:pt>
                      <c:pt idx="288">
                        <c:v>28</c:v>
                      </c:pt>
                      <c:pt idx="289">
                        <c:v>29</c:v>
                      </c:pt>
                      <c:pt idx="290">
                        <c:v>30</c:v>
                      </c:pt>
                      <c:pt idx="291">
                        <c:v>31</c:v>
                      </c:pt>
                      <c:pt idx="292">
                        <c:v>32</c:v>
                      </c:pt>
                      <c:pt idx="293">
                        <c:v>33</c:v>
                      </c:pt>
                      <c:pt idx="294">
                        <c:v>34</c:v>
                      </c:pt>
                      <c:pt idx="295">
                        <c:v>35</c:v>
                      </c:pt>
                      <c:pt idx="296">
                        <c:v>36</c:v>
                      </c:pt>
                      <c:pt idx="297">
                        <c:v>37</c:v>
                      </c:pt>
                      <c:pt idx="298">
                        <c:v>38</c:v>
                      </c:pt>
                      <c:pt idx="299">
                        <c:v>39</c:v>
                      </c:pt>
                      <c:pt idx="300">
                        <c:v>40</c:v>
                      </c:pt>
                      <c:pt idx="301">
                        <c:v>41</c:v>
                      </c:pt>
                      <c:pt idx="302">
                        <c:v>42</c:v>
                      </c:pt>
                      <c:pt idx="303">
                        <c:v>43</c:v>
                      </c:pt>
                      <c:pt idx="304">
                        <c:v>44</c:v>
                      </c:pt>
                      <c:pt idx="305">
                        <c:v>45</c:v>
                      </c:pt>
                      <c:pt idx="306">
                        <c:v>46</c:v>
                      </c:pt>
                      <c:pt idx="307">
                        <c:v>47</c:v>
                      </c:pt>
                      <c:pt idx="308">
                        <c:v>48</c:v>
                      </c:pt>
                      <c:pt idx="309">
                        <c:v>49</c:v>
                      </c:pt>
                      <c:pt idx="310">
                        <c:v>50</c:v>
                      </c:pt>
                      <c:pt idx="311">
                        <c:v>51</c:v>
                      </c:pt>
                      <c:pt idx="312">
                        <c:v>52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D$2:$D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256.18560079639178</c:v>
                      </c:pt>
                      <c:pt idx="1">
                        <c:v>1060.5666851956671</c:v>
                      </c:pt>
                      <c:pt idx="2">
                        <c:v>1654.6539900639789</c:v>
                      </c:pt>
                      <c:pt idx="3">
                        <c:v>2261.6007666295764</c:v>
                      </c:pt>
                      <c:pt idx="4">
                        <c:v>2456.1691373679373</c:v>
                      </c:pt>
                      <c:pt idx="5">
                        <c:v>2091.5176180052349</c:v>
                      </c:pt>
                      <c:pt idx="6">
                        <c:v>1775.5144084677599</c:v>
                      </c:pt>
                      <c:pt idx="7">
                        <c:v>1526.3896047575231</c:v>
                      </c:pt>
                      <c:pt idx="8">
                        <c:v>1346.8858179315337</c:v>
                      </c:pt>
                      <c:pt idx="9">
                        <c:v>1093.9551353763957</c:v>
                      </c:pt>
                      <c:pt idx="10">
                        <c:v>897.27994835124991</c:v>
                      </c:pt>
                      <c:pt idx="11">
                        <c:v>675.34774180109912</c:v>
                      </c:pt>
                      <c:pt idx="12">
                        <c:v>680.90532935000385</c:v>
                      </c:pt>
                      <c:pt idx="13">
                        <c:v>532.7865752967349</c:v>
                      </c:pt>
                      <c:pt idx="14">
                        <c:v>293.83012379562837</c:v>
                      </c:pt>
                      <c:pt idx="15">
                        <c:v>190.15246606897389</c:v>
                      </c:pt>
                      <c:pt idx="16">
                        <c:v>79.437309500396239</c:v>
                      </c:pt>
                      <c:pt idx="17">
                        <c:v>-257.03733729469667</c:v>
                      </c:pt>
                      <c:pt idx="18">
                        <c:v>0</c:v>
                      </c:pt>
                      <c:pt idx="19">
                        <c:v>117.72614762833928</c:v>
                      </c:pt>
                      <c:pt idx="20">
                        <c:v>93.529555771730941</c:v>
                      </c:pt>
                      <c:pt idx="21">
                        <c:v>65.367622637552728</c:v>
                      </c:pt>
                      <c:pt idx="22">
                        <c:v>108.0846726191259</c:v>
                      </c:pt>
                      <c:pt idx="23">
                        <c:v>60.465918565856953</c:v>
                      </c:pt>
                      <c:pt idx="24">
                        <c:v>17.51288447275688</c:v>
                      </c:pt>
                      <c:pt idx="25">
                        <c:v>-43.234090698758017</c:v>
                      </c:pt>
                      <c:pt idx="26">
                        <c:v>-28.738824231246308</c:v>
                      </c:pt>
                      <c:pt idx="27">
                        <c:v>-77.122540879486223</c:v>
                      </c:pt>
                      <c:pt idx="28">
                        <c:v>-149.63163852647946</c:v>
                      </c:pt>
                      <c:pt idx="29">
                        <c:v>26.243188345297423</c:v>
                      </c:pt>
                      <c:pt idx="30">
                        <c:v>179.55816483719076</c:v>
                      </c:pt>
                      <c:pt idx="31">
                        <c:v>193.88676463803594</c:v>
                      </c:pt>
                      <c:pt idx="32">
                        <c:v>111.31497649166647</c:v>
                      </c:pt>
                      <c:pt idx="33">
                        <c:v>381.92447135048894</c:v>
                      </c:pt>
                      <c:pt idx="34">
                        <c:v>347.96954384439357</c:v>
                      </c:pt>
                      <c:pt idx="35">
                        <c:v>316.54643494123508</c:v>
                      </c:pt>
                      <c:pt idx="36">
                        <c:v>283.52408340327526</c:v>
                      </c:pt>
                      <c:pt idx="37">
                        <c:v>179.62558886905575</c:v>
                      </c:pt>
                      <c:pt idx="38">
                        <c:v>281.75817410180616</c:v>
                      </c:pt>
                      <c:pt idx="39">
                        <c:v>398.32049518319877</c:v>
                      </c:pt>
                      <c:pt idx="40">
                        <c:v>324.27768552027374</c:v>
                      </c:pt>
                      <c:pt idx="41">
                        <c:v>386.18943394546017</c:v>
                      </c:pt>
                      <c:pt idx="42">
                        <c:v>417.28110292828097</c:v>
                      </c:pt>
                      <c:pt idx="43">
                        <c:v>413.11632967460957</c:v>
                      </c:pt>
                      <c:pt idx="44">
                        <c:v>379.36367426410874</c:v>
                      </c:pt>
                      <c:pt idx="45">
                        <c:v>418.15193510353737</c:v>
                      </c:pt>
                      <c:pt idx="46">
                        <c:v>342.08109366366602</c:v>
                      </c:pt>
                      <c:pt idx="47">
                        <c:v>388.00514927332182</c:v>
                      </c:pt>
                      <c:pt idx="48">
                        <c:v>466.35988743811788</c:v>
                      </c:pt>
                      <c:pt idx="49">
                        <c:v>465.91632040999411</c:v>
                      </c:pt>
                      <c:pt idx="50">
                        <c:v>547.50930551729562</c:v>
                      </c:pt>
                      <c:pt idx="51">
                        <c:v>636.67350148245259</c:v>
                      </c:pt>
                      <c:pt idx="52">
                        <c:v>256.18560079639178</c:v>
                      </c:pt>
                      <c:pt idx="53">
                        <c:v>1060.5666851956671</c:v>
                      </c:pt>
                      <c:pt idx="54">
                        <c:v>1654.6539900639789</c:v>
                      </c:pt>
                      <c:pt idx="55">
                        <c:v>2261.6007666295764</c:v>
                      </c:pt>
                      <c:pt idx="56">
                        <c:v>2456.1691373679373</c:v>
                      </c:pt>
                      <c:pt idx="57">
                        <c:v>2091.5176180052349</c:v>
                      </c:pt>
                      <c:pt idx="58">
                        <c:v>1775.5144084677599</c:v>
                      </c:pt>
                      <c:pt idx="59">
                        <c:v>1526.3896047575231</c:v>
                      </c:pt>
                      <c:pt idx="60">
                        <c:v>1346.8858179315337</c:v>
                      </c:pt>
                      <c:pt idx="61">
                        <c:v>1093.9551353763957</c:v>
                      </c:pt>
                      <c:pt idx="62">
                        <c:v>897.27994835124991</c:v>
                      </c:pt>
                      <c:pt idx="63">
                        <c:v>675.34774180109912</c:v>
                      </c:pt>
                      <c:pt idx="64">
                        <c:v>680.90532935000385</c:v>
                      </c:pt>
                      <c:pt idx="65">
                        <c:v>532.7865752967349</c:v>
                      </c:pt>
                      <c:pt idx="66">
                        <c:v>293.83012379562837</c:v>
                      </c:pt>
                      <c:pt idx="67">
                        <c:v>190.15246606897389</c:v>
                      </c:pt>
                      <c:pt idx="68">
                        <c:v>79.437309500396239</c:v>
                      </c:pt>
                      <c:pt idx="69">
                        <c:v>-257.03733729469667</c:v>
                      </c:pt>
                      <c:pt idx="70">
                        <c:v>0</c:v>
                      </c:pt>
                      <c:pt idx="71">
                        <c:v>117.72614762833928</c:v>
                      </c:pt>
                      <c:pt idx="72">
                        <c:v>93.529555771730941</c:v>
                      </c:pt>
                      <c:pt idx="73">
                        <c:v>65.367622637552728</c:v>
                      </c:pt>
                      <c:pt idx="74">
                        <c:v>108.0846726191259</c:v>
                      </c:pt>
                      <c:pt idx="75">
                        <c:v>60.465918565856953</c:v>
                      </c:pt>
                      <c:pt idx="76">
                        <c:v>17.51288447275688</c:v>
                      </c:pt>
                      <c:pt idx="77">
                        <c:v>-43.234090698758017</c:v>
                      </c:pt>
                      <c:pt idx="78">
                        <c:v>-28.738824231246308</c:v>
                      </c:pt>
                      <c:pt idx="79">
                        <c:v>-77.122540879486223</c:v>
                      </c:pt>
                      <c:pt idx="80">
                        <c:v>-149.63163852647946</c:v>
                      </c:pt>
                      <c:pt idx="81">
                        <c:v>26.243188345297423</c:v>
                      </c:pt>
                      <c:pt idx="82">
                        <c:v>179.55816483719076</c:v>
                      </c:pt>
                      <c:pt idx="83">
                        <c:v>193.88676463803594</c:v>
                      </c:pt>
                      <c:pt idx="84">
                        <c:v>111.31497649166647</c:v>
                      </c:pt>
                      <c:pt idx="85">
                        <c:v>381.92447135048894</c:v>
                      </c:pt>
                      <c:pt idx="86">
                        <c:v>347.96954384439357</c:v>
                      </c:pt>
                      <c:pt idx="87">
                        <c:v>316.54643494123508</c:v>
                      </c:pt>
                      <c:pt idx="88">
                        <c:v>283.52408340327526</c:v>
                      </c:pt>
                      <c:pt idx="89">
                        <c:v>179.62558886905575</c:v>
                      </c:pt>
                      <c:pt idx="90">
                        <c:v>281.75817410180616</c:v>
                      </c:pt>
                      <c:pt idx="91">
                        <c:v>398.32049518319877</c:v>
                      </c:pt>
                      <c:pt idx="92">
                        <c:v>324.27768552027374</c:v>
                      </c:pt>
                      <c:pt idx="93">
                        <c:v>386.18943394546017</c:v>
                      </c:pt>
                      <c:pt idx="94">
                        <c:v>417.28110292828097</c:v>
                      </c:pt>
                      <c:pt idx="95">
                        <c:v>413.11632967460957</c:v>
                      </c:pt>
                      <c:pt idx="96">
                        <c:v>379.36367426410874</c:v>
                      </c:pt>
                      <c:pt idx="97">
                        <c:v>418.15193510353737</c:v>
                      </c:pt>
                      <c:pt idx="98">
                        <c:v>342.08109366366602</c:v>
                      </c:pt>
                      <c:pt idx="99">
                        <c:v>388.00514927332182</c:v>
                      </c:pt>
                      <c:pt idx="100">
                        <c:v>466.35988743811788</c:v>
                      </c:pt>
                      <c:pt idx="101">
                        <c:v>465.91632040999411</c:v>
                      </c:pt>
                      <c:pt idx="102">
                        <c:v>547.50930551729562</c:v>
                      </c:pt>
                      <c:pt idx="103">
                        <c:v>636.67350148245259</c:v>
                      </c:pt>
                      <c:pt idx="104">
                        <c:v>256.18560079639178</c:v>
                      </c:pt>
                      <c:pt idx="105">
                        <c:v>1060.5666851956671</c:v>
                      </c:pt>
                      <c:pt idx="106">
                        <c:v>1654.6539900639789</c:v>
                      </c:pt>
                      <c:pt idx="107">
                        <c:v>2261.6007666295764</c:v>
                      </c:pt>
                      <c:pt idx="108">
                        <c:v>2456.1691373679373</c:v>
                      </c:pt>
                      <c:pt idx="109">
                        <c:v>2091.5176180052349</c:v>
                      </c:pt>
                      <c:pt idx="110">
                        <c:v>1775.5144084677599</c:v>
                      </c:pt>
                      <c:pt idx="111">
                        <c:v>1526.3896047575231</c:v>
                      </c:pt>
                      <c:pt idx="112">
                        <c:v>1346.8858179315337</c:v>
                      </c:pt>
                      <c:pt idx="113">
                        <c:v>1093.9551353763957</c:v>
                      </c:pt>
                      <c:pt idx="114">
                        <c:v>897.27994835124991</c:v>
                      </c:pt>
                      <c:pt idx="115">
                        <c:v>675.34774180109912</c:v>
                      </c:pt>
                      <c:pt idx="116">
                        <c:v>680.90532935000385</c:v>
                      </c:pt>
                      <c:pt idx="117">
                        <c:v>532.7865752967349</c:v>
                      </c:pt>
                      <c:pt idx="118">
                        <c:v>293.83012379562837</c:v>
                      </c:pt>
                      <c:pt idx="119">
                        <c:v>190.15246606897389</c:v>
                      </c:pt>
                      <c:pt idx="120">
                        <c:v>79.437309500396239</c:v>
                      </c:pt>
                      <c:pt idx="121">
                        <c:v>-257.03733729469667</c:v>
                      </c:pt>
                      <c:pt idx="122">
                        <c:v>0</c:v>
                      </c:pt>
                      <c:pt idx="123">
                        <c:v>117.72614762833928</c:v>
                      </c:pt>
                      <c:pt idx="124">
                        <c:v>93.529555771730941</c:v>
                      </c:pt>
                      <c:pt idx="125">
                        <c:v>65.367622637552728</c:v>
                      </c:pt>
                      <c:pt idx="126">
                        <c:v>108.0846726191259</c:v>
                      </c:pt>
                      <c:pt idx="127">
                        <c:v>60.465918565856953</c:v>
                      </c:pt>
                      <c:pt idx="128">
                        <c:v>17.51288447275688</c:v>
                      </c:pt>
                      <c:pt idx="129">
                        <c:v>-43.234090698758017</c:v>
                      </c:pt>
                      <c:pt idx="130">
                        <c:v>-28.738824231246308</c:v>
                      </c:pt>
                      <c:pt idx="131">
                        <c:v>-77.122540879486223</c:v>
                      </c:pt>
                      <c:pt idx="132">
                        <c:v>-149.63163852647946</c:v>
                      </c:pt>
                      <c:pt idx="133">
                        <c:v>26.243188345297423</c:v>
                      </c:pt>
                      <c:pt idx="134">
                        <c:v>179.55816483719076</c:v>
                      </c:pt>
                      <c:pt idx="135">
                        <c:v>193.88676463803594</c:v>
                      </c:pt>
                      <c:pt idx="136">
                        <c:v>111.31497649166647</c:v>
                      </c:pt>
                      <c:pt idx="137">
                        <c:v>381.92447135048894</c:v>
                      </c:pt>
                      <c:pt idx="138">
                        <c:v>347.96954384439357</c:v>
                      </c:pt>
                      <c:pt idx="139">
                        <c:v>316.54643494123508</c:v>
                      </c:pt>
                      <c:pt idx="140">
                        <c:v>283.52408340327526</c:v>
                      </c:pt>
                      <c:pt idx="141">
                        <c:v>179.62558886905575</c:v>
                      </c:pt>
                      <c:pt idx="142">
                        <c:v>281.75817410180616</c:v>
                      </c:pt>
                      <c:pt idx="143">
                        <c:v>398.32049518319877</c:v>
                      </c:pt>
                      <c:pt idx="144">
                        <c:v>324.27768552027374</c:v>
                      </c:pt>
                      <c:pt idx="145">
                        <c:v>386.18943394546017</c:v>
                      </c:pt>
                      <c:pt idx="146">
                        <c:v>417.28110292828097</c:v>
                      </c:pt>
                      <c:pt idx="147">
                        <c:v>413.11632967460957</c:v>
                      </c:pt>
                      <c:pt idx="148">
                        <c:v>379.36367426410874</c:v>
                      </c:pt>
                      <c:pt idx="149">
                        <c:v>418.15193510353737</c:v>
                      </c:pt>
                      <c:pt idx="150">
                        <c:v>342.08109366366602</c:v>
                      </c:pt>
                      <c:pt idx="151">
                        <c:v>388.00514927332182</c:v>
                      </c:pt>
                      <c:pt idx="152">
                        <c:v>466.35988743811788</c:v>
                      </c:pt>
                      <c:pt idx="153">
                        <c:v>465.91632040999411</c:v>
                      </c:pt>
                      <c:pt idx="154">
                        <c:v>547.50930551729562</c:v>
                      </c:pt>
                      <c:pt idx="155">
                        <c:v>636.67350148245259</c:v>
                      </c:pt>
                      <c:pt idx="156">
                        <c:v>256.18560079639178</c:v>
                      </c:pt>
                      <c:pt idx="157">
                        <c:v>1060.5666851956671</c:v>
                      </c:pt>
                      <c:pt idx="158">
                        <c:v>1654.6539900639789</c:v>
                      </c:pt>
                      <c:pt idx="159">
                        <c:v>2261.6007666295764</c:v>
                      </c:pt>
                      <c:pt idx="160">
                        <c:v>2456.1691373679373</c:v>
                      </c:pt>
                      <c:pt idx="161">
                        <c:v>2091.5176180052349</c:v>
                      </c:pt>
                      <c:pt idx="162">
                        <c:v>1775.5144084677599</c:v>
                      </c:pt>
                      <c:pt idx="163">
                        <c:v>1526.3896047575231</c:v>
                      </c:pt>
                      <c:pt idx="164">
                        <c:v>1346.8858179315337</c:v>
                      </c:pt>
                      <c:pt idx="165">
                        <c:v>1093.9551353763957</c:v>
                      </c:pt>
                      <c:pt idx="166">
                        <c:v>897.27994835124991</c:v>
                      </c:pt>
                      <c:pt idx="167">
                        <c:v>675.34774180109912</c:v>
                      </c:pt>
                      <c:pt idx="168">
                        <c:v>680.90532935000385</c:v>
                      </c:pt>
                      <c:pt idx="169">
                        <c:v>532.7865752967349</c:v>
                      </c:pt>
                      <c:pt idx="170">
                        <c:v>293.83012379562837</c:v>
                      </c:pt>
                      <c:pt idx="171">
                        <c:v>190.15246606897389</c:v>
                      </c:pt>
                      <c:pt idx="172">
                        <c:v>79.437309500396239</c:v>
                      </c:pt>
                      <c:pt idx="173">
                        <c:v>-257.03733729469667</c:v>
                      </c:pt>
                      <c:pt idx="174">
                        <c:v>0</c:v>
                      </c:pt>
                      <c:pt idx="175">
                        <c:v>117.72614762833928</c:v>
                      </c:pt>
                      <c:pt idx="176">
                        <c:v>93.529555771730941</c:v>
                      </c:pt>
                      <c:pt idx="177">
                        <c:v>65.367622637552728</c:v>
                      </c:pt>
                      <c:pt idx="178">
                        <c:v>108.0846726191259</c:v>
                      </c:pt>
                      <c:pt idx="179">
                        <c:v>60.465918565856953</c:v>
                      </c:pt>
                      <c:pt idx="180">
                        <c:v>17.51288447275688</c:v>
                      </c:pt>
                      <c:pt idx="181">
                        <c:v>-43.234090698758017</c:v>
                      </c:pt>
                      <c:pt idx="182">
                        <c:v>-28.738824231246308</c:v>
                      </c:pt>
                      <c:pt idx="183">
                        <c:v>-77.122540879486223</c:v>
                      </c:pt>
                      <c:pt idx="184">
                        <c:v>-149.63163852647946</c:v>
                      </c:pt>
                      <c:pt idx="185">
                        <c:v>26.243188345297423</c:v>
                      </c:pt>
                      <c:pt idx="186">
                        <c:v>179.55816483719076</c:v>
                      </c:pt>
                      <c:pt idx="187">
                        <c:v>193.88676463803594</c:v>
                      </c:pt>
                      <c:pt idx="188">
                        <c:v>111.31497649166647</c:v>
                      </c:pt>
                      <c:pt idx="189">
                        <c:v>381.92447135048894</c:v>
                      </c:pt>
                      <c:pt idx="190">
                        <c:v>347.96954384439357</c:v>
                      </c:pt>
                      <c:pt idx="191">
                        <c:v>316.54643494123508</c:v>
                      </c:pt>
                      <c:pt idx="192">
                        <c:v>283.52408340327526</c:v>
                      </c:pt>
                      <c:pt idx="193">
                        <c:v>179.62558886905575</c:v>
                      </c:pt>
                      <c:pt idx="194">
                        <c:v>281.75817410180616</c:v>
                      </c:pt>
                      <c:pt idx="195">
                        <c:v>398.32049518319877</c:v>
                      </c:pt>
                      <c:pt idx="196">
                        <c:v>324.27768552027374</c:v>
                      </c:pt>
                      <c:pt idx="197">
                        <c:v>386.18943394546017</c:v>
                      </c:pt>
                      <c:pt idx="198">
                        <c:v>417.28110292828097</c:v>
                      </c:pt>
                      <c:pt idx="199">
                        <c:v>413.11632967460957</c:v>
                      </c:pt>
                      <c:pt idx="200">
                        <c:v>379.36367426410874</c:v>
                      </c:pt>
                      <c:pt idx="201">
                        <c:v>418.15193510353737</c:v>
                      </c:pt>
                      <c:pt idx="202">
                        <c:v>342.08109366366602</c:v>
                      </c:pt>
                      <c:pt idx="203">
                        <c:v>388.00514927332182</c:v>
                      </c:pt>
                      <c:pt idx="204">
                        <c:v>466.35988743811788</c:v>
                      </c:pt>
                      <c:pt idx="205">
                        <c:v>465.91632040999411</c:v>
                      </c:pt>
                      <c:pt idx="206">
                        <c:v>547.50930551729562</c:v>
                      </c:pt>
                      <c:pt idx="207">
                        <c:v>636.67350148245259</c:v>
                      </c:pt>
                      <c:pt idx="208">
                        <c:v>-35.259282356205489</c:v>
                      </c:pt>
                      <c:pt idx="209">
                        <c:v>256.18560079639178</c:v>
                      </c:pt>
                      <c:pt idx="210">
                        <c:v>1060.5666851956671</c:v>
                      </c:pt>
                      <c:pt idx="211">
                        <c:v>1654.6539900639789</c:v>
                      </c:pt>
                      <c:pt idx="212">
                        <c:v>2261.6007666295764</c:v>
                      </c:pt>
                      <c:pt idx="213">
                        <c:v>2456.1691373679373</c:v>
                      </c:pt>
                      <c:pt idx="214">
                        <c:v>2091.5176180052349</c:v>
                      </c:pt>
                      <c:pt idx="215">
                        <c:v>1775.5144084677599</c:v>
                      </c:pt>
                      <c:pt idx="216">
                        <c:v>1526.3896047575231</c:v>
                      </c:pt>
                      <c:pt idx="217">
                        <c:v>1346.8858179315337</c:v>
                      </c:pt>
                      <c:pt idx="218">
                        <c:v>1093.9551353763957</c:v>
                      </c:pt>
                      <c:pt idx="219">
                        <c:v>897.27994835124991</c:v>
                      </c:pt>
                      <c:pt idx="220">
                        <c:v>675.34774180109912</c:v>
                      </c:pt>
                      <c:pt idx="221">
                        <c:v>680.90532935000385</c:v>
                      </c:pt>
                      <c:pt idx="222">
                        <c:v>532.7865752967349</c:v>
                      </c:pt>
                      <c:pt idx="223">
                        <c:v>293.83012379562837</c:v>
                      </c:pt>
                      <c:pt idx="224">
                        <c:v>190.15246606897389</c:v>
                      </c:pt>
                      <c:pt idx="225">
                        <c:v>79.437309500396239</c:v>
                      </c:pt>
                      <c:pt idx="226">
                        <c:v>-257.03733729469667</c:v>
                      </c:pt>
                      <c:pt idx="227">
                        <c:v>0</c:v>
                      </c:pt>
                      <c:pt idx="228">
                        <c:v>117.72614762833928</c:v>
                      </c:pt>
                      <c:pt idx="229">
                        <c:v>93.529555771730941</c:v>
                      </c:pt>
                      <c:pt idx="230">
                        <c:v>65.367622637552728</c:v>
                      </c:pt>
                      <c:pt idx="231">
                        <c:v>108.0846726191259</c:v>
                      </c:pt>
                      <c:pt idx="232">
                        <c:v>60.465918565856953</c:v>
                      </c:pt>
                      <c:pt idx="233">
                        <c:v>17.51288447275688</c:v>
                      </c:pt>
                      <c:pt idx="234">
                        <c:v>-43.234090698758017</c:v>
                      </c:pt>
                      <c:pt idx="235">
                        <c:v>-28.738824231246308</c:v>
                      </c:pt>
                      <c:pt idx="236">
                        <c:v>-77.122540879486223</c:v>
                      </c:pt>
                      <c:pt idx="237">
                        <c:v>-149.63163852647946</c:v>
                      </c:pt>
                      <c:pt idx="238">
                        <c:v>26.243188345297423</c:v>
                      </c:pt>
                      <c:pt idx="239">
                        <c:v>179.55816483719076</c:v>
                      </c:pt>
                      <c:pt idx="240">
                        <c:v>193.88676463803594</c:v>
                      </c:pt>
                      <c:pt idx="241">
                        <c:v>111.31497649166647</c:v>
                      </c:pt>
                      <c:pt idx="242">
                        <c:v>381.92447135048894</c:v>
                      </c:pt>
                      <c:pt idx="243">
                        <c:v>347.96954384439357</c:v>
                      </c:pt>
                      <c:pt idx="244">
                        <c:v>316.54643494123508</c:v>
                      </c:pt>
                      <c:pt idx="245">
                        <c:v>283.52408340327526</c:v>
                      </c:pt>
                      <c:pt idx="246">
                        <c:v>179.62558886905575</c:v>
                      </c:pt>
                      <c:pt idx="247">
                        <c:v>281.75817410180616</c:v>
                      </c:pt>
                      <c:pt idx="248">
                        <c:v>398.32049518319877</c:v>
                      </c:pt>
                      <c:pt idx="249">
                        <c:v>324.27768552027374</c:v>
                      </c:pt>
                      <c:pt idx="250">
                        <c:v>386.18943394546017</c:v>
                      </c:pt>
                      <c:pt idx="251">
                        <c:v>417.28110292828097</c:v>
                      </c:pt>
                      <c:pt idx="252">
                        <c:v>413.11632967460957</c:v>
                      </c:pt>
                      <c:pt idx="253">
                        <c:v>379.36367426410874</c:v>
                      </c:pt>
                      <c:pt idx="254">
                        <c:v>418.15193510353737</c:v>
                      </c:pt>
                      <c:pt idx="255">
                        <c:v>342.08109366366602</c:v>
                      </c:pt>
                      <c:pt idx="256">
                        <c:v>388.00514927332182</c:v>
                      </c:pt>
                      <c:pt idx="257">
                        <c:v>466.35988743811788</c:v>
                      </c:pt>
                      <c:pt idx="258">
                        <c:v>465.91632040999411</c:v>
                      </c:pt>
                      <c:pt idx="259">
                        <c:v>547.50930551729562</c:v>
                      </c:pt>
                      <c:pt idx="260">
                        <c:v>636.67350148245259</c:v>
                      </c:pt>
                      <c:pt idx="261">
                        <c:v>256.18560079639178</c:v>
                      </c:pt>
                      <c:pt idx="262">
                        <c:v>1060.5666851956671</c:v>
                      </c:pt>
                      <c:pt idx="263">
                        <c:v>1654.6539900639789</c:v>
                      </c:pt>
                      <c:pt idx="264">
                        <c:v>2261.6007666295764</c:v>
                      </c:pt>
                      <c:pt idx="265">
                        <c:v>2456.1691373679373</c:v>
                      </c:pt>
                      <c:pt idx="266">
                        <c:v>2091.5176180052349</c:v>
                      </c:pt>
                      <c:pt idx="267">
                        <c:v>1775.5144084677599</c:v>
                      </c:pt>
                      <c:pt idx="268">
                        <c:v>1526.3896047575231</c:v>
                      </c:pt>
                      <c:pt idx="269">
                        <c:v>1346.8858179315337</c:v>
                      </c:pt>
                      <c:pt idx="270">
                        <c:v>1093.9551353763957</c:v>
                      </c:pt>
                      <c:pt idx="271">
                        <c:v>897.27994835124991</c:v>
                      </c:pt>
                      <c:pt idx="272">
                        <c:v>675.34774180109912</c:v>
                      </c:pt>
                      <c:pt idx="273">
                        <c:v>680.90532935000385</c:v>
                      </c:pt>
                      <c:pt idx="274">
                        <c:v>532.7865752967349</c:v>
                      </c:pt>
                      <c:pt idx="275">
                        <c:v>293.83012379562837</c:v>
                      </c:pt>
                      <c:pt idx="276">
                        <c:v>190.15246606897389</c:v>
                      </c:pt>
                      <c:pt idx="277">
                        <c:v>79.437309500396239</c:v>
                      </c:pt>
                      <c:pt idx="278">
                        <c:v>-257.03733729469667</c:v>
                      </c:pt>
                      <c:pt idx="279">
                        <c:v>0</c:v>
                      </c:pt>
                      <c:pt idx="280">
                        <c:v>117.72614762833928</c:v>
                      </c:pt>
                      <c:pt idx="281">
                        <c:v>93.529555771730941</c:v>
                      </c:pt>
                      <c:pt idx="282">
                        <c:v>65.367622637552728</c:v>
                      </c:pt>
                      <c:pt idx="283">
                        <c:v>108.0846726191259</c:v>
                      </c:pt>
                      <c:pt idx="284">
                        <c:v>60.465918565856953</c:v>
                      </c:pt>
                      <c:pt idx="285">
                        <c:v>17.51288447275688</c:v>
                      </c:pt>
                      <c:pt idx="286">
                        <c:v>-43.234090698758017</c:v>
                      </c:pt>
                      <c:pt idx="287">
                        <c:v>-28.738824231246308</c:v>
                      </c:pt>
                      <c:pt idx="288">
                        <c:v>-77.122540879486223</c:v>
                      </c:pt>
                      <c:pt idx="289">
                        <c:v>-149.63163852647946</c:v>
                      </c:pt>
                      <c:pt idx="290">
                        <c:v>26.243188345297423</c:v>
                      </c:pt>
                      <c:pt idx="291">
                        <c:v>179.55816483719076</c:v>
                      </c:pt>
                      <c:pt idx="292">
                        <c:v>193.88676463803594</c:v>
                      </c:pt>
                      <c:pt idx="293">
                        <c:v>111.31497649166647</c:v>
                      </c:pt>
                      <c:pt idx="294">
                        <c:v>381.92447135048894</c:v>
                      </c:pt>
                      <c:pt idx="295">
                        <c:v>347.96954384439357</c:v>
                      </c:pt>
                      <c:pt idx="296">
                        <c:v>316.54643494123508</c:v>
                      </c:pt>
                      <c:pt idx="297">
                        <c:v>283.52408340327526</c:v>
                      </c:pt>
                      <c:pt idx="298">
                        <c:v>179.62558886905575</c:v>
                      </c:pt>
                      <c:pt idx="299">
                        <c:v>281.75817410180616</c:v>
                      </c:pt>
                      <c:pt idx="300">
                        <c:v>398.32049518319877</c:v>
                      </c:pt>
                      <c:pt idx="301">
                        <c:v>324.27768552027374</c:v>
                      </c:pt>
                      <c:pt idx="302">
                        <c:v>386.18943394546017</c:v>
                      </c:pt>
                      <c:pt idx="303">
                        <c:v>417.28110292828097</c:v>
                      </c:pt>
                      <c:pt idx="304">
                        <c:v>413.11632967460957</c:v>
                      </c:pt>
                      <c:pt idx="305">
                        <c:v>379.36367426410874</c:v>
                      </c:pt>
                      <c:pt idx="306">
                        <c:v>418.15193510353737</c:v>
                      </c:pt>
                      <c:pt idx="307">
                        <c:v>342.08109366366602</c:v>
                      </c:pt>
                      <c:pt idx="308">
                        <c:v>388.00514927332182</c:v>
                      </c:pt>
                      <c:pt idx="309">
                        <c:v>466.35988743811788</c:v>
                      </c:pt>
                      <c:pt idx="310">
                        <c:v>465.91632040999411</c:v>
                      </c:pt>
                      <c:pt idx="311">
                        <c:v>547.50930551729562</c:v>
                      </c:pt>
                      <c:pt idx="312">
                        <c:v>636.67350148245259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2-1B3D-4EC0-A8D6-5E64F831BF17}"/>
                  </c:ext>
                </c:extLst>
              </c15:ser>
            </c15:filteredLineSeries>
          </c:ext>
        </c:extLst>
      </c:lineChart>
      <c:catAx>
        <c:axId val="1627113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626116352"/>
        <c:crosses val="autoZero"/>
        <c:auto val="1"/>
        <c:lblAlgn val="ctr"/>
        <c:lblOffset val="100"/>
        <c:noMultiLvlLbl val="0"/>
      </c:catAx>
      <c:valAx>
        <c:axId val="16261163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Number of influenza cases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6271138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4405946173085094"/>
          <c:y val="0.87306911636045492"/>
          <c:w val="0.3543453786150203"/>
          <c:h val="0.117671624380285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7701</cdr:x>
      <cdr:y>0.01822</cdr:y>
    </cdr:from>
    <cdr:to>
      <cdr:x>0.9879</cdr:x>
      <cdr:y>0.07407</cdr:y>
    </cdr:to>
    <cdr:sp macro="" textlink="">
      <cdr:nvSpPr>
        <cdr:cNvPr id="2" name="タイトル 2"/>
        <cdr:cNvSpPr>
          <a:spLocks xmlns:a="http://schemas.openxmlformats.org/drawingml/2006/main" noGrp="1"/>
        </cdr:cNvSpPr>
      </cdr:nvSpPr>
      <cdr:spPr>
        <a:xfrm xmlns:a="http://schemas.openxmlformats.org/drawingml/2006/main">
          <a:off x="889000" y="124980"/>
          <a:ext cx="10515600" cy="3830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="horz" lIns="91440" tIns="45720" rIns="91440" bIns="45720" rtlCol="0" anchor="ctr">
          <a:normAutofit fontScale="90000"/>
        </a:bodyPr>
        <a:lstStyle xmlns:a="http://schemas.openxmlformats.org/drawingml/2006/main">
          <a:lvl1pPr algn="l" defTabSz="914400" rtl="0" eaLnBrk="1" latinLnBrk="0" hangingPunct="1">
            <a:lnSpc>
              <a:spcPct val="90000"/>
            </a:lnSpc>
            <a:spcBef>
              <a:spcPct val="0"/>
            </a:spcBef>
            <a:buNone/>
            <a:defRPr kumimoji="1" sz="4400" kern="1200">
              <a:solidFill>
                <a:schemeClr val="tx1"/>
              </a:solidFill>
              <a:latin typeface="+mj-lt"/>
              <a:ea typeface="+mj-ea"/>
              <a:cs typeface="+mj-cs"/>
            </a:defRPr>
          </a:lvl1pPr>
        </a:lstStyle>
        <a:p xmlns:a="http://schemas.openxmlformats.org/drawingml/2006/main">
          <a:r>
            <a:rPr kumimoji="1"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Sample figure </a:t>
          </a:r>
          <a:r>
            <a:rPr kumimoji="1"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4</a:t>
          </a:r>
          <a:endParaRPr kumimoji="1" lang="ja-JP" altLang="en-US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172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3780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0173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74631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9466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7264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2367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7851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730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8184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8099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8761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/>
          <p:cNvGraphicFramePr/>
          <p:nvPr>
            <p:extLst>
              <p:ext uri="{D42A27DB-BD31-4B8C-83A1-F6EECF244321}">
                <p14:modId xmlns:p14="http://schemas.microsoft.com/office/powerpoint/2010/main" val="3983448377"/>
              </p:ext>
            </p:extLst>
          </p:nvPr>
        </p:nvGraphicFramePr>
        <p:xfrm>
          <a:off x="333375" y="0"/>
          <a:ext cx="11544299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235122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0</Words>
  <Application>Microsoft Office PowerPoint</Application>
  <PresentationFormat>ワイド画面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tayama Yusuke</dc:creator>
  <cp:lastModifiedBy>Katayama Yusuke</cp:lastModifiedBy>
  <cp:revision>9</cp:revision>
  <dcterms:created xsi:type="dcterms:W3CDTF">2020-03-26T05:47:16Z</dcterms:created>
  <dcterms:modified xsi:type="dcterms:W3CDTF">2020-03-31T06:41:39Z</dcterms:modified>
</cp:coreProperties>
</file>